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drawings/drawing3.xml" ContentType="application/vnd.openxmlformats-officedocument.drawingml.chartshapes+xml"/>
  <Override PartName="/ppt/charts/chart4.xml" ContentType="application/vnd.openxmlformats-officedocument.drawingml.chart+xml"/>
  <Override PartName="/ppt/theme/themeOverride4.xml" ContentType="application/vnd.openxmlformats-officedocument.themeOverride+xml"/>
  <Override PartName="/ppt/drawings/drawing4.xml" ContentType="application/vnd.openxmlformats-officedocument.drawingml.chartshapes+xml"/>
  <Override PartName="/ppt/charts/chart5.xml" ContentType="application/vnd.openxmlformats-officedocument.drawingml.chart+xml"/>
  <Override PartName="/ppt/theme/themeOverride5.xml" ContentType="application/vnd.openxmlformats-officedocument.themeOverride+xml"/>
  <Override PartName="/ppt/drawings/drawing5.xml" ContentType="application/vnd.openxmlformats-officedocument.drawingml.chartshapes+xml"/>
  <Override PartName="/ppt/charts/chart6.xml" ContentType="application/vnd.openxmlformats-officedocument.drawingml.chart+xml"/>
  <Override PartName="/ppt/theme/themeOverride6.xml" ContentType="application/vnd.openxmlformats-officedocument.themeOverride+xml"/>
  <Override PartName="/ppt/drawings/drawing6.xml" ContentType="application/vnd.openxmlformats-officedocument.drawingml.chartshapes+xml"/>
  <Override PartName="/ppt/charts/chart7.xml" ContentType="application/vnd.openxmlformats-officedocument.drawingml.chart+xml"/>
  <Override PartName="/ppt/theme/themeOverride7.xml" ContentType="application/vnd.openxmlformats-officedocument.themeOverride+xml"/>
  <Override PartName="/ppt/drawings/drawing7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charts/style4.xml" ContentType="application/vnd.ms-office.chartstyle+xml"/>
  <Override PartName="/ppt/charts/colors4.xml" ContentType="application/vnd.ms-office.chartcolorstyle+xml"/>
  <Override PartName="/ppt/charts/style1.xml" ContentType="application/vnd.ms-office.chartstyle+xml"/>
  <Override PartName="/ppt/charts/colors1.xml" ContentType="application/vnd.ms-office.chartcolorstyle+xml"/>
  <Override PartName="/ppt/charts/style2.xml" ContentType="application/vnd.ms-office.chartstyle+xml"/>
  <Override PartName="/ppt/charts/colors2.xml" ContentType="application/vnd.ms-office.chartcolorstyle+xml"/>
  <Override PartName="/ppt/charts/style3.xml" ContentType="application/vnd.ms-office.chartstyle+xml"/>
  <Override PartName="/ppt/charts/colors3.xml" ContentType="application/vnd.ms-office.chartcolorstyle+xml"/>
  <Override PartName="/ppt/charts/style6.xml" ContentType="application/vnd.ms-office.chartstyle+xml"/>
  <Override PartName="/ppt/charts/colors6.xml" ContentType="application/vnd.ms-office.chartcolorstyle+xml"/>
  <Override PartName="/ppt/charts/style8.xml" ContentType="application/vnd.ms-office.chartstyle+xml"/>
  <Override PartName="/ppt/charts/colors8.xml" ContentType="application/vnd.ms-office.chartcolor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67" r:id="rId5"/>
    <p:sldId id="271" r:id="rId6"/>
    <p:sldId id="273" r:id="rId7"/>
    <p:sldId id="263" r:id="rId8"/>
    <p:sldId id="259" r:id="rId9"/>
    <p:sldId id="256" r:id="rId10"/>
    <p:sldId id="257" r:id="rId11"/>
    <p:sldId id="258" r:id="rId12"/>
    <p:sldId id="265" r:id="rId13"/>
    <p:sldId id="266" r:id="rId14"/>
    <p:sldId id="264" r:id="rId1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中度样式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E25E649-3F16-4E02-A733-19D2CDBF48F0}" styleName="中度样式 3 - 强调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EB344D84-9AFB-497E-A393-DC336BA19D2E}" styleName="中度样式 3 - 强调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321" autoAdjust="0"/>
    <p:restoredTop sz="94660"/>
  </p:normalViewPr>
  <p:slideViewPr>
    <p:cSldViewPr snapToGrid="0">
      <p:cViewPr>
        <p:scale>
          <a:sx n="89" d="100"/>
          <a:sy n="89" d="100"/>
        </p:scale>
        <p:origin x="-595" y="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viewProps" Target="viewProps.xml"/><Relationship Id="rId2" Type="http://schemas.openxmlformats.org/officeDocument/2006/relationships/customXml" Target="../customXml/item2.xml"/><Relationship Id="rId16" Type="http://schemas.openxmlformats.org/officeDocument/2006/relationships/presProps" Target="presProp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10" Type="http://schemas.openxmlformats.org/officeDocument/2006/relationships/slide" Target="slides/slide6.xml"/><Relationship Id="rId19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1.xml"/><Relationship Id="rId2" Type="http://schemas.openxmlformats.org/officeDocument/2006/relationships/oleObject" Target="file:///F:\&#26700;&#38754;\&#21326;&#24072;\&#24072;&#38376;&#31185;&#30740;\&#35838;&#39064;&#30740;&#31350;\&#35838;&#39064;&#32452;\&#23454;&#39564;\&#23454;&#39564;&#19968;\&#23454;&#39564;&#19968;&#25968;&#25454;&#22788;&#29702;%20(&#32456;).xlsx" TargetMode="External"/><Relationship Id="rId1" Type="http://schemas.openxmlformats.org/officeDocument/2006/relationships/themeOverride" Target="../theme/themeOverride1.xml"/><Relationship Id="rId5" Type="http://schemas.microsoft.com/office/2011/relationships/chartStyle" Target="style4.xml"/><Relationship Id="rId4" Type="http://schemas.microsoft.com/office/2011/relationships/chartColorStyle" Target="colors4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2.xml"/><Relationship Id="rId2" Type="http://schemas.openxmlformats.org/officeDocument/2006/relationships/oleObject" Target="file:///F:\&#26700;&#38754;\&#21326;&#24072;\&#24072;&#38376;&#31185;&#30740;\&#35838;&#39064;&#30740;&#31350;\&#35838;&#39064;&#32452;\&#23454;&#39564;\&#23454;&#39564;&#19968;\&#23454;&#39564;&#19968;&#25968;&#25454;&#22788;&#29702;%20(&#32456;).xlsx" TargetMode="External"/><Relationship Id="rId1" Type="http://schemas.openxmlformats.org/officeDocument/2006/relationships/themeOverride" Target="../theme/themeOverride2.xml"/><Relationship Id="rId5" Type="http://schemas.microsoft.com/office/2011/relationships/chartStyle" Target="style1.xml"/><Relationship Id="rId4" Type="http://schemas.microsoft.com/office/2011/relationships/chartColorStyle" Target="colors1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3.xml"/><Relationship Id="rId2" Type="http://schemas.openxmlformats.org/officeDocument/2006/relationships/oleObject" Target="file:///F:\&#26700;&#38754;\&#21326;&#24072;\&#24072;&#38376;&#31185;&#30740;\&#35838;&#39064;&#30740;&#31350;\&#35838;&#39064;&#32452;\&#23454;&#39564;\&#23454;&#39564;&#19968;\&#23454;&#39564;&#19968;&#25968;&#25454;&#22788;&#29702;%20(&#32456;).xlsx" TargetMode="External"/><Relationship Id="rId1" Type="http://schemas.openxmlformats.org/officeDocument/2006/relationships/themeOverride" Target="../theme/themeOverride3.xml"/><Relationship Id="rId5" Type="http://schemas.microsoft.com/office/2011/relationships/chartStyle" Target="style2.xml"/><Relationship Id="rId4" Type="http://schemas.microsoft.com/office/2011/relationships/chartColorStyle" Target="colors2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4.xml"/><Relationship Id="rId2" Type="http://schemas.openxmlformats.org/officeDocument/2006/relationships/oleObject" Target="file:///F:\&#26700;&#38754;\&#21326;&#24072;\&#24072;&#38376;&#31185;&#30740;\&#35838;&#39064;&#30740;&#31350;\&#35838;&#39064;&#32452;\&#23454;&#39564;\&#23454;&#39564;&#19968;\&#23454;&#39564;&#19968;&#25968;&#25454;&#22788;&#29702;%20(&#32456;).xlsx" TargetMode="External"/><Relationship Id="rId1" Type="http://schemas.openxmlformats.org/officeDocument/2006/relationships/themeOverride" Target="../theme/themeOverride4.xml"/><Relationship Id="rId5" Type="http://schemas.microsoft.com/office/2011/relationships/chartStyle" Target="style3.xml"/><Relationship Id="rId4" Type="http://schemas.microsoft.com/office/2011/relationships/chartColorStyle" Target="colors3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5.xml"/><Relationship Id="rId2" Type="http://schemas.openxmlformats.org/officeDocument/2006/relationships/oleObject" Target="file:///C:\Users\Waymon\Desktop\&#23454;&#39564;&#19968;&#25968;&#25454;&#22788;&#29702;%20(&#32456;).xlsx" TargetMode="External"/><Relationship Id="rId1" Type="http://schemas.openxmlformats.org/officeDocument/2006/relationships/themeOverride" Target="../theme/themeOverride5.xml"/><Relationship Id="rId5" Type="http://schemas.microsoft.com/office/2011/relationships/chartStyle" Target="style6.xml"/><Relationship Id="rId4" Type="http://schemas.microsoft.com/office/2011/relationships/chartColorStyle" Target="colors6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6.xml"/><Relationship Id="rId2" Type="http://schemas.openxmlformats.org/officeDocument/2006/relationships/oleObject" Target="file:///C:\Users\Waymon\Desktop\&#23454;&#39564;&#19968;&#25968;&#25454;&#22788;&#29702;%20(&#32456;).xlsx" TargetMode="External"/><Relationship Id="rId1" Type="http://schemas.openxmlformats.org/officeDocument/2006/relationships/themeOverride" Target="../theme/themeOverride6.xml"/><Relationship Id="rId5" Type="http://schemas.microsoft.com/office/2011/relationships/chartStyle" Target="style8.xml"/><Relationship Id="rId4" Type="http://schemas.microsoft.com/office/2011/relationships/chartColorStyle" Target="colors8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7.xml"/><Relationship Id="rId2" Type="http://schemas.openxmlformats.org/officeDocument/2006/relationships/oleObject" Target="file:///C:\Users\Waymon\Desktop\&#23454;&#39564;&#19968;&#25968;&#25454;&#22788;&#29702;%20(&#32456;).xlsx" TargetMode="External"/><Relationship Id="rId1" Type="http://schemas.openxmlformats.org/officeDocument/2006/relationships/themeOverride" Target="../theme/themeOverride7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7.6553512797350398E-2"/>
          <c:y val="0.15426226099704332"/>
          <c:w val="0.92344650530539796"/>
          <c:h val="0.64003698673014908"/>
        </c:manualLayout>
      </c:layout>
      <c:lineChart>
        <c:grouping val="standard"/>
        <c:varyColors val="0"/>
        <c:ser>
          <c:idx val="0"/>
          <c:order val="0"/>
          <c:tx>
            <c:strRef>
              <c:f>组4!$AR$1</c:f>
              <c:strCache>
                <c:ptCount val="1"/>
                <c:pt idx="0">
                  <c:v>CS+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9"/>
            <c:spPr>
              <a:solidFill>
                <a:sysClr val="window" lastClr="FFFFFF"/>
              </a:solidFill>
              <a:ln w="25400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组4!$AT$2:$AT$38</c:f>
                <c:numCache>
                  <c:formatCode>General</c:formatCode>
                  <c:ptCount val="37"/>
                  <c:pt idx="0">
                    <c:v>5.3933502159833863E-2</c:v>
                  </c:pt>
                  <c:pt idx="1">
                    <c:v>5.4793308872376725E-2</c:v>
                  </c:pt>
                  <c:pt idx="2">
                    <c:v>7.0180682155617277E-2</c:v>
                  </c:pt>
                  <c:pt idx="3">
                    <c:v>7.0485723612365131E-2</c:v>
                  </c:pt>
                  <c:pt idx="4">
                    <c:v>8.3792589794719929E-2</c:v>
                  </c:pt>
                  <c:pt idx="5">
                    <c:v>6.412942734351551E-2</c:v>
                  </c:pt>
                  <c:pt idx="6">
                    <c:v>8.910781955595895E-2</c:v>
                  </c:pt>
                  <c:pt idx="7">
                    <c:v>8.3532770569077444E-2</c:v>
                  </c:pt>
                  <c:pt idx="11">
                    <c:v>6.331361398726118E-2</c:v>
                  </c:pt>
                  <c:pt idx="12">
                    <c:v>9.325011463257081E-2</c:v>
                  </c:pt>
                  <c:pt idx="13">
                    <c:v>0.10091469708665748</c:v>
                  </c:pt>
                  <c:pt idx="14">
                    <c:v>9.1048933528600592E-2</c:v>
                  </c:pt>
                  <c:pt idx="15">
                    <c:v>7.722051532228047E-2</c:v>
                  </c:pt>
                  <c:pt idx="16">
                    <c:v>0.14465444192885499</c:v>
                  </c:pt>
                  <c:pt idx="17">
                    <c:v>7.9914814003204618E-2</c:v>
                  </c:pt>
                  <c:pt idx="18">
                    <c:v>5.6765492828652661E-2</c:v>
                  </c:pt>
                  <c:pt idx="20">
                    <c:v>6.0593190047845212E-2</c:v>
                  </c:pt>
                  <c:pt idx="21">
                    <c:v>8.844414922827841E-2</c:v>
                  </c:pt>
                  <c:pt idx="22">
                    <c:v>7.701003916584892E-2</c:v>
                  </c:pt>
                  <c:pt idx="23">
                    <c:v>8.1702417316467296E-2</c:v>
                  </c:pt>
                  <c:pt idx="24">
                    <c:v>4.7427289237488339E-2</c:v>
                  </c:pt>
                  <c:pt idx="25">
                    <c:v>3.6769027898554893E-2</c:v>
                  </c:pt>
                  <c:pt idx="26">
                    <c:v>4.6488603080801265E-2</c:v>
                  </c:pt>
                  <c:pt idx="27">
                    <c:v>2.2840732035454319E-2</c:v>
                  </c:pt>
                  <c:pt idx="29">
                    <c:v>9.1385873723904165E-2</c:v>
                  </c:pt>
                  <c:pt idx="30">
                    <c:v>8.3023528590906642E-2</c:v>
                  </c:pt>
                  <c:pt idx="31">
                    <c:v>3.0667868110644973E-2</c:v>
                  </c:pt>
                  <c:pt idx="32">
                    <c:v>6.7672761512176216E-2</c:v>
                  </c:pt>
                  <c:pt idx="33">
                    <c:v>8.9712308646514929E-2</c:v>
                  </c:pt>
                  <c:pt idx="34">
                    <c:v>5.8511815009277025E-2</c:v>
                  </c:pt>
                  <c:pt idx="35">
                    <c:v>4.9999999999999996E-2</c:v>
                  </c:pt>
                  <c:pt idx="36">
                    <c:v>5.5554147213157302E-2</c:v>
                  </c:pt>
                </c:numCache>
              </c:numRef>
            </c:plus>
            <c:minus>
              <c:numRef>
                <c:f>组4!$AT$2:$AT$38</c:f>
                <c:numCache>
                  <c:formatCode>General</c:formatCode>
                  <c:ptCount val="37"/>
                  <c:pt idx="0">
                    <c:v>5.3933502159833863E-2</c:v>
                  </c:pt>
                  <c:pt idx="1">
                    <c:v>5.4793308872376725E-2</c:v>
                  </c:pt>
                  <c:pt idx="2">
                    <c:v>7.0180682155617277E-2</c:v>
                  </c:pt>
                  <c:pt idx="3">
                    <c:v>7.0485723612365131E-2</c:v>
                  </c:pt>
                  <c:pt idx="4">
                    <c:v>8.3792589794719929E-2</c:v>
                  </c:pt>
                  <c:pt idx="5">
                    <c:v>6.412942734351551E-2</c:v>
                  </c:pt>
                  <c:pt idx="6">
                    <c:v>8.910781955595895E-2</c:v>
                  </c:pt>
                  <c:pt idx="7">
                    <c:v>8.3532770569077444E-2</c:v>
                  </c:pt>
                  <c:pt idx="11">
                    <c:v>6.331361398726118E-2</c:v>
                  </c:pt>
                  <c:pt idx="12">
                    <c:v>9.325011463257081E-2</c:v>
                  </c:pt>
                  <c:pt idx="13">
                    <c:v>0.10091469708665748</c:v>
                  </c:pt>
                  <c:pt idx="14">
                    <c:v>9.1048933528600592E-2</c:v>
                  </c:pt>
                  <c:pt idx="15">
                    <c:v>7.722051532228047E-2</c:v>
                  </c:pt>
                  <c:pt idx="16">
                    <c:v>0.14465444192885499</c:v>
                  </c:pt>
                  <c:pt idx="17">
                    <c:v>7.9914814003204618E-2</c:v>
                  </c:pt>
                  <c:pt idx="18">
                    <c:v>5.6765492828652661E-2</c:v>
                  </c:pt>
                  <c:pt idx="20">
                    <c:v>6.0593190047845212E-2</c:v>
                  </c:pt>
                  <c:pt idx="21">
                    <c:v>8.844414922827841E-2</c:v>
                  </c:pt>
                  <c:pt idx="22">
                    <c:v>7.701003916584892E-2</c:v>
                  </c:pt>
                  <c:pt idx="23">
                    <c:v>8.1702417316467296E-2</c:v>
                  </c:pt>
                  <c:pt idx="24">
                    <c:v>4.7427289237488339E-2</c:v>
                  </c:pt>
                  <c:pt idx="25">
                    <c:v>3.6769027898554893E-2</c:v>
                  </c:pt>
                  <c:pt idx="26">
                    <c:v>4.6488603080801265E-2</c:v>
                  </c:pt>
                  <c:pt idx="27">
                    <c:v>2.2840732035454319E-2</c:v>
                  </c:pt>
                  <c:pt idx="29">
                    <c:v>9.1385873723904165E-2</c:v>
                  </c:pt>
                  <c:pt idx="30">
                    <c:v>8.3023528590906642E-2</c:v>
                  </c:pt>
                  <c:pt idx="31">
                    <c:v>3.0667868110644973E-2</c:v>
                  </c:pt>
                  <c:pt idx="32">
                    <c:v>6.7672761512176216E-2</c:v>
                  </c:pt>
                  <c:pt idx="33">
                    <c:v>8.9712308646514929E-2</c:v>
                  </c:pt>
                  <c:pt idx="34">
                    <c:v>5.8511815009277025E-2</c:v>
                  </c:pt>
                  <c:pt idx="35">
                    <c:v>4.9999999999999996E-2</c:v>
                  </c:pt>
                  <c:pt idx="36">
                    <c:v>5.5554147213157302E-2</c:v>
                  </c:pt>
                </c:numCache>
              </c:numRef>
            </c:minus>
            <c:spPr>
              <a:noFill/>
              <a:ln w="254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组4!$AQ$2:$AQ$38</c:f>
              <c:numCache>
                <c:formatCode>General</c:formatCode>
                <c:ptCount val="37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11">
                  <c:v>1</c:v>
                </c:pt>
                <c:pt idx="12">
                  <c:v>2</c:v>
                </c:pt>
                <c:pt idx="13">
                  <c:v>3</c:v>
                </c:pt>
                <c:pt idx="14">
                  <c:v>4</c:v>
                </c:pt>
                <c:pt idx="15">
                  <c:v>5</c:v>
                </c:pt>
                <c:pt idx="16">
                  <c:v>6</c:v>
                </c:pt>
                <c:pt idx="17">
                  <c:v>7</c:v>
                </c:pt>
                <c:pt idx="18">
                  <c:v>8</c:v>
                </c:pt>
                <c:pt idx="20">
                  <c:v>1</c:v>
                </c:pt>
                <c:pt idx="21">
                  <c:v>2</c:v>
                </c:pt>
                <c:pt idx="22">
                  <c:v>3</c:v>
                </c:pt>
                <c:pt idx="23">
                  <c:v>4</c:v>
                </c:pt>
                <c:pt idx="24">
                  <c:v>5</c:v>
                </c:pt>
                <c:pt idx="25">
                  <c:v>6</c:v>
                </c:pt>
                <c:pt idx="26">
                  <c:v>7</c:v>
                </c:pt>
                <c:pt idx="27">
                  <c:v>8</c:v>
                </c:pt>
                <c:pt idx="29">
                  <c:v>1</c:v>
                </c:pt>
                <c:pt idx="30">
                  <c:v>2</c:v>
                </c:pt>
                <c:pt idx="31">
                  <c:v>3</c:v>
                </c:pt>
                <c:pt idx="32">
                  <c:v>4</c:v>
                </c:pt>
                <c:pt idx="33">
                  <c:v>5</c:v>
                </c:pt>
                <c:pt idx="34">
                  <c:v>6</c:v>
                </c:pt>
                <c:pt idx="35">
                  <c:v>7</c:v>
                </c:pt>
                <c:pt idx="36">
                  <c:v>8</c:v>
                </c:pt>
              </c:numCache>
            </c:numRef>
          </c:cat>
          <c:val>
            <c:numRef>
              <c:f>组4!$AR$2:$AR$38</c:f>
              <c:numCache>
                <c:formatCode>General</c:formatCode>
                <c:ptCount val="37"/>
                <c:pt idx="0">
                  <c:v>0.60727481739309908</c:v>
                </c:pt>
                <c:pt idx="1">
                  <c:v>0.57457706728113478</c:v>
                </c:pt>
                <c:pt idx="2">
                  <c:v>0.29753820403330405</c:v>
                </c:pt>
                <c:pt idx="3">
                  <c:v>0.36655026195182638</c:v>
                </c:pt>
                <c:pt idx="4">
                  <c:v>0.46295086429309312</c:v>
                </c:pt>
                <c:pt idx="5">
                  <c:v>0.31837589007490491</c:v>
                </c:pt>
                <c:pt idx="6">
                  <c:v>0.3948793418023443</c:v>
                </c:pt>
                <c:pt idx="7">
                  <c:v>0.30992422073012404</c:v>
                </c:pt>
                <c:pt idx="11">
                  <c:v>0.73717455952673583</c:v>
                </c:pt>
                <c:pt idx="12">
                  <c:v>0.50771906709410097</c:v>
                </c:pt>
                <c:pt idx="13">
                  <c:v>0.47089069390887472</c:v>
                </c:pt>
                <c:pt idx="14">
                  <c:v>0.42133437878462782</c:v>
                </c:pt>
                <c:pt idx="15">
                  <c:v>0.24772008891747554</c:v>
                </c:pt>
                <c:pt idx="16">
                  <c:v>0.28528795967746134</c:v>
                </c:pt>
                <c:pt idx="17">
                  <c:v>0.23018452610306078</c:v>
                </c:pt>
                <c:pt idx="18">
                  <c:v>0.11177114774344357</c:v>
                </c:pt>
                <c:pt idx="20">
                  <c:v>0.58882353887891836</c:v>
                </c:pt>
                <c:pt idx="21">
                  <c:v>0.44541945339596312</c:v>
                </c:pt>
                <c:pt idx="22">
                  <c:v>0.32806180506099403</c:v>
                </c:pt>
                <c:pt idx="23">
                  <c:v>0.23964814186270228</c:v>
                </c:pt>
                <c:pt idx="24">
                  <c:v>0.10180022828362141</c:v>
                </c:pt>
                <c:pt idx="25">
                  <c:v>5.2486768990844014E-2</c:v>
                </c:pt>
                <c:pt idx="26">
                  <c:v>0.10099212015824106</c:v>
                </c:pt>
                <c:pt idx="27">
                  <c:v>3.2036127361594967E-2</c:v>
                </c:pt>
                <c:pt idx="29">
                  <c:v>0.49104639490184498</c:v>
                </c:pt>
                <c:pt idx="30">
                  <c:v>0.29420409922392604</c:v>
                </c:pt>
                <c:pt idx="31">
                  <c:v>5.4163441796773071E-2</c:v>
                </c:pt>
                <c:pt idx="32">
                  <c:v>0.15682491755836836</c:v>
                </c:pt>
                <c:pt idx="33">
                  <c:v>0.22518578420673174</c:v>
                </c:pt>
                <c:pt idx="34">
                  <c:v>0.11675555885164912</c:v>
                </c:pt>
                <c:pt idx="35">
                  <c:v>0.05</c:v>
                </c:pt>
                <c:pt idx="36">
                  <c:v>7.5414246478913177E-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6CEB-4249-874B-13EB94F0A68F}"/>
            </c:ext>
          </c:extLst>
        </c:ser>
        <c:ser>
          <c:idx val="1"/>
          <c:order val="1"/>
          <c:tx>
            <c:strRef>
              <c:f>组4!$AS$1</c:f>
              <c:strCache>
                <c:ptCount val="1"/>
                <c:pt idx="0">
                  <c:v>CS-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round/>
              <a:headEnd w="med" len="med"/>
            </a:ln>
            <a:effectLst/>
          </c:spPr>
          <c:marker>
            <c:symbol val="circle"/>
            <c:size val="9"/>
            <c:spPr>
              <a:solidFill>
                <a:sysClr val="windowText" lastClr="000000">
                  <a:alpha val="99000"/>
                </a:sysClr>
              </a:solidFill>
              <a:ln w="19050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组4!$AU$2:$AU$38</c:f>
                <c:numCache>
                  <c:formatCode>General</c:formatCode>
                  <c:ptCount val="37"/>
                  <c:pt idx="0">
                    <c:v>5.3785206499973946E-2</c:v>
                  </c:pt>
                  <c:pt idx="1">
                    <c:v>6.1873464414026517E-2</c:v>
                  </c:pt>
                  <c:pt idx="2">
                    <c:v>6.2140264191811942E-2</c:v>
                  </c:pt>
                  <c:pt idx="3">
                    <c:v>6.0366913016765431E-2</c:v>
                  </c:pt>
                  <c:pt idx="4">
                    <c:v>4.6057780249648662E-2</c:v>
                  </c:pt>
                  <c:pt idx="5">
                    <c:v>4.8272903297315067E-2</c:v>
                  </c:pt>
                  <c:pt idx="6">
                    <c:v>5.9952502652637026E-2</c:v>
                  </c:pt>
                  <c:pt idx="7">
                    <c:v>2.1782123125716594E-2</c:v>
                  </c:pt>
                  <c:pt idx="11">
                    <c:v>8.2397243821433153E-2</c:v>
                  </c:pt>
                  <c:pt idx="12">
                    <c:v>8.946265566603441E-2</c:v>
                  </c:pt>
                  <c:pt idx="13">
                    <c:v>8.3659556076006211E-2</c:v>
                  </c:pt>
                  <c:pt idx="14">
                    <c:v>6.5363475174220156E-2</c:v>
                  </c:pt>
                  <c:pt idx="15">
                    <c:v>5.204769522172676E-2</c:v>
                  </c:pt>
                  <c:pt idx="16">
                    <c:v>8.6617412438390287E-2</c:v>
                  </c:pt>
                  <c:pt idx="17">
                    <c:v>3.0429514029078605E-2</c:v>
                  </c:pt>
                  <c:pt idx="18">
                    <c:v>5.0431226030009171E-2</c:v>
                  </c:pt>
                  <c:pt idx="20">
                    <c:v>6.4208549122642913E-2</c:v>
                  </c:pt>
                  <c:pt idx="21">
                    <c:v>6.4848962948367131E-2</c:v>
                  </c:pt>
                  <c:pt idx="22">
                    <c:v>6.6153611812655611E-2</c:v>
                  </c:pt>
                  <c:pt idx="23">
                    <c:v>5.8741679988920145E-2</c:v>
                  </c:pt>
                  <c:pt idx="24">
                    <c:v>3.9624588024778834E-2</c:v>
                  </c:pt>
                  <c:pt idx="25">
                    <c:v>5.3679435319389554E-2</c:v>
                  </c:pt>
                  <c:pt idx="26">
                    <c:v>5.6490264653451139E-2</c:v>
                  </c:pt>
                  <c:pt idx="27">
                    <c:v>1.3176871400654712E-2</c:v>
                  </c:pt>
                  <c:pt idx="29">
                    <c:v>8.1931768573639249E-2</c:v>
                  </c:pt>
                  <c:pt idx="30">
                    <c:v>6.99711193828257E-2</c:v>
                  </c:pt>
                  <c:pt idx="31">
                    <c:v>7.7042333660437182E-2</c:v>
                  </c:pt>
                  <c:pt idx="32">
                    <c:v>3.6855850128030179E-2</c:v>
                  </c:pt>
                  <c:pt idx="33">
                    <c:v>7.0493271977058222E-2</c:v>
                  </c:pt>
                  <c:pt idx="34">
                    <c:v>3.3854489547236591E-2</c:v>
                  </c:pt>
                  <c:pt idx="35">
                    <c:v>9.6177593084653193E-3</c:v>
                  </c:pt>
                  <c:pt idx="36">
                    <c:v>2.5039609480190572E-2</c:v>
                  </c:pt>
                </c:numCache>
              </c:numRef>
            </c:plus>
            <c:minus>
              <c:numRef>
                <c:f>组4!$AU$2:$AU$38</c:f>
                <c:numCache>
                  <c:formatCode>General</c:formatCode>
                  <c:ptCount val="37"/>
                  <c:pt idx="0">
                    <c:v>5.3785206499973946E-2</c:v>
                  </c:pt>
                  <c:pt idx="1">
                    <c:v>6.1873464414026517E-2</c:v>
                  </c:pt>
                  <c:pt idx="2">
                    <c:v>6.2140264191811942E-2</c:v>
                  </c:pt>
                  <c:pt idx="3">
                    <c:v>6.0366913016765431E-2</c:v>
                  </c:pt>
                  <c:pt idx="4">
                    <c:v>4.6057780249648662E-2</c:v>
                  </c:pt>
                  <c:pt idx="5">
                    <c:v>4.8272903297315067E-2</c:v>
                  </c:pt>
                  <c:pt idx="6">
                    <c:v>5.9952502652637026E-2</c:v>
                  </c:pt>
                  <c:pt idx="7">
                    <c:v>2.1782123125716594E-2</c:v>
                  </c:pt>
                  <c:pt idx="11">
                    <c:v>8.2397243821433153E-2</c:v>
                  </c:pt>
                  <c:pt idx="12">
                    <c:v>8.946265566603441E-2</c:v>
                  </c:pt>
                  <c:pt idx="13">
                    <c:v>8.3659556076006211E-2</c:v>
                  </c:pt>
                  <c:pt idx="14">
                    <c:v>6.5363475174220156E-2</c:v>
                  </c:pt>
                  <c:pt idx="15">
                    <c:v>5.204769522172676E-2</c:v>
                  </c:pt>
                  <c:pt idx="16">
                    <c:v>8.6617412438390287E-2</c:v>
                  </c:pt>
                  <c:pt idx="17">
                    <c:v>3.0429514029078605E-2</c:v>
                  </c:pt>
                  <c:pt idx="18">
                    <c:v>5.0431226030009171E-2</c:v>
                  </c:pt>
                  <c:pt idx="20">
                    <c:v>6.4208549122642913E-2</c:v>
                  </c:pt>
                  <c:pt idx="21">
                    <c:v>6.4848962948367131E-2</c:v>
                  </c:pt>
                  <c:pt idx="22">
                    <c:v>6.6153611812655611E-2</c:v>
                  </c:pt>
                  <c:pt idx="23">
                    <c:v>5.8741679988920145E-2</c:v>
                  </c:pt>
                  <c:pt idx="24">
                    <c:v>3.9624588024778834E-2</c:v>
                  </c:pt>
                  <c:pt idx="25">
                    <c:v>5.3679435319389554E-2</c:v>
                  </c:pt>
                  <c:pt idx="26">
                    <c:v>5.6490264653451139E-2</c:v>
                  </c:pt>
                  <c:pt idx="27">
                    <c:v>1.3176871400654712E-2</c:v>
                  </c:pt>
                  <c:pt idx="29">
                    <c:v>8.1931768573639249E-2</c:v>
                  </c:pt>
                  <c:pt idx="30">
                    <c:v>6.99711193828257E-2</c:v>
                  </c:pt>
                  <c:pt idx="31">
                    <c:v>7.7042333660437182E-2</c:v>
                  </c:pt>
                  <c:pt idx="32">
                    <c:v>3.6855850128030179E-2</c:v>
                  </c:pt>
                  <c:pt idx="33">
                    <c:v>7.0493271977058222E-2</c:v>
                  </c:pt>
                  <c:pt idx="34">
                    <c:v>3.3854489547236591E-2</c:v>
                  </c:pt>
                  <c:pt idx="35">
                    <c:v>9.6177593084653193E-3</c:v>
                  </c:pt>
                  <c:pt idx="36">
                    <c:v>2.5039609480190572E-2</c:v>
                  </c:pt>
                </c:numCache>
              </c:numRef>
            </c:minus>
            <c:spPr>
              <a:noFill/>
              <a:ln w="254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组4!$AQ$2:$AQ$38</c:f>
              <c:numCache>
                <c:formatCode>General</c:formatCode>
                <c:ptCount val="37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11">
                  <c:v>1</c:v>
                </c:pt>
                <c:pt idx="12">
                  <c:v>2</c:v>
                </c:pt>
                <c:pt idx="13">
                  <c:v>3</c:v>
                </c:pt>
                <c:pt idx="14">
                  <c:v>4</c:v>
                </c:pt>
                <c:pt idx="15">
                  <c:v>5</c:v>
                </c:pt>
                <c:pt idx="16">
                  <c:v>6</c:v>
                </c:pt>
                <c:pt idx="17">
                  <c:v>7</c:v>
                </c:pt>
                <c:pt idx="18">
                  <c:v>8</c:v>
                </c:pt>
                <c:pt idx="20">
                  <c:v>1</c:v>
                </c:pt>
                <c:pt idx="21">
                  <c:v>2</c:v>
                </c:pt>
                <c:pt idx="22">
                  <c:v>3</c:v>
                </c:pt>
                <c:pt idx="23">
                  <c:v>4</c:v>
                </c:pt>
                <c:pt idx="24">
                  <c:v>5</c:v>
                </c:pt>
                <c:pt idx="25">
                  <c:v>6</c:v>
                </c:pt>
                <c:pt idx="26">
                  <c:v>7</c:v>
                </c:pt>
                <c:pt idx="27">
                  <c:v>8</c:v>
                </c:pt>
                <c:pt idx="29">
                  <c:v>1</c:v>
                </c:pt>
                <c:pt idx="30">
                  <c:v>2</c:v>
                </c:pt>
                <c:pt idx="31">
                  <c:v>3</c:v>
                </c:pt>
                <c:pt idx="32">
                  <c:v>4</c:v>
                </c:pt>
                <c:pt idx="33">
                  <c:v>5</c:v>
                </c:pt>
                <c:pt idx="34">
                  <c:v>6</c:v>
                </c:pt>
                <c:pt idx="35">
                  <c:v>7</c:v>
                </c:pt>
                <c:pt idx="36">
                  <c:v>8</c:v>
                </c:pt>
              </c:numCache>
            </c:numRef>
          </c:cat>
          <c:val>
            <c:numRef>
              <c:f>组4!$AS$2:$AS$38</c:f>
              <c:numCache>
                <c:formatCode>General</c:formatCode>
                <c:ptCount val="37"/>
                <c:pt idx="0">
                  <c:v>0.72952007521041273</c:v>
                </c:pt>
                <c:pt idx="1">
                  <c:v>0.39170148047277131</c:v>
                </c:pt>
                <c:pt idx="2">
                  <c:v>0.22989706295576928</c:v>
                </c:pt>
                <c:pt idx="3">
                  <c:v>0.21933110436221229</c:v>
                </c:pt>
                <c:pt idx="4">
                  <c:v>0.13603230351437745</c:v>
                </c:pt>
                <c:pt idx="5">
                  <c:v>0.15170058004640521</c:v>
                </c:pt>
                <c:pt idx="6">
                  <c:v>0.14418767951957895</c:v>
                </c:pt>
                <c:pt idx="7">
                  <c:v>2.1782123125716594E-2</c:v>
                </c:pt>
                <c:pt idx="11">
                  <c:v>0.46287180457388527</c:v>
                </c:pt>
                <c:pt idx="12">
                  <c:v>0.4192374295143656</c:v>
                </c:pt>
                <c:pt idx="13">
                  <c:v>0.26949118137390327</c:v>
                </c:pt>
                <c:pt idx="14">
                  <c:v>0.1841342881456213</c:v>
                </c:pt>
                <c:pt idx="15">
                  <c:v>0.13127408631644344</c:v>
                </c:pt>
                <c:pt idx="16">
                  <c:v>0.23570275138040769</c:v>
                </c:pt>
                <c:pt idx="17">
                  <c:v>4.2507452370330337E-2</c:v>
                </c:pt>
                <c:pt idx="18">
                  <c:v>0.10413204685723758</c:v>
                </c:pt>
                <c:pt idx="20">
                  <c:v>0.24085289507303012</c:v>
                </c:pt>
                <c:pt idx="21">
                  <c:v>0.17703344021954437</c:v>
                </c:pt>
                <c:pt idx="22">
                  <c:v>0.14768974245150224</c:v>
                </c:pt>
                <c:pt idx="23">
                  <c:v>0.12867164220260346</c:v>
                </c:pt>
                <c:pt idx="24">
                  <c:v>9.2727425240505382E-2</c:v>
                </c:pt>
                <c:pt idx="25">
                  <c:v>0.12266642597496555</c:v>
                </c:pt>
                <c:pt idx="26">
                  <c:v>0.10084364031078123</c:v>
                </c:pt>
                <c:pt idx="27">
                  <c:v>1.8953958875740761E-2</c:v>
                </c:pt>
                <c:pt idx="29">
                  <c:v>0.20338670112964299</c:v>
                </c:pt>
                <c:pt idx="30">
                  <c:v>0.19554442880020492</c:v>
                </c:pt>
                <c:pt idx="31">
                  <c:v>0.12998418872197759</c:v>
                </c:pt>
                <c:pt idx="32">
                  <c:v>6.3171114367656739E-2</c:v>
                </c:pt>
                <c:pt idx="33">
                  <c:v>0.13910068235950462</c:v>
                </c:pt>
                <c:pt idx="34">
                  <c:v>6.9149107836076598E-2</c:v>
                </c:pt>
                <c:pt idx="35">
                  <c:v>9.6177593084653193E-3</c:v>
                </c:pt>
                <c:pt idx="36">
                  <c:v>3.1175221669928244E-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6CEB-4249-874B-13EB94F0A68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22728960"/>
        <c:axId val="222730496"/>
      </c:lineChart>
      <c:catAx>
        <c:axId val="222728960"/>
        <c:scaling>
          <c:orientation val="minMax"/>
        </c:scaling>
        <c:delete val="0"/>
        <c:axPos val="b"/>
        <c:numFmt formatCode="General" sourceLinked="0"/>
        <c:majorTickMark val="in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ln>
                  <a:solidFill>
                    <a:schemeClr val="tx1"/>
                  </a:solidFill>
                </a:ln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222730496"/>
        <c:crosses val="autoZero"/>
        <c:auto val="1"/>
        <c:lblAlgn val="ctr"/>
        <c:lblOffset val="100"/>
        <c:tickMarkSkip val="1"/>
        <c:noMultiLvlLbl val="0"/>
      </c:catAx>
      <c:valAx>
        <c:axId val="22273049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ln>
                      <a:solidFill>
                        <a:schemeClr val="tx1"/>
                      </a:solidFill>
                    </a:ln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 sz="1800" dirty="0" smtClean="0"/>
                  <a:t>Normalized</a:t>
                </a:r>
                <a:r>
                  <a:rPr lang="en-US" altLang="zh-CN" sz="1800" baseline="0" dirty="0" smtClean="0"/>
                  <a:t> SCR</a:t>
                </a:r>
                <a:endParaRPr lang="zh-CN" altLang="en-US" sz="1800" dirty="0"/>
              </a:p>
            </c:rich>
          </c:tx>
          <c:layout>
            <c:manualLayout>
              <c:xMode val="edge"/>
              <c:yMode val="edge"/>
              <c:x val="9.5742290026246714E-3"/>
              <c:y val="0.20114986166265311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ln>
                  <a:solidFill>
                    <a:schemeClr val="tx1"/>
                  </a:solidFill>
                </a:ln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222728960"/>
        <c:crossesAt val="1"/>
        <c:crossBetween val="between"/>
      </c:valAx>
      <c:spPr>
        <a:noFill/>
        <a:ln>
          <a:noFill/>
        </a:ln>
        <a:effectLst/>
      </c:spPr>
    </c:plotArea>
    <c:legend>
      <c:legendPos val="tr"/>
      <c:layout>
        <c:manualLayout>
          <c:xMode val="edge"/>
          <c:yMode val="edge"/>
          <c:x val="0.88473167576272915"/>
          <c:y val="0.17140560623297343"/>
          <c:w val="9.106197614744399E-2"/>
          <c:h val="0.1763204239687513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ln>
                <a:solidFill>
                  <a:schemeClr val="tx1"/>
                </a:solidFill>
              </a:ln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2">
    <c:autoUpdate val="0"/>
  </c:externalData>
  <c:userShapes r:id="rId3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7.6553512797350398E-2"/>
          <c:y val="0.15426226099704332"/>
          <c:w val="0.92344650530539796"/>
          <c:h val="0.64003698673014908"/>
        </c:manualLayout>
      </c:layout>
      <c:lineChart>
        <c:grouping val="standard"/>
        <c:varyColors val="0"/>
        <c:ser>
          <c:idx val="0"/>
          <c:order val="0"/>
          <c:tx>
            <c:strRef>
              <c:f>组1!$AR$1</c:f>
              <c:strCache>
                <c:ptCount val="1"/>
                <c:pt idx="0">
                  <c:v>CS+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9"/>
            <c:spPr>
              <a:solidFill>
                <a:sysClr val="window" lastClr="FFFFFF"/>
              </a:solidFill>
              <a:ln w="25400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组1!$AT$2:$AT$38</c:f>
                <c:numCache>
                  <c:formatCode>General</c:formatCode>
                  <c:ptCount val="37"/>
                  <c:pt idx="0">
                    <c:v>6.2202425294791933E-2</c:v>
                  </c:pt>
                  <c:pt idx="1">
                    <c:v>8.3868796637037321E-2</c:v>
                  </c:pt>
                  <c:pt idx="2">
                    <c:v>7.6303885326586246E-2</c:v>
                  </c:pt>
                  <c:pt idx="3">
                    <c:v>7.0022264108766649E-2</c:v>
                  </c:pt>
                  <c:pt idx="4">
                    <c:v>7.5721960411579289E-2</c:v>
                  </c:pt>
                  <c:pt idx="5">
                    <c:v>6.7342642801765787E-2</c:v>
                  </c:pt>
                  <c:pt idx="6">
                    <c:v>8.3809168386914171E-2</c:v>
                  </c:pt>
                  <c:pt idx="7">
                    <c:v>9.9625053383573303E-2</c:v>
                  </c:pt>
                  <c:pt idx="9">
                    <c:v>7.043459071366398E-2</c:v>
                  </c:pt>
                  <c:pt idx="11">
                    <c:v>6.9716352011281985E-2</c:v>
                  </c:pt>
                  <c:pt idx="12">
                    <c:v>7.1329356242922665E-2</c:v>
                  </c:pt>
                  <c:pt idx="13">
                    <c:v>0.11305131650860933</c:v>
                  </c:pt>
                  <c:pt idx="14">
                    <c:v>7.9852649452119506E-2</c:v>
                  </c:pt>
                  <c:pt idx="15">
                    <c:v>7.3993132155381544E-2</c:v>
                  </c:pt>
                  <c:pt idx="16">
                    <c:v>6.3177157706624659E-2</c:v>
                  </c:pt>
                  <c:pt idx="17">
                    <c:v>8.0387585787791094E-2</c:v>
                  </c:pt>
                  <c:pt idx="18">
                    <c:v>6.8822259309736691E-2</c:v>
                  </c:pt>
                  <c:pt idx="20">
                    <c:v>5.2807463623707668E-2</c:v>
                  </c:pt>
                  <c:pt idx="21">
                    <c:v>7.5082590623735762E-2</c:v>
                  </c:pt>
                  <c:pt idx="22">
                    <c:v>8.7120489876542015E-2</c:v>
                  </c:pt>
                  <c:pt idx="23">
                    <c:v>7.4298486161449087E-2</c:v>
                  </c:pt>
                  <c:pt idx="24">
                    <c:v>5.2363153980925906E-2</c:v>
                  </c:pt>
                  <c:pt idx="25">
                    <c:v>5.2705572191907579E-2</c:v>
                  </c:pt>
                  <c:pt idx="26">
                    <c:v>7.70446867775373E-2</c:v>
                  </c:pt>
                  <c:pt idx="27">
                    <c:v>4.4309688822389143E-2</c:v>
                  </c:pt>
                  <c:pt idx="29">
                    <c:v>8.5064075940165032E-2</c:v>
                  </c:pt>
                  <c:pt idx="30">
                    <c:v>7.9434324056360486E-2</c:v>
                  </c:pt>
                  <c:pt idx="31">
                    <c:v>8.2871304664102113E-2</c:v>
                  </c:pt>
                  <c:pt idx="32">
                    <c:v>5.6788227892300876E-2</c:v>
                  </c:pt>
                  <c:pt idx="33">
                    <c:v>5.9509167666247781E-2</c:v>
                  </c:pt>
                  <c:pt idx="34">
                    <c:v>6.6621872881949207E-2</c:v>
                  </c:pt>
                  <c:pt idx="35">
                    <c:v>3.2579002200140081E-2</c:v>
                  </c:pt>
                  <c:pt idx="36">
                    <c:v>3.5735613179737766E-2</c:v>
                  </c:pt>
                </c:numCache>
              </c:numRef>
            </c:plus>
            <c:minus>
              <c:numRef>
                <c:f>组1!$AT$2:$AT$38</c:f>
                <c:numCache>
                  <c:formatCode>General</c:formatCode>
                  <c:ptCount val="37"/>
                  <c:pt idx="0">
                    <c:v>6.2202425294791933E-2</c:v>
                  </c:pt>
                  <c:pt idx="1">
                    <c:v>8.3868796637037321E-2</c:v>
                  </c:pt>
                  <c:pt idx="2">
                    <c:v>7.6303885326586246E-2</c:v>
                  </c:pt>
                  <c:pt idx="3">
                    <c:v>7.0022264108766649E-2</c:v>
                  </c:pt>
                  <c:pt idx="4">
                    <c:v>7.5721960411579289E-2</c:v>
                  </c:pt>
                  <c:pt idx="5">
                    <c:v>6.7342642801765787E-2</c:v>
                  </c:pt>
                  <c:pt idx="6">
                    <c:v>8.3809168386914171E-2</c:v>
                  </c:pt>
                  <c:pt idx="7">
                    <c:v>9.9625053383573303E-2</c:v>
                  </c:pt>
                  <c:pt idx="9">
                    <c:v>7.043459071366398E-2</c:v>
                  </c:pt>
                  <c:pt idx="11">
                    <c:v>6.9716352011281985E-2</c:v>
                  </c:pt>
                  <c:pt idx="12">
                    <c:v>7.1329356242922665E-2</c:v>
                  </c:pt>
                  <c:pt idx="13">
                    <c:v>0.11305131650860933</c:v>
                  </c:pt>
                  <c:pt idx="14">
                    <c:v>7.9852649452119506E-2</c:v>
                  </c:pt>
                  <c:pt idx="15">
                    <c:v>7.3993132155381544E-2</c:v>
                  </c:pt>
                  <c:pt idx="16">
                    <c:v>6.3177157706624659E-2</c:v>
                  </c:pt>
                  <c:pt idx="17">
                    <c:v>8.0387585787791094E-2</c:v>
                  </c:pt>
                  <c:pt idx="18">
                    <c:v>6.8822259309736691E-2</c:v>
                  </c:pt>
                  <c:pt idx="20">
                    <c:v>5.2807463623707668E-2</c:v>
                  </c:pt>
                  <c:pt idx="21">
                    <c:v>7.5082590623735762E-2</c:v>
                  </c:pt>
                  <c:pt idx="22">
                    <c:v>8.7120489876542015E-2</c:v>
                  </c:pt>
                  <c:pt idx="23">
                    <c:v>7.4298486161449087E-2</c:v>
                  </c:pt>
                  <c:pt idx="24">
                    <c:v>5.2363153980925906E-2</c:v>
                  </c:pt>
                  <c:pt idx="25">
                    <c:v>5.2705572191907579E-2</c:v>
                  </c:pt>
                  <c:pt idx="26">
                    <c:v>7.70446867775373E-2</c:v>
                  </c:pt>
                  <c:pt idx="27">
                    <c:v>4.4309688822389143E-2</c:v>
                  </c:pt>
                  <c:pt idx="29">
                    <c:v>8.5064075940165032E-2</c:v>
                  </c:pt>
                  <c:pt idx="30">
                    <c:v>7.9434324056360486E-2</c:v>
                  </c:pt>
                  <c:pt idx="31">
                    <c:v>8.2871304664102113E-2</c:v>
                  </c:pt>
                  <c:pt idx="32">
                    <c:v>5.6788227892300876E-2</c:v>
                  </c:pt>
                  <c:pt idx="33">
                    <c:v>5.9509167666247781E-2</c:v>
                  </c:pt>
                  <c:pt idx="34">
                    <c:v>6.6621872881949207E-2</c:v>
                  </c:pt>
                  <c:pt idx="35">
                    <c:v>3.2579002200140081E-2</c:v>
                  </c:pt>
                  <c:pt idx="36">
                    <c:v>3.5735613179737766E-2</c:v>
                  </c:pt>
                </c:numCache>
              </c:numRef>
            </c:minus>
            <c:spPr>
              <a:noFill/>
              <a:ln w="254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组1!$AQ$2:$AQ$38</c:f>
              <c:numCache>
                <c:formatCode>General</c:formatCode>
                <c:ptCount val="37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9">
                  <c:v>1</c:v>
                </c:pt>
                <c:pt idx="11">
                  <c:v>1</c:v>
                </c:pt>
                <c:pt idx="12">
                  <c:v>2</c:v>
                </c:pt>
                <c:pt idx="13">
                  <c:v>3</c:v>
                </c:pt>
                <c:pt idx="14">
                  <c:v>4</c:v>
                </c:pt>
                <c:pt idx="15">
                  <c:v>5</c:v>
                </c:pt>
                <c:pt idx="16">
                  <c:v>6</c:v>
                </c:pt>
                <c:pt idx="17">
                  <c:v>7</c:v>
                </c:pt>
                <c:pt idx="18">
                  <c:v>8</c:v>
                </c:pt>
                <c:pt idx="20">
                  <c:v>1</c:v>
                </c:pt>
                <c:pt idx="21">
                  <c:v>2</c:v>
                </c:pt>
                <c:pt idx="22">
                  <c:v>3</c:v>
                </c:pt>
                <c:pt idx="23">
                  <c:v>4</c:v>
                </c:pt>
                <c:pt idx="24">
                  <c:v>5</c:v>
                </c:pt>
                <c:pt idx="25">
                  <c:v>6</c:v>
                </c:pt>
                <c:pt idx="26">
                  <c:v>7</c:v>
                </c:pt>
                <c:pt idx="27">
                  <c:v>8</c:v>
                </c:pt>
                <c:pt idx="29">
                  <c:v>1</c:v>
                </c:pt>
                <c:pt idx="30">
                  <c:v>2</c:v>
                </c:pt>
                <c:pt idx="31">
                  <c:v>3</c:v>
                </c:pt>
                <c:pt idx="32">
                  <c:v>4</c:v>
                </c:pt>
                <c:pt idx="33">
                  <c:v>5</c:v>
                </c:pt>
                <c:pt idx="34">
                  <c:v>6</c:v>
                </c:pt>
                <c:pt idx="35">
                  <c:v>7</c:v>
                </c:pt>
                <c:pt idx="36">
                  <c:v>8</c:v>
                </c:pt>
              </c:numCache>
            </c:numRef>
          </c:cat>
          <c:val>
            <c:numRef>
              <c:f>组1!$AR$2:$AR$38</c:f>
              <c:numCache>
                <c:formatCode>General</c:formatCode>
                <c:ptCount val="37"/>
                <c:pt idx="0">
                  <c:v>0.55994669898394256</c:v>
                </c:pt>
                <c:pt idx="1">
                  <c:v>0.54785597882074932</c:v>
                </c:pt>
                <c:pt idx="2">
                  <c:v>0.4573028836429569</c:v>
                </c:pt>
                <c:pt idx="3">
                  <c:v>0.50940955830192447</c:v>
                </c:pt>
                <c:pt idx="4">
                  <c:v>0.4686010461621346</c:v>
                </c:pt>
                <c:pt idx="5">
                  <c:v>0.41821482898784634</c:v>
                </c:pt>
                <c:pt idx="6">
                  <c:v>0.49039945355253628</c:v>
                </c:pt>
                <c:pt idx="7">
                  <c:v>0.43741077367448067</c:v>
                </c:pt>
                <c:pt idx="9">
                  <c:v>0.70974037767787113</c:v>
                </c:pt>
                <c:pt idx="11">
                  <c:v>0.76444445626281898</c:v>
                </c:pt>
                <c:pt idx="12">
                  <c:v>0.66394371153173759</c:v>
                </c:pt>
                <c:pt idx="13">
                  <c:v>0.41320075245792037</c:v>
                </c:pt>
                <c:pt idx="14">
                  <c:v>0.35236575431916795</c:v>
                </c:pt>
                <c:pt idx="15">
                  <c:v>0.23660909980713263</c:v>
                </c:pt>
                <c:pt idx="16">
                  <c:v>0.15570888041121025</c:v>
                </c:pt>
                <c:pt idx="17">
                  <c:v>0.23364350625684968</c:v>
                </c:pt>
                <c:pt idx="18">
                  <c:v>0.15967479996629108</c:v>
                </c:pt>
                <c:pt idx="20">
                  <c:v>0.61832508493747995</c:v>
                </c:pt>
                <c:pt idx="21">
                  <c:v>0.46256309723044031</c:v>
                </c:pt>
                <c:pt idx="22">
                  <c:v>0.45430295586326269</c:v>
                </c:pt>
                <c:pt idx="23">
                  <c:v>0.22712390194447035</c:v>
                </c:pt>
                <c:pt idx="24">
                  <c:v>0.12611993818369899</c:v>
                </c:pt>
                <c:pt idx="25">
                  <c:v>0.14312713349407954</c:v>
                </c:pt>
                <c:pt idx="26">
                  <c:v>0.17134341730748709</c:v>
                </c:pt>
                <c:pt idx="27">
                  <c:v>7.5063388559772001E-2</c:v>
                </c:pt>
                <c:pt idx="29">
                  <c:v>0.50301061270246783</c:v>
                </c:pt>
                <c:pt idx="30">
                  <c:v>0.26518472838749785</c:v>
                </c:pt>
                <c:pt idx="31">
                  <c:v>0.20878626288712393</c:v>
                </c:pt>
                <c:pt idx="32">
                  <c:v>0.11189790422581133</c:v>
                </c:pt>
                <c:pt idx="33">
                  <c:v>0.14657994364012336</c:v>
                </c:pt>
                <c:pt idx="34">
                  <c:v>0.12944089310138779</c:v>
                </c:pt>
                <c:pt idx="35">
                  <c:v>3.838050151826293E-2</c:v>
                </c:pt>
                <c:pt idx="36">
                  <c:v>6.4372982758728298E-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05CE-45BC-A666-3E9FFA1A3941}"/>
            </c:ext>
          </c:extLst>
        </c:ser>
        <c:ser>
          <c:idx val="1"/>
          <c:order val="1"/>
          <c:tx>
            <c:strRef>
              <c:f>组1!$AS$1</c:f>
              <c:strCache>
                <c:ptCount val="1"/>
                <c:pt idx="0">
                  <c:v>CS-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round/>
              <a:headEnd w="med" len="med"/>
            </a:ln>
            <a:effectLst/>
          </c:spPr>
          <c:marker>
            <c:symbol val="circle"/>
            <c:size val="9"/>
            <c:spPr>
              <a:solidFill>
                <a:sysClr val="windowText" lastClr="000000">
                  <a:alpha val="99000"/>
                </a:sysClr>
              </a:solidFill>
              <a:ln w="19050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组1!$AU$2:$AU$38</c:f>
                <c:numCache>
                  <c:formatCode>General</c:formatCode>
                  <c:ptCount val="37"/>
                  <c:pt idx="0">
                    <c:v>6.3791944177587545E-2</c:v>
                  </c:pt>
                  <c:pt idx="1">
                    <c:v>7.141239573321885E-2</c:v>
                  </c:pt>
                  <c:pt idx="2">
                    <c:v>6.9368433288733544E-2</c:v>
                  </c:pt>
                  <c:pt idx="3">
                    <c:v>6.4650284613873066E-2</c:v>
                  </c:pt>
                  <c:pt idx="4">
                    <c:v>5.4937414302893797E-2</c:v>
                  </c:pt>
                  <c:pt idx="5">
                    <c:v>5.2930070354704449E-2</c:v>
                  </c:pt>
                  <c:pt idx="6">
                    <c:v>4.349046839702856E-2</c:v>
                  </c:pt>
                  <c:pt idx="7">
                    <c:v>4.4117256060748691E-2</c:v>
                  </c:pt>
                  <c:pt idx="11">
                    <c:v>9.5444702873997159E-2</c:v>
                  </c:pt>
                  <c:pt idx="12">
                    <c:v>8.6650219503054099E-2</c:v>
                  </c:pt>
                  <c:pt idx="13">
                    <c:v>7.5826491252458814E-2</c:v>
                  </c:pt>
                  <c:pt idx="14">
                    <c:v>8.6239831588642873E-2</c:v>
                  </c:pt>
                  <c:pt idx="15">
                    <c:v>8.4159118515816533E-2</c:v>
                  </c:pt>
                  <c:pt idx="16">
                    <c:v>7.4972346421726288E-2</c:v>
                  </c:pt>
                  <c:pt idx="17">
                    <c:v>6.5399136748237802E-2</c:v>
                  </c:pt>
                  <c:pt idx="18">
                    <c:v>6.2379792288681735E-2</c:v>
                  </c:pt>
                  <c:pt idx="20">
                    <c:v>8.569967771673484E-2</c:v>
                  </c:pt>
                  <c:pt idx="21">
                    <c:v>8.228979930286727E-2</c:v>
                  </c:pt>
                  <c:pt idx="22">
                    <c:v>6.287351684198958E-2</c:v>
                  </c:pt>
                  <c:pt idx="23">
                    <c:v>3.4266586412904858E-2</c:v>
                  </c:pt>
                  <c:pt idx="24">
                    <c:v>7.322328701751972E-2</c:v>
                  </c:pt>
                  <c:pt idx="25">
                    <c:v>3.3349789061366986E-2</c:v>
                  </c:pt>
                  <c:pt idx="26">
                    <c:v>2.183261214742311E-2</c:v>
                  </c:pt>
                  <c:pt idx="27">
                    <c:v>5.3104803500746055E-2</c:v>
                  </c:pt>
                  <c:pt idx="29">
                    <c:v>7.9869893169852393E-2</c:v>
                  </c:pt>
                  <c:pt idx="30">
                    <c:v>8.3091922262698445E-2</c:v>
                  </c:pt>
                  <c:pt idx="31">
                    <c:v>5.8070331541296837E-2</c:v>
                  </c:pt>
                  <c:pt idx="32">
                    <c:v>5.6299024336343401E-2</c:v>
                  </c:pt>
                  <c:pt idx="33">
                    <c:v>5.8517579863845356E-2</c:v>
                  </c:pt>
                  <c:pt idx="34">
                    <c:v>4.3334916316250228E-2</c:v>
                  </c:pt>
                  <c:pt idx="35">
                    <c:v>4.1647832365697156E-2</c:v>
                  </c:pt>
                  <c:pt idx="36">
                    <c:v>3.9450377998216858E-2</c:v>
                  </c:pt>
                </c:numCache>
              </c:numRef>
            </c:plus>
            <c:minus>
              <c:numRef>
                <c:f>组1!$AU$2:$AU$38</c:f>
                <c:numCache>
                  <c:formatCode>General</c:formatCode>
                  <c:ptCount val="37"/>
                  <c:pt idx="0">
                    <c:v>6.3791944177587545E-2</c:v>
                  </c:pt>
                  <c:pt idx="1">
                    <c:v>7.141239573321885E-2</c:v>
                  </c:pt>
                  <c:pt idx="2">
                    <c:v>6.9368433288733544E-2</c:v>
                  </c:pt>
                  <c:pt idx="3">
                    <c:v>6.4650284613873066E-2</c:v>
                  </c:pt>
                  <c:pt idx="4">
                    <c:v>5.4937414302893797E-2</c:v>
                  </c:pt>
                  <c:pt idx="5">
                    <c:v>5.2930070354704449E-2</c:v>
                  </c:pt>
                  <c:pt idx="6">
                    <c:v>4.349046839702856E-2</c:v>
                  </c:pt>
                  <c:pt idx="7">
                    <c:v>4.4117256060748691E-2</c:v>
                  </c:pt>
                  <c:pt idx="11">
                    <c:v>9.5444702873997159E-2</c:v>
                  </c:pt>
                  <c:pt idx="12">
                    <c:v>8.6650219503054099E-2</c:v>
                  </c:pt>
                  <c:pt idx="13">
                    <c:v>7.5826491252458814E-2</c:v>
                  </c:pt>
                  <c:pt idx="14">
                    <c:v>8.6239831588642873E-2</c:v>
                  </c:pt>
                  <c:pt idx="15">
                    <c:v>8.4159118515816533E-2</c:v>
                  </c:pt>
                  <c:pt idx="16">
                    <c:v>7.4972346421726288E-2</c:v>
                  </c:pt>
                  <c:pt idx="17">
                    <c:v>6.5399136748237802E-2</c:v>
                  </c:pt>
                  <c:pt idx="18">
                    <c:v>6.2379792288681735E-2</c:v>
                  </c:pt>
                  <c:pt idx="20">
                    <c:v>8.569967771673484E-2</c:v>
                  </c:pt>
                  <c:pt idx="21">
                    <c:v>8.228979930286727E-2</c:v>
                  </c:pt>
                  <c:pt idx="22">
                    <c:v>6.287351684198958E-2</c:v>
                  </c:pt>
                  <c:pt idx="23">
                    <c:v>3.4266586412904858E-2</c:v>
                  </c:pt>
                  <c:pt idx="24">
                    <c:v>7.322328701751972E-2</c:v>
                  </c:pt>
                  <c:pt idx="25">
                    <c:v>3.3349789061366986E-2</c:v>
                  </c:pt>
                  <c:pt idx="26">
                    <c:v>2.183261214742311E-2</c:v>
                  </c:pt>
                  <c:pt idx="27">
                    <c:v>5.3104803500746055E-2</c:v>
                  </c:pt>
                  <c:pt idx="29">
                    <c:v>7.9869893169852393E-2</c:v>
                  </c:pt>
                  <c:pt idx="30">
                    <c:v>8.3091922262698445E-2</c:v>
                  </c:pt>
                  <c:pt idx="31">
                    <c:v>5.8070331541296837E-2</c:v>
                  </c:pt>
                  <c:pt idx="32">
                    <c:v>5.6299024336343401E-2</c:v>
                  </c:pt>
                  <c:pt idx="33">
                    <c:v>5.8517579863845356E-2</c:v>
                  </c:pt>
                  <c:pt idx="34">
                    <c:v>4.3334916316250228E-2</c:v>
                  </c:pt>
                  <c:pt idx="35">
                    <c:v>4.1647832365697156E-2</c:v>
                  </c:pt>
                  <c:pt idx="36">
                    <c:v>3.9450377998216858E-2</c:v>
                  </c:pt>
                </c:numCache>
              </c:numRef>
            </c:minus>
            <c:spPr>
              <a:noFill/>
              <a:ln w="254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组1!$AQ$2:$AQ$38</c:f>
              <c:numCache>
                <c:formatCode>General</c:formatCode>
                <c:ptCount val="37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9">
                  <c:v>1</c:v>
                </c:pt>
                <c:pt idx="11">
                  <c:v>1</c:v>
                </c:pt>
                <c:pt idx="12">
                  <c:v>2</c:v>
                </c:pt>
                <c:pt idx="13">
                  <c:v>3</c:v>
                </c:pt>
                <c:pt idx="14">
                  <c:v>4</c:v>
                </c:pt>
                <c:pt idx="15">
                  <c:v>5</c:v>
                </c:pt>
                <c:pt idx="16">
                  <c:v>6</c:v>
                </c:pt>
                <c:pt idx="17">
                  <c:v>7</c:v>
                </c:pt>
                <c:pt idx="18">
                  <c:v>8</c:v>
                </c:pt>
                <c:pt idx="20">
                  <c:v>1</c:v>
                </c:pt>
                <c:pt idx="21">
                  <c:v>2</c:v>
                </c:pt>
                <c:pt idx="22">
                  <c:v>3</c:v>
                </c:pt>
                <c:pt idx="23">
                  <c:v>4</c:v>
                </c:pt>
                <c:pt idx="24">
                  <c:v>5</c:v>
                </c:pt>
                <c:pt idx="25">
                  <c:v>6</c:v>
                </c:pt>
                <c:pt idx="26">
                  <c:v>7</c:v>
                </c:pt>
                <c:pt idx="27">
                  <c:v>8</c:v>
                </c:pt>
                <c:pt idx="29">
                  <c:v>1</c:v>
                </c:pt>
                <c:pt idx="30">
                  <c:v>2</c:v>
                </c:pt>
                <c:pt idx="31">
                  <c:v>3</c:v>
                </c:pt>
                <c:pt idx="32">
                  <c:v>4</c:v>
                </c:pt>
                <c:pt idx="33">
                  <c:v>5</c:v>
                </c:pt>
                <c:pt idx="34">
                  <c:v>6</c:v>
                </c:pt>
                <c:pt idx="35">
                  <c:v>7</c:v>
                </c:pt>
                <c:pt idx="36">
                  <c:v>8</c:v>
                </c:pt>
              </c:numCache>
            </c:numRef>
          </c:cat>
          <c:val>
            <c:numRef>
              <c:f>组1!$AS$2:$AS$38</c:f>
              <c:numCache>
                <c:formatCode>General</c:formatCode>
                <c:ptCount val="37"/>
                <c:pt idx="0">
                  <c:v>0.66335321119459478</c:v>
                </c:pt>
                <c:pt idx="1">
                  <c:v>0.37199783652508295</c:v>
                </c:pt>
                <c:pt idx="2">
                  <c:v>0.37693317141916338</c:v>
                </c:pt>
                <c:pt idx="3">
                  <c:v>0.24498943179951102</c:v>
                </c:pt>
                <c:pt idx="4">
                  <c:v>0.19234229381781026</c:v>
                </c:pt>
                <c:pt idx="5">
                  <c:v>0.1255226557537294</c:v>
                </c:pt>
                <c:pt idx="6">
                  <c:v>0.10674302057054134</c:v>
                </c:pt>
                <c:pt idx="7">
                  <c:v>0.10510768686734409</c:v>
                </c:pt>
                <c:pt idx="11">
                  <c:v>0.44850203601180605</c:v>
                </c:pt>
                <c:pt idx="12">
                  <c:v>0.33143792075610962</c:v>
                </c:pt>
                <c:pt idx="13">
                  <c:v>0.31237096664027708</c:v>
                </c:pt>
                <c:pt idx="14">
                  <c:v>0.26958166445249104</c:v>
                </c:pt>
                <c:pt idx="15">
                  <c:v>0.21869203670650844</c:v>
                </c:pt>
                <c:pt idx="16">
                  <c:v>0.20894934790461361</c:v>
                </c:pt>
                <c:pt idx="17">
                  <c:v>0.17382066410612612</c:v>
                </c:pt>
                <c:pt idx="18">
                  <c:v>0.110082588407862</c:v>
                </c:pt>
                <c:pt idx="20">
                  <c:v>0.2594762333269397</c:v>
                </c:pt>
                <c:pt idx="21">
                  <c:v>0.22197500157560096</c:v>
                </c:pt>
                <c:pt idx="22">
                  <c:v>0.14094456803065319</c:v>
                </c:pt>
                <c:pt idx="23">
                  <c:v>5.8510823620353411E-2</c:v>
                </c:pt>
                <c:pt idx="24">
                  <c:v>0.17711747079164147</c:v>
                </c:pt>
                <c:pt idx="25">
                  <c:v>6.5549277378387366E-2</c:v>
                </c:pt>
                <c:pt idx="26">
                  <c:v>3.6121350965759594E-2</c:v>
                </c:pt>
                <c:pt idx="27">
                  <c:v>6.3809815405658138E-2</c:v>
                </c:pt>
                <c:pt idx="29">
                  <c:v>0.18362554585130725</c:v>
                </c:pt>
                <c:pt idx="30">
                  <c:v>0.19180442095251218</c:v>
                </c:pt>
                <c:pt idx="31">
                  <c:v>0.13826303753266941</c:v>
                </c:pt>
                <c:pt idx="32">
                  <c:v>0.10122347152135611</c:v>
                </c:pt>
                <c:pt idx="33">
                  <c:v>7.2888598624962067E-2</c:v>
                </c:pt>
                <c:pt idx="34">
                  <c:v>8.5085224010600272E-2</c:v>
                </c:pt>
                <c:pt idx="35">
                  <c:v>8.7575267036830232E-2</c:v>
                </c:pt>
                <c:pt idx="36">
                  <c:v>6.5277921676966263E-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05CE-45BC-A666-3E9FFA1A394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23323264"/>
        <c:axId val="223324800"/>
      </c:lineChart>
      <c:catAx>
        <c:axId val="223323264"/>
        <c:scaling>
          <c:orientation val="minMax"/>
        </c:scaling>
        <c:delete val="0"/>
        <c:axPos val="b"/>
        <c:numFmt formatCode="General" sourceLinked="0"/>
        <c:majorTickMark val="in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ln>
                  <a:solidFill>
                    <a:schemeClr val="tx1"/>
                  </a:solidFill>
                </a:ln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223324800"/>
        <c:crosses val="autoZero"/>
        <c:auto val="1"/>
        <c:lblAlgn val="ctr"/>
        <c:lblOffset val="100"/>
        <c:tickMarkSkip val="1"/>
        <c:noMultiLvlLbl val="0"/>
      </c:catAx>
      <c:valAx>
        <c:axId val="22332480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ln>
                      <a:solidFill>
                        <a:schemeClr val="tx1"/>
                      </a:solidFill>
                    </a:ln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 sz="1800" dirty="0" smtClean="0"/>
                  <a:t>Normalized</a:t>
                </a:r>
                <a:r>
                  <a:rPr lang="en-US" altLang="zh-CN" sz="1800" baseline="0" dirty="0" smtClean="0"/>
                  <a:t> SCR</a:t>
                </a:r>
                <a:endParaRPr lang="zh-CN" altLang="en-US" sz="1800" dirty="0"/>
              </a:p>
            </c:rich>
          </c:tx>
          <c:layout>
            <c:manualLayout>
              <c:xMode val="edge"/>
              <c:yMode val="edge"/>
              <c:x val="1.1678620402383736E-2"/>
              <c:y val="0.19992581907371929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ln>
                  <a:solidFill>
                    <a:schemeClr val="tx1"/>
                  </a:solidFill>
                </a:ln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223323264"/>
        <c:crossesAt val="1"/>
        <c:crossBetween val="between"/>
      </c:valAx>
      <c:spPr>
        <a:noFill/>
        <a:ln>
          <a:noFill/>
        </a:ln>
        <a:effectLst/>
      </c:spPr>
    </c:plotArea>
    <c:legend>
      <c:legendPos val="tr"/>
      <c:layout>
        <c:manualLayout>
          <c:xMode val="edge"/>
          <c:yMode val="edge"/>
          <c:x val="0.88473167576272915"/>
          <c:y val="0.17140560623297343"/>
          <c:w val="9.106197614744399E-2"/>
          <c:h val="0.1763204239687513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ln>
                <a:solidFill>
                  <a:schemeClr val="tx1"/>
                </a:solidFill>
              </a:ln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2">
    <c:autoUpdate val="0"/>
  </c:externalData>
  <c:userShapes r:id="rId3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7.4165278675436819E-2"/>
          <c:y val="0.15426232082895869"/>
          <c:w val="0.92344650530539796"/>
          <c:h val="0.64003698673014908"/>
        </c:manualLayout>
      </c:layout>
      <c:lineChart>
        <c:grouping val="standard"/>
        <c:varyColors val="0"/>
        <c:ser>
          <c:idx val="0"/>
          <c:order val="0"/>
          <c:tx>
            <c:strRef>
              <c:f>组2!$AR$1</c:f>
              <c:strCache>
                <c:ptCount val="1"/>
                <c:pt idx="0">
                  <c:v>CS+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9"/>
            <c:spPr>
              <a:solidFill>
                <a:sysClr val="window" lastClr="FFFFFF"/>
              </a:solidFill>
              <a:ln w="25400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组2!$AT$2:$AT$38</c:f>
                <c:numCache>
                  <c:formatCode>General</c:formatCode>
                  <c:ptCount val="37"/>
                  <c:pt idx="0">
                    <c:v>7.2684256919500617E-2</c:v>
                  </c:pt>
                  <c:pt idx="1">
                    <c:v>6.0923911803687725E-2</c:v>
                  </c:pt>
                  <c:pt idx="2">
                    <c:v>7.1865173878611327E-2</c:v>
                  </c:pt>
                  <c:pt idx="3">
                    <c:v>5.9741410941510788E-2</c:v>
                  </c:pt>
                  <c:pt idx="4">
                    <c:v>6.3619841407762126E-2</c:v>
                  </c:pt>
                  <c:pt idx="5">
                    <c:v>7.0078813935414513E-2</c:v>
                  </c:pt>
                  <c:pt idx="6">
                    <c:v>6.1574242970526299E-2</c:v>
                  </c:pt>
                  <c:pt idx="7">
                    <c:v>5.6226301322956869E-2</c:v>
                  </c:pt>
                  <c:pt idx="9">
                    <c:v>5.825404054782013E-2</c:v>
                  </c:pt>
                  <c:pt idx="11">
                    <c:v>5.5734548390785746E-2</c:v>
                  </c:pt>
                  <c:pt idx="12">
                    <c:v>8.4962119924417351E-2</c:v>
                  </c:pt>
                  <c:pt idx="13">
                    <c:v>9.2119502021145425E-2</c:v>
                  </c:pt>
                  <c:pt idx="14">
                    <c:v>8.1651236344502887E-2</c:v>
                  </c:pt>
                  <c:pt idx="15">
                    <c:v>7.1502916599282443E-2</c:v>
                  </c:pt>
                  <c:pt idx="16">
                    <c:v>8.4489974347146571E-2</c:v>
                  </c:pt>
                  <c:pt idx="17">
                    <c:v>6.202562989917678E-2</c:v>
                  </c:pt>
                  <c:pt idx="18">
                    <c:v>3.1969393312074455E-2</c:v>
                  </c:pt>
                  <c:pt idx="20">
                    <c:v>4.4341361623685474E-2</c:v>
                  </c:pt>
                  <c:pt idx="21">
                    <c:v>5.4641586168163309E-2</c:v>
                  </c:pt>
                  <c:pt idx="22">
                    <c:v>5.4867613590572774E-2</c:v>
                  </c:pt>
                  <c:pt idx="23">
                    <c:v>6.013509721138996E-2</c:v>
                  </c:pt>
                  <c:pt idx="24">
                    <c:v>5.9700158101273403E-2</c:v>
                  </c:pt>
                  <c:pt idx="25">
                    <c:v>4.4650420571814106E-2</c:v>
                  </c:pt>
                  <c:pt idx="26">
                    <c:v>4.2619592603134408E-2</c:v>
                  </c:pt>
                  <c:pt idx="27">
                    <c:v>3.778060162852611E-2</c:v>
                  </c:pt>
                  <c:pt idx="29">
                    <c:v>6.0492390622098866E-2</c:v>
                  </c:pt>
                  <c:pt idx="30">
                    <c:v>5.4301387063336717E-2</c:v>
                  </c:pt>
                  <c:pt idx="31">
                    <c:v>6.0104113371762108E-2</c:v>
                  </c:pt>
                  <c:pt idx="32">
                    <c:v>4.2154211721966255E-2</c:v>
                  </c:pt>
                  <c:pt idx="33">
                    <c:v>4.4434997292129762E-2</c:v>
                  </c:pt>
                  <c:pt idx="34">
                    <c:v>5.0310445466679524E-2</c:v>
                  </c:pt>
                  <c:pt idx="35">
                    <c:v>5.0024228506950007E-2</c:v>
                  </c:pt>
                  <c:pt idx="36">
                    <c:v>4.061605599896885E-2</c:v>
                  </c:pt>
                </c:numCache>
              </c:numRef>
            </c:plus>
            <c:minus>
              <c:numRef>
                <c:f>组2!$AT$2:$AT$38</c:f>
                <c:numCache>
                  <c:formatCode>General</c:formatCode>
                  <c:ptCount val="37"/>
                  <c:pt idx="0">
                    <c:v>7.2684256919500617E-2</c:v>
                  </c:pt>
                  <c:pt idx="1">
                    <c:v>6.0923911803687725E-2</c:v>
                  </c:pt>
                  <c:pt idx="2">
                    <c:v>7.1865173878611327E-2</c:v>
                  </c:pt>
                  <c:pt idx="3">
                    <c:v>5.9741410941510788E-2</c:v>
                  </c:pt>
                  <c:pt idx="4">
                    <c:v>6.3619841407762126E-2</c:v>
                  </c:pt>
                  <c:pt idx="5">
                    <c:v>7.0078813935414513E-2</c:v>
                  </c:pt>
                  <c:pt idx="6">
                    <c:v>6.1574242970526299E-2</c:v>
                  </c:pt>
                  <c:pt idx="7">
                    <c:v>5.6226301322956869E-2</c:v>
                  </c:pt>
                  <c:pt idx="9">
                    <c:v>5.825404054782013E-2</c:v>
                  </c:pt>
                  <c:pt idx="11">
                    <c:v>5.5734548390785746E-2</c:v>
                  </c:pt>
                  <c:pt idx="12">
                    <c:v>8.4962119924417351E-2</c:v>
                  </c:pt>
                  <c:pt idx="13">
                    <c:v>9.2119502021145425E-2</c:v>
                  </c:pt>
                  <c:pt idx="14">
                    <c:v>8.1651236344502887E-2</c:v>
                  </c:pt>
                  <c:pt idx="15">
                    <c:v>7.1502916599282443E-2</c:v>
                  </c:pt>
                  <c:pt idx="16">
                    <c:v>8.4489974347146571E-2</c:v>
                  </c:pt>
                  <c:pt idx="17">
                    <c:v>6.202562989917678E-2</c:v>
                  </c:pt>
                  <c:pt idx="18">
                    <c:v>3.1969393312074455E-2</c:v>
                  </c:pt>
                  <c:pt idx="20">
                    <c:v>4.4341361623685474E-2</c:v>
                  </c:pt>
                  <c:pt idx="21">
                    <c:v>5.4641586168163309E-2</c:v>
                  </c:pt>
                  <c:pt idx="22">
                    <c:v>5.4867613590572774E-2</c:v>
                  </c:pt>
                  <c:pt idx="23">
                    <c:v>6.013509721138996E-2</c:v>
                  </c:pt>
                  <c:pt idx="24">
                    <c:v>5.9700158101273403E-2</c:v>
                  </c:pt>
                  <c:pt idx="25">
                    <c:v>4.4650420571814106E-2</c:v>
                  </c:pt>
                  <c:pt idx="26">
                    <c:v>4.2619592603134408E-2</c:v>
                  </c:pt>
                  <c:pt idx="27">
                    <c:v>3.778060162852611E-2</c:v>
                  </c:pt>
                  <c:pt idx="29">
                    <c:v>6.0492390622098866E-2</c:v>
                  </c:pt>
                  <c:pt idx="30">
                    <c:v>5.4301387063336717E-2</c:v>
                  </c:pt>
                  <c:pt idx="31">
                    <c:v>6.0104113371762108E-2</c:v>
                  </c:pt>
                  <c:pt idx="32">
                    <c:v>4.2154211721966255E-2</c:v>
                  </c:pt>
                  <c:pt idx="33">
                    <c:v>4.4434997292129762E-2</c:v>
                  </c:pt>
                  <c:pt idx="34">
                    <c:v>5.0310445466679524E-2</c:v>
                  </c:pt>
                  <c:pt idx="35">
                    <c:v>5.0024228506950007E-2</c:v>
                  </c:pt>
                  <c:pt idx="36">
                    <c:v>4.061605599896885E-2</c:v>
                  </c:pt>
                </c:numCache>
              </c:numRef>
            </c:minus>
            <c:spPr>
              <a:noFill/>
              <a:ln w="254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组2!$AQ$2:$AQ$38</c:f>
              <c:numCache>
                <c:formatCode>General</c:formatCode>
                <c:ptCount val="37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9">
                  <c:v>1</c:v>
                </c:pt>
                <c:pt idx="11">
                  <c:v>1</c:v>
                </c:pt>
                <c:pt idx="12">
                  <c:v>2</c:v>
                </c:pt>
                <c:pt idx="13">
                  <c:v>3</c:v>
                </c:pt>
                <c:pt idx="14">
                  <c:v>4</c:v>
                </c:pt>
                <c:pt idx="15">
                  <c:v>5</c:v>
                </c:pt>
                <c:pt idx="16">
                  <c:v>6</c:v>
                </c:pt>
                <c:pt idx="17">
                  <c:v>7</c:v>
                </c:pt>
                <c:pt idx="18">
                  <c:v>8</c:v>
                </c:pt>
                <c:pt idx="20">
                  <c:v>1</c:v>
                </c:pt>
                <c:pt idx="21">
                  <c:v>2</c:v>
                </c:pt>
                <c:pt idx="22">
                  <c:v>3</c:v>
                </c:pt>
                <c:pt idx="23">
                  <c:v>4</c:v>
                </c:pt>
                <c:pt idx="24">
                  <c:v>5</c:v>
                </c:pt>
                <c:pt idx="25">
                  <c:v>6</c:v>
                </c:pt>
                <c:pt idx="26">
                  <c:v>7</c:v>
                </c:pt>
                <c:pt idx="27">
                  <c:v>8</c:v>
                </c:pt>
                <c:pt idx="29">
                  <c:v>1</c:v>
                </c:pt>
                <c:pt idx="30">
                  <c:v>2</c:v>
                </c:pt>
                <c:pt idx="31">
                  <c:v>3</c:v>
                </c:pt>
                <c:pt idx="32">
                  <c:v>4</c:v>
                </c:pt>
                <c:pt idx="33">
                  <c:v>5</c:v>
                </c:pt>
                <c:pt idx="34">
                  <c:v>6</c:v>
                </c:pt>
                <c:pt idx="35">
                  <c:v>7</c:v>
                </c:pt>
                <c:pt idx="36">
                  <c:v>8</c:v>
                </c:pt>
              </c:numCache>
            </c:numRef>
          </c:cat>
          <c:val>
            <c:numRef>
              <c:f>组2!$AR$2:$AR$38</c:f>
              <c:numCache>
                <c:formatCode>General</c:formatCode>
                <c:ptCount val="37"/>
                <c:pt idx="0">
                  <c:v>0.49279945400957648</c:v>
                </c:pt>
                <c:pt idx="1">
                  <c:v>0.52970837343753674</c:v>
                </c:pt>
                <c:pt idx="2">
                  <c:v>0.47809287248656585</c:v>
                </c:pt>
                <c:pt idx="3">
                  <c:v>0.42802631985082346</c:v>
                </c:pt>
                <c:pt idx="4">
                  <c:v>0.48367144680066498</c:v>
                </c:pt>
                <c:pt idx="5">
                  <c:v>0.42574917274992413</c:v>
                </c:pt>
                <c:pt idx="6">
                  <c:v>0.44629470068037974</c:v>
                </c:pt>
                <c:pt idx="7">
                  <c:v>0.43659561037968359</c:v>
                </c:pt>
                <c:pt idx="9">
                  <c:v>0.85382456061822509</c:v>
                </c:pt>
                <c:pt idx="11">
                  <c:v>0.73843976984417148</c:v>
                </c:pt>
                <c:pt idx="12">
                  <c:v>0.69347755728121008</c:v>
                </c:pt>
                <c:pt idx="13">
                  <c:v>0.52031806774380385</c:v>
                </c:pt>
                <c:pt idx="14">
                  <c:v>0.372792582385788</c:v>
                </c:pt>
                <c:pt idx="15">
                  <c:v>0.28768984205035703</c:v>
                </c:pt>
                <c:pt idx="16">
                  <c:v>0.23803756659893627</c:v>
                </c:pt>
                <c:pt idx="17">
                  <c:v>0.140058401750596</c:v>
                </c:pt>
                <c:pt idx="18">
                  <c:v>6.8388040055077634E-2</c:v>
                </c:pt>
                <c:pt idx="20">
                  <c:v>0.34030430454462818</c:v>
                </c:pt>
                <c:pt idx="21">
                  <c:v>0.2917515299129117</c:v>
                </c:pt>
                <c:pt idx="22">
                  <c:v>0.22624748031281858</c:v>
                </c:pt>
                <c:pt idx="23">
                  <c:v>0.22865055265430895</c:v>
                </c:pt>
                <c:pt idx="24">
                  <c:v>0.10316106584862379</c:v>
                </c:pt>
                <c:pt idx="25">
                  <c:v>5.5415947374421771E-2</c:v>
                </c:pt>
                <c:pt idx="26">
                  <c:v>8.5547957285389747E-2</c:v>
                </c:pt>
                <c:pt idx="27">
                  <c:v>5.1756666808314658E-2</c:v>
                </c:pt>
                <c:pt idx="29">
                  <c:v>0.20541631418380324</c:v>
                </c:pt>
                <c:pt idx="30">
                  <c:v>0.18517509329143611</c:v>
                </c:pt>
                <c:pt idx="31">
                  <c:v>0.16590876495098111</c:v>
                </c:pt>
                <c:pt idx="32">
                  <c:v>0.10779537014908062</c:v>
                </c:pt>
                <c:pt idx="33">
                  <c:v>0.10913339521276395</c:v>
                </c:pt>
                <c:pt idx="34">
                  <c:v>8.762138418759044E-2</c:v>
                </c:pt>
                <c:pt idx="35">
                  <c:v>7.5272483800419634E-2</c:v>
                </c:pt>
                <c:pt idx="36">
                  <c:v>7.4020427666498273E-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DBD1-467E-8CBC-173AFE74E9B0}"/>
            </c:ext>
          </c:extLst>
        </c:ser>
        <c:ser>
          <c:idx val="1"/>
          <c:order val="1"/>
          <c:tx>
            <c:strRef>
              <c:f>组2!$AS$1</c:f>
              <c:strCache>
                <c:ptCount val="1"/>
                <c:pt idx="0">
                  <c:v>CS-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round/>
              <a:headEnd w="med" len="med"/>
            </a:ln>
            <a:effectLst/>
          </c:spPr>
          <c:marker>
            <c:symbol val="circle"/>
            <c:size val="9"/>
            <c:spPr>
              <a:solidFill>
                <a:sysClr val="windowText" lastClr="000000">
                  <a:alpha val="99000"/>
                </a:sysClr>
              </a:solidFill>
              <a:ln w="19050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组2!$AU$2:$AU$38</c:f>
                <c:numCache>
                  <c:formatCode>General</c:formatCode>
                  <c:ptCount val="37"/>
                  <c:pt idx="0">
                    <c:v>7.6877940162373828E-2</c:v>
                  </c:pt>
                  <c:pt idx="1">
                    <c:v>5.6963390301249708E-2</c:v>
                  </c:pt>
                  <c:pt idx="2">
                    <c:v>4.884806091496207E-2</c:v>
                  </c:pt>
                  <c:pt idx="3">
                    <c:v>4.7905699232270477E-2</c:v>
                  </c:pt>
                  <c:pt idx="4">
                    <c:v>5.3196102269443442E-2</c:v>
                  </c:pt>
                  <c:pt idx="5">
                    <c:v>5.1206613247052779E-2</c:v>
                  </c:pt>
                  <c:pt idx="6">
                    <c:v>3.6780725694734895E-2</c:v>
                  </c:pt>
                  <c:pt idx="7">
                    <c:v>1.7742868463234744E-2</c:v>
                  </c:pt>
                  <c:pt idx="11">
                    <c:v>8.6253123247867075E-2</c:v>
                  </c:pt>
                  <c:pt idx="12">
                    <c:v>8.7392963523712994E-2</c:v>
                  </c:pt>
                  <c:pt idx="13">
                    <c:v>8.8110618116177389E-2</c:v>
                  </c:pt>
                  <c:pt idx="14">
                    <c:v>6.8017135148538924E-2</c:v>
                  </c:pt>
                  <c:pt idx="15">
                    <c:v>6.5692297391820281E-2</c:v>
                  </c:pt>
                  <c:pt idx="16">
                    <c:v>6.5937764640582916E-2</c:v>
                  </c:pt>
                  <c:pt idx="17">
                    <c:v>5.7031638457333327E-2</c:v>
                  </c:pt>
                  <c:pt idx="18">
                    <c:v>2.9717611401675809E-2</c:v>
                  </c:pt>
                  <c:pt idx="20">
                    <c:v>6.1721197098154157E-2</c:v>
                  </c:pt>
                  <c:pt idx="21">
                    <c:v>6.5012336243629912E-2</c:v>
                  </c:pt>
                  <c:pt idx="22">
                    <c:v>4.0405210141184936E-2</c:v>
                  </c:pt>
                  <c:pt idx="23">
                    <c:v>2.892836358655506E-2</c:v>
                  </c:pt>
                  <c:pt idx="24">
                    <c:v>4.0764316497873328E-2</c:v>
                  </c:pt>
                  <c:pt idx="25">
                    <c:v>5.428740886309881E-2</c:v>
                  </c:pt>
                  <c:pt idx="26">
                    <c:v>2.8492627569880375E-2</c:v>
                  </c:pt>
                  <c:pt idx="27">
                    <c:v>4.1096240849779309E-2</c:v>
                  </c:pt>
                  <c:pt idx="29">
                    <c:v>6.2923182867703695E-2</c:v>
                  </c:pt>
                  <c:pt idx="30">
                    <c:v>5.4630914305945077E-2</c:v>
                  </c:pt>
                  <c:pt idx="31">
                    <c:v>3.6382045698306706E-2</c:v>
                  </c:pt>
                  <c:pt idx="32">
                    <c:v>5.9026885672330748E-2</c:v>
                  </c:pt>
                  <c:pt idx="33">
                    <c:v>7.0814089701539976E-2</c:v>
                  </c:pt>
                  <c:pt idx="34">
                    <c:v>2.9630305475494299E-2</c:v>
                  </c:pt>
                  <c:pt idx="35">
                    <c:v>4.1980150561728075E-2</c:v>
                  </c:pt>
                  <c:pt idx="36">
                    <c:v>4.6889937985473418E-2</c:v>
                  </c:pt>
                </c:numCache>
              </c:numRef>
            </c:plus>
            <c:minus>
              <c:numRef>
                <c:f>组2!$AU$2:$AU$38</c:f>
                <c:numCache>
                  <c:formatCode>General</c:formatCode>
                  <c:ptCount val="37"/>
                  <c:pt idx="0">
                    <c:v>7.6877940162373828E-2</c:v>
                  </c:pt>
                  <c:pt idx="1">
                    <c:v>5.6963390301249708E-2</c:v>
                  </c:pt>
                  <c:pt idx="2">
                    <c:v>4.884806091496207E-2</c:v>
                  </c:pt>
                  <c:pt idx="3">
                    <c:v>4.7905699232270477E-2</c:v>
                  </c:pt>
                  <c:pt idx="4">
                    <c:v>5.3196102269443442E-2</c:v>
                  </c:pt>
                  <c:pt idx="5">
                    <c:v>5.1206613247052779E-2</c:v>
                  </c:pt>
                  <c:pt idx="6">
                    <c:v>3.6780725694734895E-2</c:v>
                  </c:pt>
                  <c:pt idx="7">
                    <c:v>1.7742868463234744E-2</c:v>
                  </c:pt>
                  <c:pt idx="11">
                    <c:v>8.6253123247867075E-2</c:v>
                  </c:pt>
                  <c:pt idx="12">
                    <c:v>8.7392963523712994E-2</c:v>
                  </c:pt>
                  <c:pt idx="13">
                    <c:v>8.8110618116177389E-2</c:v>
                  </c:pt>
                  <c:pt idx="14">
                    <c:v>6.8017135148538924E-2</c:v>
                  </c:pt>
                  <c:pt idx="15">
                    <c:v>6.5692297391820281E-2</c:v>
                  </c:pt>
                  <c:pt idx="16">
                    <c:v>6.5937764640582916E-2</c:v>
                  </c:pt>
                  <c:pt idx="17">
                    <c:v>5.7031638457333327E-2</c:v>
                  </c:pt>
                  <c:pt idx="18">
                    <c:v>2.9717611401675809E-2</c:v>
                  </c:pt>
                  <c:pt idx="20">
                    <c:v>6.1721197098154157E-2</c:v>
                  </c:pt>
                  <c:pt idx="21">
                    <c:v>6.5012336243629912E-2</c:v>
                  </c:pt>
                  <c:pt idx="22">
                    <c:v>4.0405210141184936E-2</c:v>
                  </c:pt>
                  <c:pt idx="23">
                    <c:v>2.892836358655506E-2</c:v>
                  </c:pt>
                  <c:pt idx="24">
                    <c:v>4.0764316497873328E-2</c:v>
                  </c:pt>
                  <c:pt idx="25">
                    <c:v>5.428740886309881E-2</c:v>
                  </c:pt>
                  <c:pt idx="26">
                    <c:v>2.8492627569880375E-2</c:v>
                  </c:pt>
                  <c:pt idx="27">
                    <c:v>4.1096240849779309E-2</c:v>
                  </c:pt>
                  <c:pt idx="29">
                    <c:v>6.2923182867703695E-2</c:v>
                  </c:pt>
                  <c:pt idx="30">
                    <c:v>5.4630914305945077E-2</c:v>
                  </c:pt>
                  <c:pt idx="31">
                    <c:v>3.6382045698306706E-2</c:v>
                  </c:pt>
                  <c:pt idx="32">
                    <c:v>5.9026885672330748E-2</c:v>
                  </c:pt>
                  <c:pt idx="33">
                    <c:v>7.0814089701539976E-2</c:v>
                  </c:pt>
                  <c:pt idx="34">
                    <c:v>2.9630305475494299E-2</c:v>
                  </c:pt>
                  <c:pt idx="35">
                    <c:v>4.1980150561728075E-2</c:v>
                  </c:pt>
                  <c:pt idx="36">
                    <c:v>4.6889937985473418E-2</c:v>
                  </c:pt>
                </c:numCache>
              </c:numRef>
            </c:minus>
            <c:spPr>
              <a:noFill/>
              <a:ln w="254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组2!$AQ$2:$AQ$38</c:f>
              <c:numCache>
                <c:formatCode>General</c:formatCode>
                <c:ptCount val="37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9">
                  <c:v>1</c:v>
                </c:pt>
                <c:pt idx="11">
                  <c:v>1</c:v>
                </c:pt>
                <c:pt idx="12">
                  <c:v>2</c:v>
                </c:pt>
                <c:pt idx="13">
                  <c:v>3</c:v>
                </c:pt>
                <c:pt idx="14">
                  <c:v>4</c:v>
                </c:pt>
                <c:pt idx="15">
                  <c:v>5</c:v>
                </c:pt>
                <c:pt idx="16">
                  <c:v>6</c:v>
                </c:pt>
                <c:pt idx="17">
                  <c:v>7</c:v>
                </c:pt>
                <c:pt idx="18">
                  <c:v>8</c:v>
                </c:pt>
                <c:pt idx="20">
                  <c:v>1</c:v>
                </c:pt>
                <c:pt idx="21">
                  <c:v>2</c:v>
                </c:pt>
                <c:pt idx="22">
                  <c:v>3</c:v>
                </c:pt>
                <c:pt idx="23">
                  <c:v>4</c:v>
                </c:pt>
                <c:pt idx="24">
                  <c:v>5</c:v>
                </c:pt>
                <c:pt idx="25">
                  <c:v>6</c:v>
                </c:pt>
                <c:pt idx="26">
                  <c:v>7</c:v>
                </c:pt>
                <c:pt idx="27">
                  <c:v>8</c:v>
                </c:pt>
                <c:pt idx="29">
                  <c:v>1</c:v>
                </c:pt>
                <c:pt idx="30">
                  <c:v>2</c:v>
                </c:pt>
                <c:pt idx="31">
                  <c:v>3</c:v>
                </c:pt>
                <c:pt idx="32">
                  <c:v>4</c:v>
                </c:pt>
                <c:pt idx="33">
                  <c:v>5</c:v>
                </c:pt>
                <c:pt idx="34">
                  <c:v>6</c:v>
                </c:pt>
                <c:pt idx="35">
                  <c:v>7</c:v>
                </c:pt>
                <c:pt idx="36">
                  <c:v>8</c:v>
                </c:pt>
              </c:numCache>
            </c:numRef>
          </c:cat>
          <c:val>
            <c:numRef>
              <c:f>组2!$AS$2:$AS$38</c:f>
              <c:numCache>
                <c:formatCode>General</c:formatCode>
                <c:ptCount val="37"/>
                <c:pt idx="0">
                  <c:v>0.550106981278909</c:v>
                </c:pt>
                <c:pt idx="1">
                  <c:v>0.31302337921999757</c:v>
                </c:pt>
                <c:pt idx="2">
                  <c:v>0.28751326971634683</c:v>
                </c:pt>
                <c:pt idx="3">
                  <c:v>0.24179080518901391</c:v>
                </c:pt>
                <c:pt idx="4">
                  <c:v>0.26899515416138764</c:v>
                </c:pt>
                <c:pt idx="5">
                  <c:v>0.15950441795455889</c:v>
                </c:pt>
                <c:pt idx="6">
                  <c:v>0.11454212931641927</c:v>
                </c:pt>
                <c:pt idx="7">
                  <c:v>2.5672347427767868E-2</c:v>
                </c:pt>
                <c:pt idx="11">
                  <c:v>0.39874478230265381</c:v>
                </c:pt>
                <c:pt idx="12">
                  <c:v>0.32898097828779094</c:v>
                </c:pt>
                <c:pt idx="13">
                  <c:v>0.26966315620637432</c:v>
                </c:pt>
                <c:pt idx="14">
                  <c:v>0.1754605107488485</c:v>
                </c:pt>
                <c:pt idx="15">
                  <c:v>0.19459252692596588</c:v>
                </c:pt>
                <c:pt idx="16">
                  <c:v>0.12240671692302038</c:v>
                </c:pt>
                <c:pt idx="17">
                  <c:v>0.11966207595103832</c:v>
                </c:pt>
                <c:pt idx="18">
                  <c:v>6.3216705006805193E-2</c:v>
                </c:pt>
                <c:pt idx="20">
                  <c:v>0.29168620414488283</c:v>
                </c:pt>
                <c:pt idx="21">
                  <c:v>0.20570434868902163</c:v>
                </c:pt>
                <c:pt idx="22">
                  <c:v>0.12915974882915732</c:v>
                </c:pt>
                <c:pt idx="23">
                  <c:v>2.892836358655506E-2</c:v>
                </c:pt>
                <c:pt idx="24">
                  <c:v>6.6266111525895247E-2</c:v>
                </c:pt>
                <c:pt idx="25">
                  <c:v>8.1069221024263768E-2</c:v>
                </c:pt>
                <c:pt idx="26">
                  <c:v>3.9095455563749638E-2</c:v>
                </c:pt>
                <c:pt idx="27">
                  <c:v>5.4377243264530396E-2</c:v>
                </c:pt>
                <c:pt idx="29">
                  <c:v>0.16357596318474016</c:v>
                </c:pt>
                <c:pt idx="30">
                  <c:v>0.14708531823852172</c:v>
                </c:pt>
                <c:pt idx="31">
                  <c:v>9.7474222166739205E-2</c:v>
                </c:pt>
                <c:pt idx="32">
                  <c:v>0.1114548693305573</c:v>
                </c:pt>
                <c:pt idx="33">
                  <c:v>0.16642014053154497</c:v>
                </c:pt>
                <c:pt idx="34">
                  <c:v>6.152541514480124E-2</c:v>
                </c:pt>
                <c:pt idx="35">
                  <c:v>7.2550189913010127E-2</c:v>
                </c:pt>
                <c:pt idx="36">
                  <c:v>0.1092262680538021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DBD1-467E-8CBC-173AFE74E9B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86369536"/>
        <c:axId val="186371072"/>
      </c:lineChart>
      <c:catAx>
        <c:axId val="186369536"/>
        <c:scaling>
          <c:orientation val="minMax"/>
        </c:scaling>
        <c:delete val="0"/>
        <c:axPos val="b"/>
        <c:numFmt formatCode="General" sourceLinked="0"/>
        <c:majorTickMark val="in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ln>
                  <a:solidFill>
                    <a:schemeClr val="tx1"/>
                  </a:solidFill>
                </a:ln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86371072"/>
        <c:crosses val="autoZero"/>
        <c:auto val="1"/>
        <c:lblAlgn val="ctr"/>
        <c:lblOffset val="100"/>
        <c:tickMarkSkip val="1"/>
        <c:noMultiLvlLbl val="0"/>
      </c:catAx>
      <c:valAx>
        <c:axId val="18637107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ln>
                      <a:solidFill>
                        <a:schemeClr val="tx1"/>
                      </a:solidFill>
                    </a:ln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 sz="1800" dirty="0" smtClean="0"/>
                  <a:t>Normalized</a:t>
                </a:r>
                <a:r>
                  <a:rPr lang="en-US" altLang="zh-CN" sz="1800" baseline="0" dirty="0" smtClean="0"/>
                  <a:t> SCR</a:t>
                </a:r>
                <a:endParaRPr lang="zh-CN" altLang="en-US" sz="1800" dirty="0"/>
              </a:p>
            </c:rich>
          </c:tx>
          <c:layout>
            <c:manualLayout>
              <c:xMode val="edge"/>
              <c:yMode val="edge"/>
              <c:x val="9.5742290026246714E-3"/>
              <c:y val="0.24468105725733791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ln>
                  <a:solidFill>
                    <a:schemeClr val="tx1"/>
                  </a:solidFill>
                </a:ln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86369536"/>
        <c:crossesAt val="1"/>
        <c:crossBetween val="between"/>
      </c:valAx>
      <c:spPr>
        <a:noFill/>
        <a:ln>
          <a:noFill/>
        </a:ln>
        <a:effectLst/>
      </c:spPr>
    </c:plotArea>
    <c:legend>
      <c:legendPos val="tr"/>
      <c:layout>
        <c:manualLayout>
          <c:xMode val="edge"/>
          <c:yMode val="edge"/>
          <c:x val="0.88473167576272915"/>
          <c:y val="0.17140560623297343"/>
          <c:w val="9.106197614744399E-2"/>
          <c:h val="0.1763204239687513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ln>
                <a:solidFill>
                  <a:schemeClr val="tx1"/>
                </a:solidFill>
              </a:ln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2">
    <c:autoUpdate val="0"/>
  </c:externalData>
  <c:userShapes r:id="rId3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7.6553512797350398E-2"/>
          <c:y val="0.15426226099704332"/>
          <c:w val="0.92344650530539796"/>
          <c:h val="0.64003698673014908"/>
        </c:manualLayout>
      </c:layout>
      <c:lineChart>
        <c:grouping val="standard"/>
        <c:varyColors val="0"/>
        <c:ser>
          <c:idx val="0"/>
          <c:order val="0"/>
          <c:tx>
            <c:strRef>
              <c:f>组3!$AR$1</c:f>
              <c:strCache>
                <c:ptCount val="1"/>
                <c:pt idx="0">
                  <c:v>CS+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9"/>
            <c:spPr>
              <a:solidFill>
                <a:sysClr val="window" lastClr="FFFFFF"/>
              </a:solidFill>
              <a:ln w="25400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组3!$AT$2:$AT$38</c:f>
                <c:numCache>
                  <c:formatCode>General</c:formatCode>
                  <c:ptCount val="37"/>
                  <c:pt idx="0">
                    <c:v>5.274193141425073E-2</c:v>
                  </c:pt>
                  <c:pt idx="1">
                    <c:v>6.7469204617329734E-2</c:v>
                  </c:pt>
                  <c:pt idx="2">
                    <c:v>7.0236698490306379E-2</c:v>
                  </c:pt>
                  <c:pt idx="3">
                    <c:v>6.2327762087157276E-2</c:v>
                  </c:pt>
                  <c:pt idx="4">
                    <c:v>7.9731794051692104E-2</c:v>
                  </c:pt>
                  <c:pt idx="5">
                    <c:v>8.2382139341248398E-2</c:v>
                  </c:pt>
                  <c:pt idx="6">
                    <c:v>7.7206536064169509E-2</c:v>
                  </c:pt>
                  <c:pt idx="7">
                    <c:v>8.4881824400191291E-2</c:v>
                  </c:pt>
                  <c:pt idx="9">
                    <c:v>4.652057752329717E-2</c:v>
                  </c:pt>
                  <c:pt idx="11">
                    <c:v>8.520583108803069E-2</c:v>
                  </c:pt>
                  <c:pt idx="12">
                    <c:v>8.0157265415741141E-2</c:v>
                  </c:pt>
                  <c:pt idx="13">
                    <c:v>0.11522190078144334</c:v>
                  </c:pt>
                  <c:pt idx="14">
                    <c:v>0.10124987470699626</c:v>
                  </c:pt>
                  <c:pt idx="15">
                    <c:v>8.5167648025426007E-2</c:v>
                  </c:pt>
                  <c:pt idx="16">
                    <c:v>7.4649923061349086E-2</c:v>
                  </c:pt>
                  <c:pt idx="17">
                    <c:v>7.8457192402566545E-2</c:v>
                  </c:pt>
                  <c:pt idx="18">
                    <c:v>7.7325036052804899E-2</c:v>
                  </c:pt>
                  <c:pt idx="20">
                    <c:v>7.1281295823200683E-2</c:v>
                  </c:pt>
                  <c:pt idx="21">
                    <c:v>7.8160646262536243E-2</c:v>
                  </c:pt>
                  <c:pt idx="22">
                    <c:v>8.6370860563138627E-2</c:v>
                  </c:pt>
                  <c:pt idx="23">
                    <c:v>8.1959575314800304E-2</c:v>
                  </c:pt>
                  <c:pt idx="24">
                    <c:v>8.3780545981366764E-2</c:v>
                  </c:pt>
                  <c:pt idx="25">
                    <c:v>5.937300336303894E-2</c:v>
                  </c:pt>
                  <c:pt idx="26">
                    <c:v>5.6050918728990824E-2</c:v>
                  </c:pt>
                  <c:pt idx="27">
                    <c:v>3.5812751905259996E-2</c:v>
                  </c:pt>
                  <c:pt idx="29">
                    <c:v>7.3603385066646265E-2</c:v>
                  </c:pt>
                  <c:pt idx="30">
                    <c:v>5.7728575570492623E-2</c:v>
                  </c:pt>
                  <c:pt idx="31">
                    <c:v>6.5596575690841499E-2</c:v>
                  </c:pt>
                  <c:pt idx="32">
                    <c:v>6.0027834991566761E-2</c:v>
                  </c:pt>
                  <c:pt idx="33">
                    <c:v>0.10632170758810319</c:v>
                  </c:pt>
                  <c:pt idx="34">
                    <c:v>4.3949287168265384E-2</c:v>
                  </c:pt>
                  <c:pt idx="35">
                    <c:v>1.9832242635660222E-2</c:v>
                  </c:pt>
                  <c:pt idx="36">
                    <c:v>3.2586226842773319E-2</c:v>
                  </c:pt>
                </c:numCache>
              </c:numRef>
            </c:plus>
            <c:minus>
              <c:numRef>
                <c:f>组3!$AT$2:$AT$38</c:f>
                <c:numCache>
                  <c:formatCode>General</c:formatCode>
                  <c:ptCount val="37"/>
                  <c:pt idx="0">
                    <c:v>5.274193141425073E-2</c:v>
                  </c:pt>
                  <c:pt idx="1">
                    <c:v>6.7469204617329734E-2</c:v>
                  </c:pt>
                  <c:pt idx="2">
                    <c:v>7.0236698490306379E-2</c:v>
                  </c:pt>
                  <c:pt idx="3">
                    <c:v>6.2327762087157276E-2</c:v>
                  </c:pt>
                  <c:pt idx="4">
                    <c:v>7.9731794051692104E-2</c:v>
                  </c:pt>
                  <c:pt idx="5">
                    <c:v>8.2382139341248398E-2</c:v>
                  </c:pt>
                  <c:pt idx="6">
                    <c:v>7.7206536064169509E-2</c:v>
                  </c:pt>
                  <c:pt idx="7">
                    <c:v>8.4881824400191291E-2</c:v>
                  </c:pt>
                  <c:pt idx="9">
                    <c:v>4.652057752329717E-2</c:v>
                  </c:pt>
                  <c:pt idx="11">
                    <c:v>8.520583108803069E-2</c:v>
                  </c:pt>
                  <c:pt idx="12">
                    <c:v>8.0157265415741141E-2</c:v>
                  </c:pt>
                  <c:pt idx="13">
                    <c:v>0.11522190078144334</c:v>
                  </c:pt>
                  <c:pt idx="14">
                    <c:v>0.10124987470699626</c:v>
                  </c:pt>
                  <c:pt idx="15">
                    <c:v>8.5167648025426007E-2</c:v>
                  </c:pt>
                  <c:pt idx="16">
                    <c:v>7.4649923061349086E-2</c:v>
                  </c:pt>
                  <c:pt idx="17">
                    <c:v>7.8457192402566545E-2</c:v>
                  </c:pt>
                  <c:pt idx="18">
                    <c:v>7.7325036052804899E-2</c:v>
                  </c:pt>
                  <c:pt idx="20">
                    <c:v>7.1281295823200683E-2</c:v>
                  </c:pt>
                  <c:pt idx="21">
                    <c:v>7.8160646262536243E-2</c:v>
                  </c:pt>
                  <c:pt idx="22">
                    <c:v>8.6370860563138627E-2</c:v>
                  </c:pt>
                  <c:pt idx="23">
                    <c:v>8.1959575314800304E-2</c:v>
                  </c:pt>
                  <c:pt idx="24">
                    <c:v>8.3780545981366764E-2</c:v>
                  </c:pt>
                  <c:pt idx="25">
                    <c:v>5.937300336303894E-2</c:v>
                  </c:pt>
                  <c:pt idx="26">
                    <c:v>5.6050918728990824E-2</c:v>
                  </c:pt>
                  <c:pt idx="27">
                    <c:v>3.5812751905259996E-2</c:v>
                  </c:pt>
                  <c:pt idx="29">
                    <c:v>7.3603385066646265E-2</c:v>
                  </c:pt>
                  <c:pt idx="30">
                    <c:v>5.7728575570492623E-2</c:v>
                  </c:pt>
                  <c:pt idx="31">
                    <c:v>6.5596575690841499E-2</c:v>
                  </c:pt>
                  <c:pt idx="32">
                    <c:v>6.0027834991566761E-2</c:v>
                  </c:pt>
                  <c:pt idx="33">
                    <c:v>0.10632170758810319</c:v>
                  </c:pt>
                  <c:pt idx="34">
                    <c:v>4.3949287168265384E-2</c:v>
                  </c:pt>
                  <c:pt idx="35">
                    <c:v>1.9832242635660222E-2</c:v>
                  </c:pt>
                  <c:pt idx="36">
                    <c:v>3.2586226842773319E-2</c:v>
                  </c:pt>
                </c:numCache>
              </c:numRef>
            </c:minus>
            <c:spPr>
              <a:noFill/>
              <a:ln w="254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组3!$AQ$2:$AQ$38</c:f>
              <c:numCache>
                <c:formatCode>General</c:formatCode>
                <c:ptCount val="37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9">
                  <c:v>1</c:v>
                </c:pt>
                <c:pt idx="11">
                  <c:v>1</c:v>
                </c:pt>
                <c:pt idx="12">
                  <c:v>2</c:v>
                </c:pt>
                <c:pt idx="13">
                  <c:v>3</c:v>
                </c:pt>
                <c:pt idx="14">
                  <c:v>4</c:v>
                </c:pt>
                <c:pt idx="15">
                  <c:v>5</c:v>
                </c:pt>
                <c:pt idx="16">
                  <c:v>6</c:v>
                </c:pt>
                <c:pt idx="17">
                  <c:v>7</c:v>
                </c:pt>
                <c:pt idx="18">
                  <c:v>8</c:v>
                </c:pt>
                <c:pt idx="20">
                  <c:v>1</c:v>
                </c:pt>
                <c:pt idx="21">
                  <c:v>2</c:v>
                </c:pt>
                <c:pt idx="22">
                  <c:v>3</c:v>
                </c:pt>
                <c:pt idx="23">
                  <c:v>4</c:v>
                </c:pt>
                <c:pt idx="24">
                  <c:v>5</c:v>
                </c:pt>
                <c:pt idx="25">
                  <c:v>6</c:v>
                </c:pt>
                <c:pt idx="26">
                  <c:v>7</c:v>
                </c:pt>
                <c:pt idx="27">
                  <c:v>8</c:v>
                </c:pt>
                <c:pt idx="29">
                  <c:v>1</c:v>
                </c:pt>
                <c:pt idx="30">
                  <c:v>2</c:v>
                </c:pt>
                <c:pt idx="31">
                  <c:v>3</c:v>
                </c:pt>
                <c:pt idx="32">
                  <c:v>4</c:v>
                </c:pt>
                <c:pt idx="33">
                  <c:v>5</c:v>
                </c:pt>
                <c:pt idx="34">
                  <c:v>6</c:v>
                </c:pt>
                <c:pt idx="35">
                  <c:v>7</c:v>
                </c:pt>
                <c:pt idx="36">
                  <c:v>8</c:v>
                </c:pt>
              </c:numCache>
            </c:numRef>
          </c:cat>
          <c:val>
            <c:numRef>
              <c:f>组3!$AR$2:$AR$38</c:f>
              <c:numCache>
                <c:formatCode>General</c:formatCode>
                <c:ptCount val="37"/>
                <c:pt idx="0">
                  <c:v>0.62540373944436556</c:v>
                </c:pt>
                <c:pt idx="1">
                  <c:v>0.57791069547790086</c:v>
                </c:pt>
                <c:pt idx="2">
                  <c:v>0.4814802722477064</c:v>
                </c:pt>
                <c:pt idx="3">
                  <c:v>0.46247796813313719</c:v>
                </c:pt>
                <c:pt idx="4">
                  <c:v>0.49500019339411161</c:v>
                </c:pt>
                <c:pt idx="5">
                  <c:v>0.40176950198692413</c:v>
                </c:pt>
                <c:pt idx="6">
                  <c:v>0.37876315806625466</c:v>
                </c:pt>
                <c:pt idx="7">
                  <c:v>0.392472987610055</c:v>
                </c:pt>
                <c:pt idx="9">
                  <c:v>0.87003900434726944</c:v>
                </c:pt>
                <c:pt idx="11">
                  <c:v>0.73209373267032307</c:v>
                </c:pt>
                <c:pt idx="12">
                  <c:v>0.63190736824459692</c:v>
                </c:pt>
                <c:pt idx="13">
                  <c:v>0.5384078829363681</c:v>
                </c:pt>
                <c:pt idx="14">
                  <c:v>0.42757423926202359</c:v>
                </c:pt>
                <c:pt idx="15">
                  <c:v>0.21569354377340288</c:v>
                </c:pt>
                <c:pt idx="16">
                  <c:v>0.23021912665687361</c:v>
                </c:pt>
                <c:pt idx="17">
                  <c:v>0.14479050946652852</c:v>
                </c:pt>
                <c:pt idx="18">
                  <c:v>0.17832782330148766</c:v>
                </c:pt>
                <c:pt idx="20">
                  <c:v>0.53031819053499196</c:v>
                </c:pt>
                <c:pt idx="21">
                  <c:v>0.50699821451721394</c:v>
                </c:pt>
                <c:pt idx="22">
                  <c:v>0.36936391949195263</c:v>
                </c:pt>
                <c:pt idx="23">
                  <c:v>0.27063025670729673</c:v>
                </c:pt>
                <c:pt idx="24">
                  <c:v>0.22266634357282739</c:v>
                </c:pt>
                <c:pt idx="25">
                  <c:v>0.10091421737903346</c:v>
                </c:pt>
                <c:pt idx="26">
                  <c:v>0.1015631728431368</c:v>
                </c:pt>
                <c:pt idx="27">
                  <c:v>4.1328097209506462E-2</c:v>
                </c:pt>
                <c:pt idx="29">
                  <c:v>0.25715324023097896</c:v>
                </c:pt>
                <c:pt idx="30">
                  <c:v>0.11543782314818658</c:v>
                </c:pt>
                <c:pt idx="31">
                  <c:v>0.18873444520352045</c:v>
                </c:pt>
                <c:pt idx="32">
                  <c:v>0.15439917872120026</c:v>
                </c:pt>
                <c:pt idx="33">
                  <c:v>0.1454308251373457</c:v>
                </c:pt>
                <c:pt idx="34">
                  <c:v>7.8439927030485718E-2</c:v>
                </c:pt>
                <c:pt idx="35">
                  <c:v>3.5102764578942E-2</c:v>
                </c:pt>
                <c:pt idx="36">
                  <c:v>5.8276877500282862E-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BA7D-4F4D-9FDA-888BE6BDBF17}"/>
            </c:ext>
          </c:extLst>
        </c:ser>
        <c:ser>
          <c:idx val="1"/>
          <c:order val="1"/>
          <c:tx>
            <c:strRef>
              <c:f>组3!$AS$1</c:f>
              <c:strCache>
                <c:ptCount val="1"/>
                <c:pt idx="0">
                  <c:v>CS-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round/>
              <a:headEnd w="med" len="med"/>
            </a:ln>
            <a:effectLst/>
          </c:spPr>
          <c:marker>
            <c:symbol val="circle"/>
            <c:size val="9"/>
            <c:spPr>
              <a:solidFill>
                <a:sysClr val="windowText" lastClr="000000">
                  <a:alpha val="99000"/>
                </a:sysClr>
              </a:solidFill>
              <a:ln w="19050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组3!$AU$2:$AU$38</c:f>
                <c:numCache>
                  <c:formatCode>General</c:formatCode>
                  <c:ptCount val="37"/>
                  <c:pt idx="0">
                    <c:v>5.7205390961469989E-2</c:v>
                  </c:pt>
                  <c:pt idx="1">
                    <c:v>7.6585003830660983E-2</c:v>
                  </c:pt>
                  <c:pt idx="2">
                    <c:v>9.6093473311613498E-2</c:v>
                  </c:pt>
                  <c:pt idx="3">
                    <c:v>6.2408145583930069E-2</c:v>
                  </c:pt>
                  <c:pt idx="4">
                    <c:v>6.1307389133942423E-2</c:v>
                  </c:pt>
                  <c:pt idx="5">
                    <c:v>4.8205205622722576E-2</c:v>
                  </c:pt>
                  <c:pt idx="6">
                    <c:v>5.7667046698995798E-2</c:v>
                  </c:pt>
                  <c:pt idx="7">
                    <c:v>3.6403649236272886E-2</c:v>
                  </c:pt>
                  <c:pt idx="11">
                    <c:v>0.10067347610387625</c:v>
                  </c:pt>
                  <c:pt idx="12">
                    <c:v>9.8546233637911498E-2</c:v>
                  </c:pt>
                  <c:pt idx="13">
                    <c:v>5.6347896123622697E-2</c:v>
                  </c:pt>
                  <c:pt idx="14">
                    <c:v>7.8742220161072074E-2</c:v>
                  </c:pt>
                  <c:pt idx="15">
                    <c:v>6.9937017984286892E-2</c:v>
                  </c:pt>
                  <c:pt idx="16">
                    <c:v>5.4605228818213253E-2</c:v>
                  </c:pt>
                  <c:pt idx="17">
                    <c:v>5.6341075779326524E-2</c:v>
                  </c:pt>
                  <c:pt idx="18">
                    <c:v>5.8247299242486422E-2</c:v>
                  </c:pt>
                  <c:pt idx="20">
                    <c:v>7.4351548909900658E-2</c:v>
                  </c:pt>
                  <c:pt idx="21">
                    <c:v>6.7466338005237075E-2</c:v>
                  </c:pt>
                  <c:pt idx="22">
                    <c:v>6.7443572534670607E-2</c:v>
                  </c:pt>
                  <c:pt idx="23">
                    <c:v>3.4134834656598827E-2</c:v>
                  </c:pt>
                  <c:pt idx="24">
                    <c:v>5.0623358066267193E-2</c:v>
                  </c:pt>
                  <c:pt idx="25">
                    <c:v>4.9084378065587006E-2</c:v>
                  </c:pt>
                  <c:pt idx="26">
                    <c:v>5.7711022631946461E-2</c:v>
                  </c:pt>
                  <c:pt idx="27">
                    <c:v>2.3420212318475846E-2</c:v>
                  </c:pt>
                  <c:pt idx="29">
                    <c:v>5.9951981720568169E-2</c:v>
                  </c:pt>
                  <c:pt idx="30">
                    <c:v>7.1919274724516299E-2</c:v>
                  </c:pt>
                  <c:pt idx="31">
                    <c:v>6.839182563050987E-2</c:v>
                  </c:pt>
                  <c:pt idx="32">
                    <c:v>1.5729687756693537E-2</c:v>
                  </c:pt>
                  <c:pt idx="33">
                    <c:v>2.8743954046066267E-2</c:v>
                  </c:pt>
                  <c:pt idx="34">
                    <c:v>3.325546225374016E-2</c:v>
                  </c:pt>
                  <c:pt idx="35">
                    <c:v>1.3111860517013168E-2</c:v>
                  </c:pt>
                  <c:pt idx="36">
                    <c:v>6.1448964320690726E-2</c:v>
                  </c:pt>
                </c:numCache>
              </c:numRef>
            </c:plus>
            <c:minus>
              <c:numRef>
                <c:f>组3!$AU$2:$AU$38</c:f>
                <c:numCache>
                  <c:formatCode>General</c:formatCode>
                  <c:ptCount val="37"/>
                  <c:pt idx="0">
                    <c:v>5.7205390961469989E-2</c:v>
                  </c:pt>
                  <c:pt idx="1">
                    <c:v>7.6585003830660983E-2</c:v>
                  </c:pt>
                  <c:pt idx="2">
                    <c:v>9.6093473311613498E-2</c:v>
                  </c:pt>
                  <c:pt idx="3">
                    <c:v>6.2408145583930069E-2</c:v>
                  </c:pt>
                  <c:pt idx="4">
                    <c:v>6.1307389133942423E-2</c:v>
                  </c:pt>
                  <c:pt idx="5">
                    <c:v>4.8205205622722576E-2</c:v>
                  </c:pt>
                  <c:pt idx="6">
                    <c:v>5.7667046698995798E-2</c:v>
                  </c:pt>
                  <c:pt idx="7">
                    <c:v>3.6403649236272886E-2</c:v>
                  </c:pt>
                  <c:pt idx="11">
                    <c:v>0.10067347610387625</c:v>
                  </c:pt>
                  <c:pt idx="12">
                    <c:v>9.8546233637911498E-2</c:v>
                  </c:pt>
                  <c:pt idx="13">
                    <c:v>5.6347896123622697E-2</c:v>
                  </c:pt>
                  <c:pt idx="14">
                    <c:v>7.8742220161072074E-2</c:v>
                  </c:pt>
                  <c:pt idx="15">
                    <c:v>6.9937017984286892E-2</c:v>
                  </c:pt>
                  <c:pt idx="16">
                    <c:v>5.4605228818213253E-2</c:v>
                  </c:pt>
                  <c:pt idx="17">
                    <c:v>5.6341075779326524E-2</c:v>
                  </c:pt>
                  <c:pt idx="18">
                    <c:v>5.8247299242486422E-2</c:v>
                  </c:pt>
                  <c:pt idx="20">
                    <c:v>7.4351548909900658E-2</c:v>
                  </c:pt>
                  <c:pt idx="21">
                    <c:v>6.7466338005237075E-2</c:v>
                  </c:pt>
                  <c:pt idx="22">
                    <c:v>6.7443572534670607E-2</c:v>
                  </c:pt>
                  <c:pt idx="23">
                    <c:v>3.4134834656598827E-2</c:v>
                  </c:pt>
                  <c:pt idx="24">
                    <c:v>5.0623358066267193E-2</c:v>
                  </c:pt>
                  <c:pt idx="25">
                    <c:v>4.9084378065587006E-2</c:v>
                  </c:pt>
                  <c:pt idx="26">
                    <c:v>5.7711022631946461E-2</c:v>
                  </c:pt>
                  <c:pt idx="27">
                    <c:v>2.3420212318475846E-2</c:v>
                  </c:pt>
                  <c:pt idx="29">
                    <c:v>5.9951981720568169E-2</c:v>
                  </c:pt>
                  <c:pt idx="30">
                    <c:v>7.1919274724516299E-2</c:v>
                  </c:pt>
                  <c:pt idx="31">
                    <c:v>6.839182563050987E-2</c:v>
                  </c:pt>
                  <c:pt idx="32">
                    <c:v>1.5729687756693537E-2</c:v>
                  </c:pt>
                  <c:pt idx="33">
                    <c:v>2.8743954046066267E-2</c:v>
                  </c:pt>
                  <c:pt idx="34">
                    <c:v>3.325546225374016E-2</c:v>
                  </c:pt>
                  <c:pt idx="35">
                    <c:v>1.3111860517013168E-2</c:v>
                  </c:pt>
                  <c:pt idx="36">
                    <c:v>6.1448964320690726E-2</c:v>
                  </c:pt>
                </c:numCache>
              </c:numRef>
            </c:minus>
            <c:spPr>
              <a:noFill/>
              <a:ln w="254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组3!$AQ$2:$AQ$38</c:f>
              <c:numCache>
                <c:formatCode>General</c:formatCode>
                <c:ptCount val="37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9">
                  <c:v>1</c:v>
                </c:pt>
                <c:pt idx="11">
                  <c:v>1</c:v>
                </c:pt>
                <c:pt idx="12">
                  <c:v>2</c:v>
                </c:pt>
                <c:pt idx="13">
                  <c:v>3</c:v>
                </c:pt>
                <c:pt idx="14">
                  <c:v>4</c:v>
                </c:pt>
                <c:pt idx="15">
                  <c:v>5</c:v>
                </c:pt>
                <c:pt idx="16">
                  <c:v>6</c:v>
                </c:pt>
                <c:pt idx="17">
                  <c:v>7</c:v>
                </c:pt>
                <c:pt idx="18">
                  <c:v>8</c:v>
                </c:pt>
                <c:pt idx="20">
                  <c:v>1</c:v>
                </c:pt>
                <c:pt idx="21">
                  <c:v>2</c:v>
                </c:pt>
                <c:pt idx="22">
                  <c:v>3</c:v>
                </c:pt>
                <c:pt idx="23">
                  <c:v>4</c:v>
                </c:pt>
                <c:pt idx="24">
                  <c:v>5</c:v>
                </c:pt>
                <c:pt idx="25">
                  <c:v>6</c:v>
                </c:pt>
                <c:pt idx="26">
                  <c:v>7</c:v>
                </c:pt>
                <c:pt idx="27">
                  <c:v>8</c:v>
                </c:pt>
                <c:pt idx="29">
                  <c:v>1</c:v>
                </c:pt>
                <c:pt idx="30">
                  <c:v>2</c:v>
                </c:pt>
                <c:pt idx="31">
                  <c:v>3</c:v>
                </c:pt>
                <c:pt idx="32">
                  <c:v>4</c:v>
                </c:pt>
                <c:pt idx="33">
                  <c:v>5</c:v>
                </c:pt>
                <c:pt idx="34">
                  <c:v>6</c:v>
                </c:pt>
                <c:pt idx="35">
                  <c:v>7</c:v>
                </c:pt>
                <c:pt idx="36">
                  <c:v>8</c:v>
                </c:pt>
              </c:numCache>
            </c:numRef>
          </c:cat>
          <c:val>
            <c:numRef>
              <c:f>组3!$AS$2:$AS$38</c:f>
              <c:numCache>
                <c:formatCode>General</c:formatCode>
                <c:ptCount val="37"/>
                <c:pt idx="0">
                  <c:v>0.70944424401742701</c:v>
                </c:pt>
                <c:pt idx="1">
                  <c:v>0.46289067995053379</c:v>
                </c:pt>
                <c:pt idx="2">
                  <c:v>0.36549105199057436</c:v>
                </c:pt>
                <c:pt idx="3">
                  <c:v>0.24981771886949181</c:v>
                </c:pt>
                <c:pt idx="4">
                  <c:v>0.1377334965874922</c:v>
                </c:pt>
                <c:pt idx="5">
                  <c:v>0.12592265936565986</c:v>
                </c:pt>
                <c:pt idx="6">
                  <c:v>0.1563443746190297</c:v>
                </c:pt>
                <c:pt idx="7">
                  <c:v>5.2803450363258286E-2</c:v>
                </c:pt>
                <c:pt idx="11">
                  <c:v>0.48524802463223227</c:v>
                </c:pt>
                <c:pt idx="12">
                  <c:v>0.33203209390390176</c:v>
                </c:pt>
                <c:pt idx="13">
                  <c:v>0.13467944173341262</c:v>
                </c:pt>
                <c:pt idx="14">
                  <c:v>0.22263776811199171</c:v>
                </c:pt>
                <c:pt idx="15">
                  <c:v>0.14408551409830742</c:v>
                </c:pt>
                <c:pt idx="16">
                  <c:v>0.13073462869305955</c:v>
                </c:pt>
                <c:pt idx="17">
                  <c:v>0.1427483008730896</c:v>
                </c:pt>
                <c:pt idx="18">
                  <c:v>9.13929064177047E-2</c:v>
                </c:pt>
                <c:pt idx="20">
                  <c:v>0.25198092356801072</c:v>
                </c:pt>
                <c:pt idx="21">
                  <c:v>0.24065229244046349</c:v>
                </c:pt>
                <c:pt idx="22">
                  <c:v>0.17638496910563334</c:v>
                </c:pt>
                <c:pt idx="23">
                  <c:v>5.8056537045758617E-2</c:v>
                </c:pt>
                <c:pt idx="24">
                  <c:v>9.0958114552632779E-2</c:v>
                </c:pt>
                <c:pt idx="25">
                  <c:v>0.12544651028087941</c:v>
                </c:pt>
                <c:pt idx="26">
                  <c:v>9.5274227207291479E-2</c:v>
                </c:pt>
                <c:pt idx="27">
                  <c:v>3.9237339947067372E-2</c:v>
                </c:pt>
                <c:pt idx="29">
                  <c:v>0.22119282215683719</c:v>
                </c:pt>
                <c:pt idx="30">
                  <c:v>0.16750456341903869</c:v>
                </c:pt>
                <c:pt idx="31">
                  <c:v>0.10971691651949658</c:v>
                </c:pt>
                <c:pt idx="32">
                  <c:v>1.5729687756693537E-2</c:v>
                </c:pt>
                <c:pt idx="33">
                  <c:v>3.4539804150621425E-2</c:v>
                </c:pt>
                <c:pt idx="34">
                  <c:v>6.1286711843404562E-2</c:v>
                </c:pt>
                <c:pt idx="35">
                  <c:v>1.3111860517013168E-2</c:v>
                </c:pt>
                <c:pt idx="36">
                  <c:v>0.1009629994858607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BA7D-4F4D-9FDA-888BE6BDBF1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23352704"/>
        <c:axId val="223354240"/>
      </c:lineChart>
      <c:catAx>
        <c:axId val="223352704"/>
        <c:scaling>
          <c:orientation val="minMax"/>
        </c:scaling>
        <c:delete val="0"/>
        <c:axPos val="b"/>
        <c:numFmt formatCode="General" sourceLinked="0"/>
        <c:majorTickMark val="in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ln>
                  <a:solidFill>
                    <a:schemeClr val="tx1"/>
                  </a:solidFill>
                </a:ln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223354240"/>
        <c:crosses val="autoZero"/>
        <c:auto val="1"/>
        <c:lblAlgn val="ctr"/>
        <c:lblOffset val="100"/>
        <c:tickMarkSkip val="1"/>
        <c:noMultiLvlLbl val="0"/>
      </c:catAx>
      <c:valAx>
        <c:axId val="22335424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ln>
                      <a:solidFill>
                        <a:schemeClr val="tx1"/>
                      </a:solidFill>
                    </a:ln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 sz="1800" dirty="0" smtClean="0"/>
                  <a:t>Normalized</a:t>
                </a:r>
                <a:r>
                  <a:rPr lang="en-US" altLang="zh-CN" sz="1800" baseline="0" dirty="0" smtClean="0"/>
                  <a:t> SCR</a:t>
                </a:r>
                <a:endParaRPr lang="zh-CN" altLang="en-US" sz="1800" dirty="0"/>
              </a:p>
            </c:rich>
          </c:tx>
          <c:layout>
            <c:manualLayout>
              <c:xMode val="edge"/>
              <c:yMode val="edge"/>
              <c:x val="9.5742290026246714E-3"/>
              <c:y val="0.24244101878900787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ln>
                  <a:solidFill>
                    <a:schemeClr val="tx1"/>
                  </a:solidFill>
                </a:ln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223352704"/>
        <c:crossesAt val="1"/>
        <c:crossBetween val="between"/>
      </c:valAx>
      <c:spPr>
        <a:noFill/>
        <a:ln>
          <a:noFill/>
        </a:ln>
        <a:effectLst/>
      </c:spPr>
    </c:plotArea>
    <c:legend>
      <c:legendPos val="tr"/>
      <c:layout>
        <c:manualLayout>
          <c:xMode val="edge"/>
          <c:yMode val="edge"/>
          <c:x val="0.88473167576272915"/>
          <c:y val="0.17140560623297343"/>
          <c:w val="9.106197614744399E-2"/>
          <c:h val="0.1763204239687513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ln>
                <a:solidFill>
                  <a:schemeClr val="tx1"/>
                </a:solidFill>
              </a:ln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2">
    <c:autoUpdate val="0"/>
  </c:externalData>
  <c:userShapes r:id="rId3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1700082020997375"/>
          <c:y val="0.30039825057203851"/>
          <c:w val="0.8190350902992094"/>
          <c:h val="0.5533873695227400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图!$A$24</c:f>
              <c:strCache>
                <c:ptCount val="1"/>
                <c:pt idx="0">
                  <c:v>last trial of extinction </c:v>
                </c:pt>
              </c:strCache>
            </c:strRef>
          </c:tx>
          <c:spPr>
            <a:solidFill>
              <a:sysClr val="window" lastClr="FFFFFF"/>
            </a:solidFill>
            <a:ln w="22225"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stdErr"/>
            <c:noEndCap val="0"/>
          </c:errBars>
          <c:cat>
            <c:strRef>
              <c:f>图!$B$23:$E$23</c:f>
              <c:strCache>
                <c:ptCount val="4"/>
                <c:pt idx="0">
                  <c:v>no Retrieval</c:v>
                </c:pt>
                <c:pt idx="1">
                  <c:v>1/3 Retrieval</c:v>
                </c:pt>
                <c:pt idx="2">
                  <c:v>2/3 Retrieval</c:v>
                </c:pt>
                <c:pt idx="3">
                  <c:v>Retrieval</c:v>
                </c:pt>
              </c:strCache>
            </c:strRef>
          </c:cat>
          <c:val>
            <c:numRef>
              <c:f>图!$B$24:$E$24</c:f>
              <c:numCache>
                <c:formatCode>General</c:formatCode>
                <c:ptCount val="4"/>
                <c:pt idx="0">
                  <c:v>7.639100886206002E-3</c:v>
                </c:pt>
                <c:pt idx="1">
                  <c:v>4.9592211558429078E-2</c:v>
                </c:pt>
                <c:pt idx="2">
                  <c:v>5.1713350482724459E-3</c:v>
                </c:pt>
                <c:pt idx="3">
                  <c:v>8.6934916883782992E-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3178-4678-9CEF-306F588F1E80}"/>
            </c:ext>
          </c:extLst>
        </c:ser>
        <c:ser>
          <c:idx val="1"/>
          <c:order val="1"/>
          <c:tx>
            <c:strRef>
              <c:f>图!$A$25</c:f>
              <c:strCache>
                <c:ptCount val="1"/>
                <c:pt idx="0">
                  <c:v>1st of spontaneous recovery</c:v>
                </c:pt>
              </c:strCache>
            </c:strRef>
          </c:tx>
          <c:spPr>
            <a:solidFill>
              <a:sysClr val="windowText" lastClr="000000">
                <a:lumMod val="50000"/>
                <a:lumOff val="50000"/>
              </a:sysClr>
            </a:solidFill>
            <a:ln w="22225"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stdErr"/>
            <c:noEndCap val="0"/>
          </c:errBars>
          <c:cat>
            <c:strRef>
              <c:f>图!$B$23:$E$23</c:f>
              <c:strCache>
                <c:ptCount val="4"/>
                <c:pt idx="0">
                  <c:v>no Retrieval</c:v>
                </c:pt>
                <c:pt idx="1">
                  <c:v>1/3 Retrieval</c:v>
                </c:pt>
                <c:pt idx="2">
                  <c:v>2/3 Retrieval</c:v>
                </c:pt>
                <c:pt idx="3">
                  <c:v>Retrieval</c:v>
                </c:pt>
              </c:strCache>
            </c:strRef>
          </c:cat>
          <c:val>
            <c:numRef>
              <c:f>图!$B$25:$E$25</c:f>
              <c:numCache>
                <c:formatCode>General</c:formatCode>
                <c:ptCount val="4"/>
                <c:pt idx="0">
                  <c:v>0.34797064380588827</c:v>
                </c:pt>
                <c:pt idx="1">
                  <c:v>0.35884885161054025</c:v>
                </c:pt>
                <c:pt idx="2">
                  <c:v>4.8618100399745387E-2</c:v>
                </c:pt>
                <c:pt idx="3">
                  <c:v>0.2783372669669811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3178-4678-9CEF-306F588F1E8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23693056"/>
        <c:axId val="223694848"/>
      </c:barChart>
      <c:catAx>
        <c:axId val="2236930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ln>
                  <a:solidFill>
                    <a:sysClr val="windowText" lastClr="000000"/>
                  </a:solidFill>
                </a:ln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223694848"/>
        <c:crosses val="autoZero"/>
        <c:auto val="1"/>
        <c:lblAlgn val="ctr"/>
        <c:lblOffset val="600"/>
        <c:noMultiLvlLbl val="0"/>
      </c:catAx>
      <c:valAx>
        <c:axId val="22369484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ln>
                      <a:solidFill>
                        <a:sysClr val="windowText" lastClr="000000"/>
                      </a:solidFill>
                    </a:ln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 sz="1800" b="0" i="0" baseline="0" dirty="0" smtClean="0">
                    <a:effectLst/>
                  </a:rPr>
                  <a:t>Normalized mean </a:t>
                </a:r>
                <a:r>
                  <a:rPr lang="en-US" altLang="zh-CN" sz="1800" b="0" i="0" baseline="0" dirty="0">
                    <a:effectLst/>
                  </a:rPr>
                  <a:t>differential </a:t>
                </a:r>
                <a:r>
                  <a:rPr lang="en-US" altLang="zh-CN" sz="1800" b="0" i="0" baseline="0" dirty="0" smtClean="0">
                    <a:effectLst/>
                  </a:rPr>
                  <a:t>SCR </a:t>
                </a:r>
                <a:endParaRPr lang="zh-CN" altLang="zh-CN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2.5114191898220034E-2"/>
              <c:y val="0.25877579082472535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rgbClr val="40404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ln>
                  <a:solidFill>
                    <a:srgbClr val="404040"/>
                  </a:solidFill>
                </a:ln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22369305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r"/>
      <c:layout>
        <c:manualLayout>
          <c:xMode val="edge"/>
          <c:yMode val="edge"/>
          <c:x val="0.10258966596500872"/>
          <c:y val="3.3137240146036693E-4"/>
          <c:w val="0.41431427783812297"/>
          <c:h val="0.1951418065334594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ln>
                <a:solidFill>
                  <a:sysClr val="windowText" lastClr="000000"/>
                </a:solidFill>
              </a:ln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 baseline="0"/>
      </a:pPr>
      <a:endParaRPr lang="zh-CN"/>
    </a:p>
  </c:txPr>
  <c:externalData r:id="rId2">
    <c:autoUpdate val="0"/>
  </c:externalData>
  <c:userShapes r:id="rId3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1700082020997375"/>
          <c:y val="0.30039825057203851"/>
          <c:w val="0.8190350902992094"/>
          <c:h val="0.5533873695227400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图!$A$57</c:f>
              <c:strCache>
                <c:ptCount val="1"/>
                <c:pt idx="0">
                  <c:v>last trial of spontaneous</c:v>
                </c:pt>
              </c:strCache>
            </c:strRef>
          </c:tx>
          <c:spPr>
            <a:solidFill>
              <a:sysClr val="window" lastClr="FFFFFF"/>
            </a:solidFill>
            <a:ln w="22225"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stdErr"/>
            <c:noEndCap val="0"/>
          </c:errBars>
          <c:cat>
            <c:strRef>
              <c:f>图!$B$56:$E$56</c:f>
              <c:strCache>
                <c:ptCount val="4"/>
                <c:pt idx="0">
                  <c:v>no Retrieval</c:v>
                </c:pt>
                <c:pt idx="1">
                  <c:v>1/3 Retrieval</c:v>
                </c:pt>
                <c:pt idx="2">
                  <c:v>2/3 Retrieval</c:v>
                </c:pt>
                <c:pt idx="3">
                  <c:v>Retrieval</c:v>
                </c:pt>
              </c:strCache>
            </c:strRef>
          </c:cat>
          <c:val>
            <c:numRef>
              <c:f>图!$B$57:$E$57</c:f>
              <c:numCache>
                <c:formatCode>General</c:formatCode>
                <c:ptCount val="4"/>
                <c:pt idx="0">
                  <c:v>1.3082168485854206E-2</c:v>
                </c:pt>
                <c:pt idx="1">
                  <c:v>1.1253573154113865E-2</c:v>
                </c:pt>
                <c:pt idx="2">
                  <c:v>-2.6205764562157339E-3</c:v>
                </c:pt>
                <c:pt idx="3">
                  <c:v>2.090757262439083E-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91E5-4CFD-AF2D-3DAD014F934E}"/>
            </c:ext>
          </c:extLst>
        </c:ser>
        <c:ser>
          <c:idx val="1"/>
          <c:order val="1"/>
          <c:tx>
            <c:strRef>
              <c:f>图!$A$58</c:f>
              <c:strCache>
                <c:ptCount val="1"/>
                <c:pt idx="0">
                  <c:v>1st of reinstatement</c:v>
                </c:pt>
              </c:strCache>
            </c:strRef>
          </c:tx>
          <c:spPr>
            <a:solidFill>
              <a:sysClr val="windowText" lastClr="000000">
                <a:lumMod val="50000"/>
                <a:lumOff val="50000"/>
              </a:sysClr>
            </a:solidFill>
            <a:ln w="22225"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stdErr"/>
            <c:noEndCap val="0"/>
          </c:errBars>
          <c:cat>
            <c:strRef>
              <c:f>图!$B$56:$E$56</c:f>
              <c:strCache>
                <c:ptCount val="4"/>
                <c:pt idx="0">
                  <c:v>no Retrieval</c:v>
                </c:pt>
                <c:pt idx="1">
                  <c:v>1/3 Retrieval</c:v>
                </c:pt>
                <c:pt idx="2">
                  <c:v>2/3 Retrieval</c:v>
                </c:pt>
                <c:pt idx="3">
                  <c:v>Retrieval</c:v>
                </c:pt>
              </c:strCache>
            </c:strRef>
          </c:cat>
          <c:val>
            <c:numRef>
              <c:f>图!$B$58:$E$58</c:f>
              <c:numCache>
                <c:formatCode>General</c:formatCode>
                <c:ptCount val="4"/>
                <c:pt idx="0">
                  <c:v>0.28765969377220191</c:v>
                </c:pt>
                <c:pt idx="1">
                  <c:v>0.31938506685116053</c:v>
                </c:pt>
                <c:pt idx="2">
                  <c:v>4.1840350999063067E-2</c:v>
                </c:pt>
                <c:pt idx="3">
                  <c:v>3.5960418074141784E-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91E5-4CFD-AF2D-3DAD014F934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23771648"/>
        <c:axId val="223773440"/>
      </c:barChart>
      <c:catAx>
        <c:axId val="2237716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ln>
                  <a:solidFill>
                    <a:sysClr val="windowText" lastClr="000000"/>
                  </a:solidFill>
                </a:ln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223773440"/>
        <c:crosses val="autoZero"/>
        <c:auto val="1"/>
        <c:lblAlgn val="ctr"/>
        <c:lblOffset val="600"/>
        <c:noMultiLvlLbl val="0"/>
      </c:catAx>
      <c:valAx>
        <c:axId val="22377344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ln>
                      <a:solidFill>
                        <a:sysClr val="windowText" lastClr="000000"/>
                      </a:solidFill>
                    </a:ln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 sz="1800" b="0" i="0" baseline="0" dirty="0" smtClean="0">
                    <a:effectLst/>
                  </a:rPr>
                  <a:t>Normalized mean </a:t>
                </a:r>
                <a:r>
                  <a:rPr lang="en-US" altLang="zh-CN" sz="1800" b="0" i="0" baseline="0" dirty="0">
                    <a:effectLst/>
                  </a:rPr>
                  <a:t>differential </a:t>
                </a:r>
                <a:r>
                  <a:rPr lang="en-US" altLang="zh-CN" sz="1800" b="0" i="0" baseline="0" dirty="0" smtClean="0">
                    <a:effectLst/>
                  </a:rPr>
                  <a:t>SCR </a:t>
                </a:r>
                <a:endParaRPr lang="zh-CN" altLang="zh-CN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2.5114191898220034E-2"/>
              <c:y val="0.25877579082472535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rgbClr val="40404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ln>
                  <a:solidFill>
                    <a:srgbClr val="404040"/>
                  </a:solidFill>
                </a:ln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22377164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r"/>
      <c:layout>
        <c:manualLayout>
          <c:xMode val="edge"/>
          <c:yMode val="edge"/>
          <c:x val="0.10258971223591799"/>
          <c:y val="3.3146974111667913E-4"/>
          <c:w val="0.41431427783812297"/>
          <c:h val="0.1951418065334594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ln>
                <a:solidFill>
                  <a:sysClr val="windowText" lastClr="000000"/>
                </a:solidFill>
              </a:ln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 baseline="0"/>
      </a:pPr>
      <a:endParaRPr lang="zh-CN"/>
    </a:p>
  </c:txPr>
  <c:externalData r:id="rId2">
    <c:autoUpdate val="0"/>
  </c:externalData>
  <c:userShapes r:id="rId3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1700082020997375"/>
          <c:y val="0.21065348938366277"/>
          <c:w val="0.86335094438734206"/>
          <c:h val="0.7289503295715239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图!$A$2</c:f>
              <c:strCache>
                <c:ptCount val="1"/>
                <c:pt idx="0">
                  <c:v>no Retrieval</c:v>
                </c:pt>
              </c:strCache>
            </c:strRef>
          </c:tx>
          <c:spPr>
            <a:solidFill>
              <a:sysClr val="window" lastClr="FFFFFF"/>
            </a:solidFill>
            <a:ln w="22225">
              <a:solidFill>
                <a:sysClr val="windowText" lastClr="000000"/>
              </a:solidFill>
            </a:ln>
            <a:effectLst/>
          </c:spPr>
          <c:invertIfNegative val="0"/>
          <c:dLbls>
            <c:delete val="1"/>
          </c:dLbls>
          <c:errBars>
            <c:errBarType val="both"/>
            <c:errValType val="stdErr"/>
            <c:noEndCap val="0"/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图!$B$1:$E$1</c:f>
              <c:strCache>
                <c:ptCount val="4"/>
                <c:pt idx="0">
                  <c:v>acquisition</c:v>
                </c:pt>
                <c:pt idx="1">
                  <c:v>extinction </c:v>
                </c:pt>
                <c:pt idx="2">
                  <c:v>spontaneous recovery</c:v>
                </c:pt>
                <c:pt idx="3">
                  <c:v>reinstatement</c:v>
                </c:pt>
              </c:strCache>
            </c:strRef>
          </c:cat>
          <c:val>
            <c:numRef>
              <c:f>图!$B$2:$E$2</c:f>
              <c:numCache>
                <c:formatCode>General</c:formatCode>
                <c:ptCount val="4"/>
                <c:pt idx="0">
                  <c:v>0.25810690767359701</c:v>
                </c:pt>
                <c:pt idx="1">
                  <c:v>7.639100886206002E-3</c:v>
                </c:pt>
                <c:pt idx="2">
                  <c:v>0.34797064380588827</c:v>
                </c:pt>
                <c:pt idx="3">
                  <c:v>0.2876596937722019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482C-4ADE-935D-92F00396CFC1}"/>
            </c:ext>
          </c:extLst>
        </c:ser>
        <c:ser>
          <c:idx val="1"/>
          <c:order val="1"/>
          <c:tx>
            <c:strRef>
              <c:f>图!$A$3</c:f>
              <c:strCache>
                <c:ptCount val="1"/>
                <c:pt idx="0">
                  <c:v>1/3 Retrieval</c:v>
                </c:pt>
              </c:strCache>
            </c:strRef>
          </c:tx>
          <c:spPr>
            <a:solidFill>
              <a:sysClr val="windowText" lastClr="000000">
                <a:lumMod val="50000"/>
                <a:lumOff val="50000"/>
              </a:sysClr>
            </a:solidFill>
            <a:ln w="22225">
              <a:solidFill>
                <a:sysClr val="windowText" lastClr="000000"/>
              </a:solidFill>
            </a:ln>
            <a:effectLst/>
          </c:spPr>
          <c:invertIfNegative val="0"/>
          <c:dLbls>
            <c:delete val="1"/>
          </c:dLbls>
          <c:errBars>
            <c:errBarType val="both"/>
            <c:errValType val="stdErr"/>
            <c:noEndCap val="0"/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图!$B$1:$E$1</c:f>
              <c:strCache>
                <c:ptCount val="4"/>
                <c:pt idx="0">
                  <c:v>acquisition</c:v>
                </c:pt>
                <c:pt idx="1">
                  <c:v>extinction </c:v>
                </c:pt>
                <c:pt idx="2">
                  <c:v>spontaneous recovery</c:v>
                </c:pt>
                <c:pt idx="3">
                  <c:v>reinstatement</c:v>
                </c:pt>
              </c:strCache>
            </c:strRef>
          </c:cat>
          <c:val>
            <c:numRef>
              <c:f>图!$B$3:$E$3</c:f>
              <c:numCache>
                <c:formatCode>General</c:formatCode>
                <c:ptCount val="4"/>
                <c:pt idx="0">
                  <c:v>0.3212276113418932</c:v>
                </c:pt>
                <c:pt idx="1">
                  <c:v>4.9592211558429078E-2</c:v>
                </c:pt>
                <c:pt idx="2">
                  <c:v>0.35884885161054025</c:v>
                </c:pt>
                <c:pt idx="3">
                  <c:v>0.3193850668511605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9-482C-4ADE-935D-92F00396CFC1}"/>
            </c:ext>
          </c:extLst>
        </c:ser>
        <c:ser>
          <c:idx val="2"/>
          <c:order val="2"/>
          <c:tx>
            <c:strRef>
              <c:f>图!$A$4</c:f>
              <c:strCache>
                <c:ptCount val="1"/>
                <c:pt idx="0">
                  <c:v>2/3 Retrieval</c:v>
                </c:pt>
              </c:strCache>
            </c:strRef>
          </c:tx>
          <c:spPr>
            <a:pattFill prst="wdDnDiag">
              <a:fgClr>
                <a:sysClr val="windowText" lastClr="000000"/>
              </a:fgClr>
              <a:bgClr>
                <a:sysClr val="window" lastClr="FFFFFF"/>
              </a:bgClr>
            </a:pattFill>
            <a:ln w="22225">
              <a:solidFill>
                <a:sysClr val="windowText" lastClr="000000"/>
              </a:solidFill>
            </a:ln>
            <a:effectLst/>
          </c:spPr>
          <c:invertIfNegative val="0"/>
          <c:dLbls>
            <c:delete val="1"/>
          </c:dLbls>
          <c:errBars>
            <c:errBarType val="both"/>
            <c:errValType val="stdErr"/>
            <c:noEndCap val="0"/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图!$B$1:$E$1</c:f>
              <c:strCache>
                <c:ptCount val="4"/>
                <c:pt idx="0">
                  <c:v>acquisition</c:v>
                </c:pt>
                <c:pt idx="1">
                  <c:v>extinction </c:v>
                </c:pt>
                <c:pt idx="2">
                  <c:v>spontaneous recovery</c:v>
                </c:pt>
                <c:pt idx="3">
                  <c:v>reinstatement</c:v>
                </c:pt>
              </c:strCache>
            </c:strRef>
          </c:cat>
          <c:val>
            <c:numRef>
              <c:f>图!$B$4:$E$4</c:f>
              <c:numCache>
                <c:formatCode>General</c:formatCode>
                <c:ptCount val="4"/>
                <c:pt idx="0">
                  <c:v>0.30589922043762974</c:v>
                </c:pt>
                <c:pt idx="1">
                  <c:v>5.1713350482724459E-3</c:v>
                </c:pt>
                <c:pt idx="2">
                  <c:v>4.8618100399745387E-2</c:v>
                </c:pt>
                <c:pt idx="3">
                  <c:v>4.1840350999063067E-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E-482C-4ADE-935D-92F00396CFC1}"/>
            </c:ext>
          </c:extLst>
        </c:ser>
        <c:ser>
          <c:idx val="3"/>
          <c:order val="3"/>
          <c:tx>
            <c:strRef>
              <c:f>图!$A$5</c:f>
              <c:strCache>
                <c:ptCount val="1"/>
                <c:pt idx="0">
                  <c:v>Retrieval</c:v>
                </c:pt>
              </c:strCache>
            </c:strRef>
          </c:tx>
          <c:spPr>
            <a:solidFill>
              <a:sysClr val="windowText" lastClr="000000"/>
            </a:solidFill>
            <a:ln w="22225">
              <a:solidFill>
                <a:sysClr val="windowText" lastClr="000000"/>
              </a:solidFill>
            </a:ln>
            <a:effectLst/>
          </c:spPr>
          <c:invertIfNegative val="0"/>
          <c:dLbls>
            <c:delete val="1"/>
          </c:dLbls>
          <c:errBars>
            <c:errBarType val="both"/>
            <c:errValType val="stdErr"/>
            <c:noEndCap val="0"/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图!$B$1:$E$1</c:f>
              <c:strCache>
                <c:ptCount val="4"/>
                <c:pt idx="0">
                  <c:v>acquisition</c:v>
                </c:pt>
                <c:pt idx="1">
                  <c:v>extinction </c:v>
                </c:pt>
                <c:pt idx="2">
                  <c:v>spontaneous recovery</c:v>
                </c:pt>
                <c:pt idx="3">
                  <c:v>reinstatement</c:v>
                </c:pt>
              </c:strCache>
            </c:strRef>
          </c:cat>
          <c:val>
            <c:numRef>
              <c:f>图!$B$5:$E$5</c:f>
              <c:numCache>
                <c:formatCode>General</c:formatCode>
                <c:ptCount val="4"/>
                <c:pt idx="0">
                  <c:v>0.26625274080199335</c:v>
                </c:pt>
                <c:pt idx="1">
                  <c:v>8.6934916883782992E-2</c:v>
                </c:pt>
                <c:pt idx="2">
                  <c:v>0.27833726696698119</c:v>
                </c:pt>
                <c:pt idx="3">
                  <c:v>3.5960418074141784E-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3-482C-4ADE-935D-92F00396CFC1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100"/>
        <c:axId val="223446912"/>
        <c:axId val="223448448"/>
      </c:barChart>
      <c:catAx>
        <c:axId val="2234469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ln>
                  <a:solidFill>
                    <a:sysClr val="windowText" lastClr="000000"/>
                  </a:solidFill>
                </a:ln>
                <a:solidFill>
                  <a:schemeClr val="tx1">
                    <a:lumMod val="65000"/>
                    <a:lumOff val="35000"/>
                  </a:schemeClr>
                </a:solidFill>
                <a:latin typeface="Cambria Math" panose="02040503050406030204" pitchFamily="18" charset="0"/>
                <a:ea typeface="Cambria Math" panose="02040503050406030204" pitchFamily="18" charset="0"/>
                <a:cs typeface="+mn-cs"/>
              </a:defRPr>
            </a:pPr>
            <a:endParaRPr lang="zh-CN"/>
          </a:p>
        </c:txPr>
        <c:crossAx val="223448448"/>
        <c:crosses val="autoZero"/>
        <c:auto val="1"/>
        <c:lblAlgn val="ctr"/>
        <c:lblOffset val="600"/>
        <c:noMultiLvlLbl val="0"/>
      </c:catAx>
      <c:valAx>
        <c:axId val="22344844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ln>
                      <a:solidFill>
                        <a:sysClr val="windowText" lastClr="000000"/>
                      </a:solidFill>
                    </a:ln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 sz="1800" b="0" i="0" baseline="0" dirty="0" smtClean="0">
                    <a:effectLst/>
                  </a:rPr>
                  <a:t>Normalized mean </a:t>
                </a:r>
                <a:r>
                  <a:rPr lang="en-US" altLang="zh-CN" sz="1800" b="0" i="0" baseline="0" dirty="0">
                    <a:effectLst/>
                  </a:rPr>
                  <a:t>differential </a:t>
                </a:r>
                <a:r>
                  <a:rPr lang="en-US" altLang="zh-CN" sz="1800" b="0" i="0" baseline="0" dirty="0" smtClean="0">
                    <a:effectLst/>
                  </a:rPr>
                  <a:t>SCR</a:t>
                </a:r>
                <a:endParaRPr lang="zh-CN" altLang="zh-CN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3.9041994750656166E-2"/>
              <c:y val="0.25030775047487575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rgbClr val="40404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ln>
                  <a:solidFill>
                    <a:srgbClr val="404040"/>
                  </a:solidFill>
                </a:ln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223446912"/>
        <c:crosses val="autoZero"/>
        <c:crossBetween val="between"/>
      </c:valAx>
      <c:spPr>
        <a:noFill/>
        <a:ln w="25400">
          <a:noFill/>
        </a:ln>
        <a:effectLst/>
      </c:spPr>
    </c:plotArea>
    <c:legend>
      <c:legendPos val="tr"/>
      <c:layout>
        <c:manualLayout>
          <c:xMode val="edge"/>
          <c:yMode val="edge"/>
          <c:x val="0.14057477322755288"/>
          <c:y val="2.3235101908791064E-2"/>
          <c:w val="0.14082200418546764"/>
          <c:h val="0.2213840509869612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ln>
                <a:solidFill>
                  <a:sysClr val="windowText" lastClr="000000"/>
                </a:solidFill>
              </a:ln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 baseline="0"/>
      </a:pPr>
      <a:endParaRPr lang="zh-CN"/>
    </a:p>
  </c:txPr>
  <c:externalData r:id="rId2">
    <c:autoUpdate val="0"/>
  </c:externalData>
  <c:userShapes r:id="rId3"/>
</c:chartSpace>
</file>

<file path=ppt/charts/colors1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6147</cdr:x>
      <cdr:y>0.01142</cdr:y>
    </cdr:from>
    <cdr:to>
      <cdr:x>0.40267</cdr:x>
      <cdr:y>0.16807</cdr:y>
    </cdr:to>
    <cdr:sp macro="" textlink="">
      <cdr:nvSpPr>
        <cdr:cNvPr id="16" name="文本框 1"/>
        <cdr:cNvSpPr txBox="1"/>
      </cdr:nvSpPr>
      <cdr:spPr>
        <a:xfrm xmlns:a="http://schemas.openxmlformats.org/drawingml/2006/main">
          <a:off x="3175000" y="38894"/>
          <a:ext cx="1714500" cy="533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zh-CN" sz="1800" b="1" dirty="0"/>
            <a:t>Retrieval</a:t>
          </a:r>
          <a:endParaRPr lang="zh-CN" altLang="en-US" sz="1800" b="1" dirty="0"/>
        </a:p>
      </cdr:txBody>
    </cdr:sp>
  </cdr:relSizeAnchor>
  <cdr:relSizeAnchor xmlns:cdr="http://schemas.openxmlformats.org/drawingml/2006/chartDrawing">
    <cdr:from>
      <cdr:x>0.28612</cdr:x>
      <cdr:y>0.15455</cdr:y>
    </cdr:from>
    <cdr:to>
      <cdr:x>0.28631</cdr:x>
      <cdr:y>0.79371</cdr:y>
    </cdr:to>
    <cdr:cxnSp macro="">
      <cdr:nvCxnSpPr>
        <cdr:cNvPr id="5" name="直接连接符 4"/>
        <cdr:cNvCxnSpPr/>
      </cdr:nvCxnSpPr>
      <cdr:spPr>
        <a:xfrm xmlns:a="http://schemas.openxmlformats.org/drawingml/2006/main" flipH="1">
          <a:off x="3474244" y="526257"/>
          <a:ext cx="2382" cy="2176462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56077</cdr:x>
      <cdr:y>0.15604</cdr:y>
    </cdr:from>
    <cdr:to>
      <cdr:x>0.56096</cdr:x>
      <cdr:y>0.7952</cdr:y>
    </cdr:to>
    <cdr:cxnSp macro="">
      <cdr:nvCxnSpPr>
        <cdr:cNvPr id="9" name="直接连接符 8"/>
        <cdr:cNvCxnSpPr/>
      </cdr:nvCxnSpPr>
      <cdr:spPr>
        <a:xfrm xmlns:a="http://schemas.openxmlformats.org/drawingml/2006/main" flipH="1">
          <a:off x="6809264" y="531337"/>
          <a:ext cx="2382" cy="2176462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33611</cdr:x>
      <cdr:y>0.15604</cdr:y>
    </cdr:from>
    <cdr:to>
      <cdr:x>0.33631</cdr:x>
      <cdr:y>0.7952</cdr:y>
    </cdr:to>
    <cdr:cxnSp macro="">
      <cdr:nvCxnSpPr>
        <cdr:cNvPr id="10" name="直接连接符 9"/>
        <cdr:cNvCxnSpPr/>
      </cdr:nvCxnSpPr>
      <cdr:spPr>
        <a:xfrm xmlns:a="http://schemas.openxmlformats.org/drawingml/2006/main" flipH="1">
          <a:off x="4081304" y="531337"/>
          <a:ext cx="2382" cy="2176462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77737</cdr:x>
      <cdr:y>0.29372</cdr:y>
    </cdr:from>
    <cdr:to>
      <cdr:x>0.79605</cdr:x>
      <cdr:y>0.39362</cdr:y>
    </cdr:to>
    <cdr:sp macro="" textlink="">
      <cdr:nvSpPr>
        <cdr:cNvPr id="12" name="闪电形 11"/>
        <cdr:cNvSpPr/>
      </cdr:nvSpPr>
      <cdr:spPr>
        <a:xfrm xmlns:a="http://schemas.openxmlformats.org/drawingml/2006/main" flipH="1">
          <a:off x="9439422" y="1000186"/>
          <a:ext cx="226842" cy="340165"/>
        </a:xfrm>
        <a:prstGeom xmlns:a="http://schemas.openxmlformats.org/drawingml/2006/main" prst="lightningBolt">
          <a:avLst/>
        </a:prstGeom>
        <a:ln xmlns:a="http://schemas.openxmlformats.org/drawingml/2006/main"/>
      </cdr:spPr>
      <cdr:style>
        <a:lnRef xmlns:a="http://schemas.openxmlformats.org/drawingml/2006/main" idx="2">
          <a:schemeClr val="dk1">
            <a:shade val="50000"/>
          </a:schemeClr>
        </a:lnRef>
        <a:fillRef xmlns:a="http://schemas.openxmlformats.org/drawingml/2006/main" idx="1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zh-CN"/>
        </a:p>
      </cdr:txBody>
    </cdr:sp>
  </cdr:relSizeAnchor>
  <cdr:relSizeAnchor xmlns:cdr="http://schemas.openxmlformats.org/drawingml/2006/chartDrawing">
    <cdr:from>
      <cdr:x>0.10668</cdr:x>
      <cdr:y>0.01142</cdr:y>
    </cdr:from>
    <cdr:to>
      <cdr:x>0.24788</cdr:x>
      <cdr:y>0.16807</cdr:y>
    </cdr:to>
    <cdr:sp macro="" textlink="">
      <cdr:nvSpPr>
        <cdr:cNvPr id="13" name="文本框 12"/>
        <cdr:cNvSpPr txBox="1"/>
      </cdr:nvSpPr>
      <cdr:spPr>
        <a:xfrm xmlns:a="http://schemas.openxmlformats.org/drawingml/2006/main">
          <a:off x="1295400" y="38894"/>
          <a:ext cx="1714500" cy="533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zh-CN" sz="1800" b="1" dirty="0"/>
            <a:t>Acquisition</a:t>
          </a:r>
          <a:endParaRPr lang="zh-CN" altLang="en-US" sz="1800" b="1" dirty="0"/>
        </a:p>
      </cdr:txBody>
    </cdr:sp>
  </cdr:relSizeAnchor>
  <cdr:relSizeAnchor xmlns:cdr="http://schemas.openxmlformats.org/drawingml/2006/chartDrawing">
    <cdr:from>
      <cdr:x>0.38907</cdr:x>
      <cdr:y>0.00769</cdr:y>
    </cdr:from>
    <cdr:to>
      <cdr:x>0.53027</cdr:x>
      <cdr:y>0.16434</cdr:y>
    </cdr:to>
    <cdr:sp macro="" textlink="">
      <cdr:nvSpPr>
        <cdr:cNvPr id="17" name="文本框 1"/>
        <cdr:cNvSpPr txBox="1"/>
      </cdr:nvSpPr>
      <cdr:spPr>
        <a:xfrm xmlns:a="http://schemas.openxmlformats.org/drawingml/2006/main">
          <a:off x="4724400" y="26194"/>
          <a:ext cx="1714500" cy="533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zh-CN" sz="1800" b="1" dirty="0"/>
            <a:t>Extinction</a:t>
          </a:r>
          <a:endParaRPr lang="zh-CN" altLang="en-US" sz="1800" b="1" dirty="0"/>
        </a:p>
      </cdr:txBody>
    </cdr:sp>
  </cdr:relSizeAnchor>
  <cdr:relSizeAnchor xmlns:cdr="http://schemas.openxmlformats.org/drawingml/2006/chartDrawing">
    <cdr:from>
      <cdr:x>0.75513</cdr:x>
      <cdr:y>0.01119</cdr:y>
    </cdr:from>
    <cdr:to>
      <cdr:x>0.89633</cdr:x>
      <cdr:y>0.16783</cdr:y>
    </cdr:to>
    <cdr:sp macro="" textlink="">
      <cdr:nvSpPr>
        <cdr:cNvPr id="18" name="文本框 1"/>
        <cdr:cNvSpPr txBox="1"/>
      </cdr:nvSpPr>
      <cdr:spPr>
        <a:xfrm xmlns:a="http://schemas.openxmlformats.org/drawingml/2006/main">
          <a:off x="9169400" y="38100"/>
          <a:ext cx="1714500" cy="533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zh-CN" sz="1800" b="1" dirty="0"/>
            <a:t>Test</a:t>
          </a:r>
          <a:endParaRPr lang="zh-CN" altLang="en-US" sz="1800" b="1" dirty="0"/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26147</cdr:x>
      <cdr:y>0.01142</cdr:y>
    </cdr:from>
    <cdr:to>
      <cdr:x>0.40267</cdr:x>
      <cdr:y>0.16807</cdr:y>
    </cdr:to>
    <cdr:sp macro="" textlink="">
      <cdr:nvSpPr>
        <cdr:cNvPr id="16" name="文本框 1"/>
        <cdr:cNvSpPr txBox="1"/>
      </cdr:nvSpPr>
      <cdr:spPr>
        <a:xfrm xmlns:a="http://schemas.openxmlformats.org/drawingml/2006/main">
          <a:off x="3175000" y="38894"/>
          <a:ext cx="1714500" cy="533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zh-CN" sz="1800" b="1" dirty="0"/>
            <a:t>Retrieval</a:t>
          </a:r>
          <a:endParaRPr lang="zh-CN" altLang="en-US" sz="1800" b="1" dirty="0"/>
        </a:p>
      </cdr:txBody>
    </cdr:sp>
  </cdr:relSizeAnchor>
  <cdr:relSizeAnchor xmlns:cdr="http://schemas.openxmlformats.org/drawingml/2006/chartDrawing">
    <cdr:from>
      <cdr:x>0.28612</cdr:x>
      <cdr:y>0.15455</cdr:y>
    </cdr:from>
    <cdr:to>
      <cdr:x>0.28631</cdr:x>
      <cdr:y>0.79371</cdr:y>
    </cdr:to>
    <cdr:cxnSp macro="">
      <cdr:nvCxnSpPr>
        <cdr:cNvPr id="5" name="直接连接符 4"/>
        <cdr:cNvCxnSpPr/>
      </cdr:nvCxnSpPr>
      <cdr:spPr>
        <a:xfrm xmlns:a="http://schemas.openxmlformats.org/drawingml/2006/main" flipH="1">
          <a:off x="3474244" y="526257"/>
          <a:ext cx="2382" cy="2176462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56077</cdr:x>
      <cdr:y>0.15604</cdr:y>
    </cdr:from>
    <cdr:to>
      <cdr:x>0.56096</cdr:x>
      <cdr:y>0.7952</cdr:y>
    </cdr:to>
    <cdr:cxnSp macro="">
      <cdr:nvCxnSpPr>
        <cdr:cNvPr id="9" name="直接连接符 8"/>
        <cdr:cNvCxnSpPr/>
      </cdr:nvCxnSpPr>
      <cdr:spPr>
        <a:xfrm xmlns:a="http://schemas.openxmlformats.org/drawingml/2006/main" flipH="1">
          <a:off x="6809264" y="531337"/>
          <a:ext cx="2382" cy="2176462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33611</cdr:x>
      <cdr:y>0.15604</cdr:y>
    </cdr:from>
    <cdr:to>
      <cdr:x>0.33631</cdr:x>
      <cdr:y>0.7952</cdr:y>
    </cdr:to>
    <cdr:cxnSp macro="">
      <cdr:nvCxnSpPr>
        <cdr:cNvPr id="10" name="直接连接符 9"/>
        <cdr:cNvCxnSpPr/>
      </cdr:nvCxnSpPr>
      <cdr:spPr>
        <a:xfrm xmlns:a="http://schemas.openxmlformats.org/drawingml/2006/main" flipH="1">
          <a:off x="4081304" y="531337"/>
          <a:ext cx="2382" cy="2176462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77737</cdr:x>
      <cdr:y>0.29372</cdr:y>
    </cdr:from>
    <cdr:to>
      <cdr:x>0.79605</cdr:x>
      <cdr:y>0.39362</cdr:y>
    </cdr:to>
    <cdr:sp macro="" textlink="">
      <cdr:nvSpPr>
        <cdr:cNvPr id="12" name="闪电形 11"/>
        <cdr:cNvSpPr/>
      </cdr:nvSpPr>
      <cdr:spPr>
        <a:xfrm xmlns:a="http://schemas.openxmlformats.org/drawingml/2006/main" flipH="1">
          <a:off x="9439422" y="1000186"/>
          <a:ext cx="226842" cy="340165"/>
        </a:xfrm>
        <a:prstGeom xmlns:a="http://schemas.openxmlformats.org/drawingml/2006/main" prst="lightningBolt">
          <a:avLst/>
        </a:prstGeom>
        <a:ln xmlns:a="http://schemas.openxmlformats.org/drawingml/2006/main"/>
      </cdr:spPr>
      <cdr:style>
        <a:lnRef xmlns:a="http://schemas.openxmlformats.org/drawingml/2006/main" idx="2">
          <a:schemeClr val="dk1">
            <a:shade val="50000"/>
          </a:schemeClr>
        </a:lnRef>
        <a:fillRef xmlns:a="http://schemas.openxmlformats.org/drawingml/2006/main" idx="1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zh-CN"/>
        </a:p>
      </cdr:txBody>
    </cdr:sp>
  </cdr:relSizeAnchor>
  <cdr:relSizeAnchor xmlns:cdr="http://schemas.openxmlformats.org/drawingml/2006/chartDrawing">
    <cdr:from>
      <cdr:x>0.10668</cdr:x>
      <cdr:y>0.01142</cdr:y>
    </cdr:from>
    <cdr:to>
      <cdr:x>0.24788</cdr:x>
      <cdr:y>0.16807</cdr:y>
    </cdr:to>
    <cdr:sp macro="" textlink="">
      <cdr:nvSpPr>
        <cdr:cNvPr id="13" name="文本框 12"/>
        <cdr:cNvSpPr txBox="1"/>
      </cdr:nvSpPr>
      <cdr:spPr>
        <a:xfrm xmlns:a="http://schemas.openxmlformats.org/drawingml/2006/main">
          <a:off x="1295400" y="38894"/>
          <a:ext cx="1714500" cy="533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zh-CN" sz="1800" b="1" dirty="0"/>
            <a:t>Acquisition</a:t>
          </a:r>
          <a:endParaRPr lang="zh-CN" altLang="en-US" sz="1800" b="1" dirty="0"/>
        </a:p>
      </cdr:txBody>
    </cdr:sp>
  </cdr:relSizeAnchor>
  <cdr:relSizeAnchor xmlns:cdr="http://schemas.openxmlformats.org/drawingml/2006/chartDrawing">
    <cdr:from>
      <cdr:x>0.38907</cdr:x>
      <cdr:y>0.00769</cdr:y>
    </cdr:from>
    <cdr:to>
      <cdr:x>0.53027</cdr:x>
      <cdr:y>0.16434</cdr:y>
    </cdr:to>
    <cdr:sp macro="" textlink="">
      <cdr:nvSpPr>
        <cdr:cNvPr id="17" name="文本框 1"/>
        <cdr:cNvSpPr txBox="1"/>
      </cdr:nvSpPr>
      <cdr:spPr>
        <a:xfrm xmlns:a="http://schemas.openxmlformats.org/drawingml/2006/main">
          <a:off x="4724400" y="26194"/>
          <a:ext cx="1714500" cy="533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zh-CN" sz="1800" b="1" dirty="0"/>
            <a:t>Extinction</a:t>
          </a:r>
          <a:endParaRPr lang="zh-CN" altLang="en-US" sz="1800" b="1" dirty="0"/>
        </a:p>
      </cdr:txBody>
    </cdr:sp>
  </cdr:relSizeAnchor>
  <cdr:relSizeAnchor xmlns:cdr="http://schemas.openxmlformats.org/drawingml/2006/chartDrawing">
    <cdr:from>
      <cdr:x>0.75513</cdr:x>
      <cdr:y>0.01119</cdr:y>
    </cdr:from>
    <cdr:to>
      <cdr:x>0.89633</cdr:x>
      <cdr:y>0.16783</cdr:y>
    </cdr:to>
    <cdr:sp macro="" textlink="">
      <cdr:nvSpPr>
        <cdr:cNvPr id="18" name="文本框 1"/>
        <cdr:cNvSpPr txBox="1"/>
      </cdr:nvSpPr>
      <cdr:spPr>
        <a:xfrm xmlns:a="http://schemas.openxmlformats.org/drawingml/2006/main">
          <a:off x="9169400" y="38100"/>
          <a:ext cx="1714500" cy="533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zh-CN" sz="1800" b="1" dirty="0"/>
            <a:t>Test</a:t>
          </a:r>
          <a:endParaRPr lang="zh-CN" altLang="en-US" sz="1800" b="1" dirty="0"/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26147</cdr:x>
      <cdr:y>0.01142</cdr:y>
    </cdr:from>
    <cdr:to>
      <cdr:x>0.40267</cdr:x>
      <cdr:y>0.16807</cdr:y>
    </cdr:to>
    <cdr:sp macro="" textlink="">
      <cdr:nvSpPr>
        <cdr:cNvPr id="16" name="文本框 1"/>
        <cdr:cNvSpPr txBox="1"/>
      </cdr:nvSpPr>
      <cdr:spPr>
        <a:xfrm xmlns:a="http://schemas.openxmlformats.org/drawingml/2006/main">
          <a:off x="3175000" y="38894"/>
          <a:ext cx="1714500" cy="533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zh-CN" sz="1800" b="1" dirty="0"/>
            <a:t>Retrieval</a:t>
          </a:r>
          <a:endParaRPr lang="zh-CN" altLang="en-US" sz="1800" b="1" dirty="0"/>
        </a:p>
      </cdr:txBody>
    </cdr:sp>
  </cdr:relSizeAnchor>
  <cdr:relSizeAnchor xmlns:cdr="http://schemas.openxmlformats.org/drawingml/2006/chartDrawing">
    <cdr:from>
      <cdr:x>0.28612</cdr:x>
      <cdr:y>0.15455</cdr:y>
    </cdr:from>
    <cdr:to>
      <cdr:x>0.28631</cdr:x>
      <cdr:y>0.79371</cdr:y>
    </cdr:to>
    <cdr:cxnSp macro="">
      <cdr:nvCxnSpPr>
        <cdr:cNvPr id="5" name="直接连接符 4"/>
        <cdr:cNvCxnSpPr/>
      </cdr:nvCxnSpPr>
      <cdr:spPr>
        <a:xfrm xmlns:a="http://schemas.openxmlformats.org/drawingml/2006/main" flipH="1">
          <a:off x="3474244" y="526257"/>
          <a:ext cx="2382" cy="2176462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56077</cdr:x>
      <cdr:y>0.15604</cdr:y>
    </cdr:from>
    <cdr:to>
      <cdr:x>0.56096</cdr:x>
      <cdr:y>0.7952</cdr:y>
    </cdr:to>
    <cdr:cxnSp macro="">
      <cdr:nvCxnSpPr>
        <cdr:cNvPr id="9" name="直接连接符 8"/>
        <cdr:cNvCxnSpPr/>
      </cdr:nvCxnSpPr>
      <cdr:spPr>
        <a:xfrm xmlns:a="http://schemas.openxmlformats.org/drawingml/2006/main" flipH="1">
          <a:off x="6809264" y="531337"/>
          <a:ext cx="2382" cy="2176462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33611</cdr:x>
      <cdr:y>0.15604</cdr:y>
    </cdr:from>
    <cdr:to>
      <cdr:x>0.33631</cdr:x>
      <cdr:y>0.7952</cdr:y>
    </cdr:to>
    <cdr:cxnSp macro="">
      <cdr:nvCxnSpPr>
        <cdr:cNvPr id="10" name="直接连接符 9"/>
        <cdr:cNvCxnSpPr/>
      </cdr:nvCxnSpPr>
      <cdr:spPr>
        <a:xfrm xmlns:a="http://schemas.openxmlformats.org/drawingml/2006/main" flipH="1">
          <a:off x="4081304" y="531337"/>
          <a:ext cx="2382" cy="2176462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77737</cdr:x>
      <cdr:y>0.29372</cdr:y>
    </cdr:from>
    <cdr:to>
      <cdr:x>0.79605</cdr:x>
      <cdr:y>0.39362</cdr:y>
    </cdr:to>
    <cdr:sp macro="" textlink="">
      <cdr:nvSpPr>
        <cdr:cNvPr id="12" name="闪电形 11"/>
        <cdr:cNvSpPr/>
      </cdr:nvSpPr>
      <cdr:spPr>
        <a:xfrm xmlns:a="http://schemas.openxmlformats.org/drawingml/2006/main" flipH="1">
          <a:off x="9439422" y="1000186"/>
          <a:ext cx="226842" cy="340165"/>
        </a:xfrm>
        <a:prstGeom xmlns:a="http://schemas.openxmlformats.org/drawingml/2006/main" prst="lightningBolt">
          <a:avLst/>
        </a:prstGeom>
        <a:ln xmlns:a="http://schemas.openxmlformats.org/drawingml/2006/main"/>
      </cdr:spPr>
      <cdr:style>
        <a:lnRef xmlns:a="http://schemas.openxmlformats.org/drawingml/2006/main" idx="2">
          <a:schemeClr val="dk1">
            <a:shade val="50000"/>
          </a:schemeClr>
        </a:lnRef>
        <a:fillRef xmlns:a="http://schemas.openxmlformats.org/drawingml/2006/main" idx="1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zh-CN"/>
        </a:p>
      </cdr:txBody>
    </cdr:sp>
  </cdr:relSizeAnchor>
  <cdr:relSizeAnchor xmlns:cdr="http://schemas.openxmlformats.org/drawingml/2006/chartDrawing">
    <cdr:from>
      <cdr:x>0.10668</cdr:x>
      <cdr:y>0.01142</cdr:y>
    </cdr:from>
    <cdr:to>
      <cdr:x>0.24788</cdr:x>
      <cdr:y>0.16807</cdr:y>
    </cdr:to>
    <cdr:sp macro="" textlink="">
      <cdr:nvSpPr>
        <cdr:cNvPr id="13" name="文本框 12"/>
        <cdr:cNvSpPr txBox="1"/>
      </cdr:nvSpPr>
      <cdr:spPr>
        <a:xfrm xmlns:a="http://schemas.openxmlformats.org/drawingml/2006/main">
          <a:off x="1295400" y="38894"/>
          <a:ext cx="1714500" cy="533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zh-CN" sz="1800" b="1" dirty="0"/>
            <a:t>Acquisition</a:t>
          </a:r>
          <a:endParaRPr lang="zh-CN" altLang="en-US" sz="1800" b="1" dirty="0"/>
        </a:p>
      </cdr:txBody>
    </cdr:sp>
  </cdr:relSizeAnchor>
  <cdr:relSizeAnchor xmlns:cdr="http://schemas.openxmlformats.org/drawingml/2006/chartDrawing">
    <cdr:from>
      <cdr:x>0.38907</cdr:x>
      <cdr:y>0.00769</cdr:y>
    </cdr:from>
    <cdr:to>
      <cdr:x>0.53027</cdr:x>
      <cdr:y>0.16434</cdr:y>
    </cdr:to>
    <cdr:sp macro="" textlink="">
      <cdr:nvSpPr>
        <cdr:cNvPr id="17" name="文本框 1"/>
        <cdr:cNvSpPr txBox="1"/>
      </cdr:nvSpPr>
      <cdr:spPr>
        <a:xfrm xmlns:a="http://schemas.openxmlformats.org/drawingml/2006/main">
          <a:off x="4724400" y="26194"/>
          <a:ext cx="1714500" cy="533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zh-CN" sz="1800" b="1" dirty="0"/>
            <a:t>Extinction</a:t>
          </a:r>
          <a:endParaRPr lang="zh-CN" altLang="en-US" sz="1800" b="1" dirty="0"/>
        </a:p>
      </cdr:txBody>
    </cdr:sp>
  </cdr:relSizeAnchor>
  <cdr:relSizeAnchor xmlns:cdr="http://schemas.openxmlformats.org/drawingml/2006/chartDrawing">
    <cdr:from>
      <cdr:x>0.75513</cdr:x>
      <cdr:y>0.01119</cdr:y>
    </cdr:from>
    <cdr:to>
      <cdr:x>0.89633</cdr:x>
      <cdr:y>0.16783</cdr:y>
    </cdr:to>
    <cdr:sp macro="" textlink="">
      <cdr:nvSpPr>
        <cdr:cNvPr id="18" name="文本框 1"/>
        <cdr:cNvSpPr txBox="1"/>
      </cdr:nvSpPr>
      <cdr:spPr>
        <a:xfrm xmlns:a="http://schemas.openxmlformats.org/drawingml/2006/main">
          <a:off x="9169400" y="38100"/>
          <a:ext cx="1714500" cy="533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zh-CN" sz="1800" b="1" dirty="0"/>
            <a:t>Test</a:t>
          </a:r>
          <a:endParaRPr lang="zh-CN" altLang="en-US" sz="1800" b="1" dirty="0"/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26147</cdr:x>
      <cdr:y>0.01142</cdr:y>
    </cdr:from>
    <cdr:to>
      <cdr:x>0.40267</cdr:x>
      <cdr:y>0.16807</cdr:y>
    </cdr:to>
    <cdr:sp macro="" textlink="">
      <cdr:nvSpPr>
        <cdr:cNvPr id="16" name="文本框 1"/>
        <cdr:cNvSpPr txBox="1"/>
      </cdr:nvSpPr>
      <cdr:spPr>
        <a:xfrm xmlns:a="http://schemas.openxmlformats.org/drawingml/2006/main">
          <a:off x="3175000" y="38894"/>
          <a:ext cx="1714500" cy="533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zh-CN" sz="1800" b="1" dirty="0"/>
            <a:t>Retrieval</a:t>
          </a:r>
          <a:endParaRPr lang="zh-CN" altLang="en-US" sz="1800" b="1" dirty="0"/>
        </a:p>
      </cdr:txBody>
    </cdr:sp>
  </cdr:relSizeAnchor>
  <cdr:relSizeAnchor xmlns:cdr="http://schemas.openxmlformats.org/drawingml/2006/chartDrawing">
    <cdr:from>
      <cdr:x>0.28612</cdr:x>
      <cdr:y>0.15455</cdr:y>
    </cdr:from>
    <cdr:to>
      <cdr:x>0.28631</cdr:x>
      <cdr:y>0.79371</cdr:y>
    </cdr:to>
    <cdr:cxnSp macro="">
      <cdr:nvCxnSpPr>
        <cdr:cNvPr id="5" name="直接连接符 4"/>
        <cdr:cNvCxnSpPr/>
      </cdr:nvCxnSpPr>
      <cdr:spPr>
        <a:xfrm xmlns:a="http://schemas.openxmlformats.org/drawingml/2006/main" flipH="1">
          <a:off x="3474244" y="526257"/>
          <a:ext cx="2382" cy="2176462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56077</cdr:x>
      <cdr:y>0.15604</cdr:y>
    </cdr:from>
    <cdr:to>
      <cdr:x>0.56096</cdr:x>
      <cdr:y>0.7952</cdr:y>
    </cdr:to>
    <cdr:cxnSp macro="">
      <cdr:nvCxnSpPr>
        <cdr:cNvPr id="9" name="直接连接符 8"/>
        <cdr:cNvCxnSpPr/>
      </cdr:nvCxnSpPr>
      <cdr:spPr>
        <a:xfrm xmlns:a="http://schemas.openxmlformats.org/drawingml/2006/main" flipH="1">
          <a:off x="6809264" y="531337"/>
          <a:ext cx="2382" cy="2176462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33611</cdr:x>
      <cdr:y>0.15604</cdr:y>
    </cdr:from>
    <cdr:to>
      <cdr:x>0.33631</cdr:x>
      <cdr:y>0.7952</cdr:y>
    </cdr:to>
    <cdr:cxnSp macro="">
      <cdr:nvCxnSpPr>
        <cdr:cNvPr id="10" name="直接连接符 9"/>
        <cdr:cNvCxnSpPr/>
      </cdr:nvCxnSpPr>
      <cdr:spPr>
        <a:xfrm xmlns:a="http://schemas.openxmlformats.org/drawingml/2006/main" flipH="1">
          <a:off x="4081304" y="531337"/>
          <a:ext cx="2382" cy="2176462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77737</cdr:x>
      <cdr:y>0.29372</cdr:y>
    </cdr:from>
    <cdr:to>
      <cdr:x>0.79605</cdr:x>
      <cdr:y>0.39362</cdr:y>
    </cdr:to>
    <cdr:sp macro="" textlink="">
      <cdr:nvSpPr>
        <cdr:cNvPr id="12" name="闪电形 11"/>
        <cdr:cNvSpPr/>
      </cdr:nvSpPr>
      <cdr:spPr>
        <a:xfrm xmlns:a="http://schemas.openxmlformats.org/drawingml/2006/main" flipH="1">
          <a:off x="9439422" y="1000186"/>
          <a:ext cx="226842" cy="340165"/>
        </a:xfrm>
        <a:prstGeom xmlns:a="http://schemas.openxmlformats.org/drawingml/2006/main" prst="lightningBolt">
          <a:avLst/>
        </a:prstGeom>
        <a:ln xmlns:a="http://schemas.openxmlformats.org/drawingml/2006/main"/>
      </cdr:spPr>
      <cdr:style>
        <a:lnRef xmlns:a="http://schemas.openxmlformats.org/drawingml/2006/main" idx="2">
          <a:schemeClr val="dk1">
            <a:shade val="50000"/>
          </a:schemeClr>
        </a:lnRef>
        <a:fillRef xmlns:a="http://schemas.openxmlformats.org/drawingml/2006/main" idx="1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zh-CN"/>
        </a:p>
      </cdr:txBody>
    </cdr:sp>
  </cdr:relSizeAnchor>
  <cdr:relSizeAnchor xmlns:cdr="http://schemas.openxmlformats.org/drawingml/2006/chartDrawing">
    <cdr:from>
      <cdr:x>0.10668</cdr:x>
      <cdr:y>0.01142</cdr:y>
    </cdr:from>
    <cdr:to>
      <cdr:x>0.24788</cdr:x>
      <cdr:y>0.16807</cdr:y>
    </cdr:to>
    <cdr:sp macro="" textlink="">
      <cdr:nvSpPr>
        <cdr:cNvPr id="13" name="文本框 12"/>
        <cdr:cNvSpPr txBox="1"/>
      </cdr:nvSpPr>
      <cdr:spPr>
        <a:xfrm xmlns:a="http://schemas.openxmlformats.org/drawingml/2006/main">
          <a:off x="1295400" y="38894"/>
          <a:ext cx="1714500" cy="533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zh-CN" sz="1800" b="1" dirty="0"/>
            <a:t>Acquisition</a:t>
          </a:r>
          <a:endParaRPr lang="zh-CN" altLang="en-US" sz="1800" b="1" dirty="0"/>
        </a:p>
      </cdr:txBody>
    </cdr:sp>
  </cdr:relSizeAnchor>
  <cdr:relSizeAnchor xmlns:cdr="http://schemas.openxmlformats.org/drawingml/2006/chartDrawing">
    <cdr:from>
      <cdr:x>0.38907</cdr:x>
      <cdr:y>0.00769</cdr:y>
    </cdr:from>
    <cdr:to>
      <cdr:x>0.53027</cdr:x>
      <cdr:y>0.16434</cdr:y>
    </cdr:to>
    <cdr:sp macro="" textlink="">
      <cdr:nvSpPr>
        <cdr:cNvPr id="17" name="文本框 1"/>
        <cdr:cNvSpPr txBox="1"/>
      </cdr:nvSpPr>
      <cdr:spPr>
        <a:xfrm xmlns:a="http://schemas.openxmlformats.org/drawingml/2006/main">
          <a:off x="4724400" y="26194"/>
          <a:ext cx="1714500" cy="533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zh-CN" sz="1800" b="1" dirty="0"/>
            <a:t>Extinction</a:t>
          </a:r>
          <a:endParaRPr lang="zh-CN" altLang="en-US" sz="1800" b="1" dirty="0"/>
        </a:p>
      </cdr:txBody>
    </cdr:sp>
  </cdr:relSizeAnchor>
  <cdr:relSizeAnchor xmlns:cdr="http://schemas.openxmlformats.org/drawingml/2006/chartDrawing">
    <cdr:from>
      <cdr:x>0.75513</cdr:x>
      <cdr:y>0.01119</cdr:y>
    </cdr:from>
    <cdr:to>
      <cdr:x>0.89633</cdr:x>
      <cdr:y>0.16783</cdr:y>
    </cdr:to>
    <cdr:sp macro="" textlink="">
      <cdr:nvSpPr>
        <cdr:cNvPr id="18" name="文本框 1"/>
        <cdr:cNvSpPr txBox="1"/>
      </cdr:nvSpPr>
      <cdr:spPr>
        <a:xfrm xmlns:a="http://schemas.openxmlformats.org/drawingml/2006/main">
          <a:off x="9169400" y="38100"/>
          <a:ext cx="1714500" cy="533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zh-CN" sz="1800" b="1" dirty="0"/>
            <a:t>Test</a:t>
          </a:r>
          <a:endParaRPr lang="zh-CN" altLang="en-US" sz="1800" b="1" dirty="0"/>
        </a:p>
      </cdr:txBody>
    </cdr:sp>
  </cdr:relSizeAnchor>
</c:userShapes>
</file>

<file path=ppt/drawings/drawing5.xml><?xml version="1.0" encoding="utf-8"?>
<c:userShapes xmlns:c="http://schemas.openxmlformats.org/drawingml/2006/chart">
  <cdr:relSizeAnchor xmlns:cdr="http://schemas.openxmlformats.org/drawingml/2006/chartDrawing">
    <cdr:from>
      <cdr:x>0.17111</cdr:x>
      <cdr:y>0.29041</cdr:y>
    </cdr:from>
    <cdr:to>
      <cdr:x>0.26367</cdr:x>
      <cdr:y>0.32055</cdr:y>
    </cdr:to>
    <cdr:sp macro="" textlink="">
      <cdr:nvSpPr>
        <cdr:cNvPr id="4" name="左中括号 3"/>
        <cdr:cNvSpPr/>
      </cdr:nvSpPr>
      <cdr:spPr>
        <a:xfrm xmlns:a="http://schemas.openxmlformats.org/drawingml/2006/main" rot="5400000">
          <a:off x="2103118" y="1104317"/>
          <a:ext cx="154746" cy="928468"/>
        </a:xfrm>
        <a:prstGeom xmlns:a="http://schemas.openxmlformats.org/drawingml/2006/main" prst="leftBracket">
          <a:avLst/>
        </a:prstGeom>
        <a:ln xmlns:a="http://schemas.openxmlformats.org/drawingml/2006/main" w="22225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zh-CN"/>
        </a:p>
      </cdr:txBody>
    </cdr:sp>
  </cdr:relSizeAnchor>
  <cdr:relSizeAnchor xmlns:cdr="http://schemas.openxmlformats.org/drawingml/2006/chartDrawing">
    <cdr:from>
      <cdr:x>0.20337</cdr:x>
      <cdr:y>0.22192</cdr:y>
    </cdr:from>
    <cdr:to>
      <cdr:x>0.25386</cdr:x>
      <cdr:y>0.29041</cdr:y>
    </cdr:to>
    <cdr:sp macro="" textlink="">
      <cdr:nvSpPr>
        <cdr:cNvPr id="5" name="文本框 4"/>
        <cdr:cNvSpPr txBox="1"/>
      </cdr:nvSpPr>
      <cdr:spPr>
        <a:xfrm xmlns:a="http://schemas.openxmlformats.org/drawingml/2006/main">
          <a:off x="2039815" y="1139483"/>
          <a:ext cx="506437" cy="35169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zh-CN" sz="1800" dirty="0"/>
            <a:t>*</a:t>
          </a:r>
          <a:endParaRPr lang="zh-CN" altLang="en-US" sz="1800" dirty="0"/>
        </a:p>
      </cdr:txBody>
    </cdr:sp>
  </cdr:relSizeAnchor>
  <cdr:relSizeAnchor xmlns:cdr="http://schemas.openxmlformats.org/drawingml/2006/chartDrawing">
    <cdr:from>
      <cdr:x>0.77325</cdr:x>
      <cdr:y>0.2851</cdr:y>
    </cdr:from>
    <cdr:to>
      <cdr:x>0.86582</cdr:x>
      <cdr:y>0.31524</cdr:y>
    </cdr:to>
    <cdr:sp macro="" textlink="">
      <cdr:nvSpPr>
        <cdr:cNvPr id="6" name="左中括号 5"/>
        <cdr:cNvSpPr/>
      </cdr:nvSpPr>
      <cdr:spPr>
        <a:xfrm xmlns:a="http://schemas.openxmlformats.org/drawingml/2006/main" rot="5400000">
          <a:off x="8175419" y="1066003"/>
          <a:ext cx="153835" cy="932132"/>
        </a:xfrm>
        <a:prstGeom xmlns:a="http://schemas.openxmlformats.org/drawingml/2006/main" prst="leftBracket">
          <a:avLst/>
        </a:prstGeom>
        <a:ln xmlns:a="http://schemas.openxmlformats.org/drawingml/2006/main" w="22225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zh-CN"/>
        </a:p>
      </cdr:txBody>
    </cdr:sp>
  </cdr:relSizeAnchor>
  <cdr:relSizeAnchor xmlns:cdr="http://schemas.openxmlformats.org/drawingml/2006/chartDrawing">
    <cdr:from>
      <cdr:x>0.80271</cdr:x>
      <cdr:y>0.21661</cdr:y>
    </cdr:from>
    <cdr:to>
      <cdr:x>0.8532</cdr:x>
      <cdr:y>0.2851</cdr:y>
    </cdr:to>
    <cdr:sp macro="" textlink="">
      <cdr:nvSpPr>
        <cdr:cNvPr id="7" name="文本框 2"/>
        <cdr:cNvSpPr txBox="1"/>
      </cdr:nvSpPr>
      <cdr:spPr>
        <a:xfrm xmlns:a="http://schemas.openxmlformats.org/drawingml/2006/main">
          <a:off x="8082918" y="1105577"/>
          <a:ext cx="508408" cy="34957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zh-CN" sz="1800" dirty="0"/>
            <a:t>*</a:t>
          </a:r>
          <a:endParaRPr lang="zh-CN" altLang="en-US" sz="1800" dirty="0"/>
        </a:p>
      </cdr:txBody>
    </cdr:sp>
  </cdr:relSizeAnchor>
  <cdr:relSizeAnchor xmlns:cdr="http://schemas.openxmlformats.org/drawingml/2006/chartDrawing">
    <cdr:from>
      <cdr:x>0.3719</cdr:x>
      <cdr:y>0.28861</cdr:y>
    </cdr:from>
    <cdr:to>
      <cdr:x>0.46447</cdr:x>
      <cdr:y>0.31874</cdr:y>
    </cdr:to>
    <cdr:sp macro="" textlink="">
      <cdr:nvSpPr>
        <cdr:cNvPr id="8" name="左中括号 7"/>
        <cdr:cNvSpPr/>
      </cdr:nvSpPr>
      <cdr:spPr>
        <a:xfrm xmlns:a="http://schemas.openxmlformats.org/drawingml/2006/main" rot="5400000">
          <a:off x="4134017" y="1083876"/>
          <a:ext cx="153784" cy="932132"/>
        </a:xfrm>
        <a:prstGeom xmlns:a="http://schemas.openxmlformats.org/drawingml/2006/main" prst="leftBracket">
          <a:avLst/>
        </a:prstGeom>
        <a:ln xmlns:a="http://schemas.openxmlformats.org/drawingml/2006/main" w="22225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zh-CN"/>
        </a:p>
      </cdr:txBody>
    </cdr:sp>
  </cdr:relSizeAnchor>
  <cdr:relSizeAnchor xmlns:cdr="http://schemas.openxmlformats.org/drawingml/2006/chartDrawing">
    <cdr:from>
      <cdr:x>0.40136</cdr:x>
      <cdr:y>0.21737</cdr:y>
    </cdr:from>
    <cdr:to>
      <cdr:x>0.45185</cdr:x>
      <cdr:y>0.28587</cdr:y>
    </cdr:to>
    <cdr:sp macro="" textlink="">
      <cdr:nvSpPr>
        <cdr:cNvPr id="9" name="文本框 2"/>
        <cdr:cNvSpPr txBox="1"/>
      </cdr:nvSpPr>
      <cdr:spPr>
        <a:xfrm xmlns:a="http://schemas.openxmlformats.org/drawingml/2006/main">
          <a:off x="4041490" y="1109440"/>
          <a:ext cx="508408" cy="3496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zh-CN" sz="1800" dirty="0"/>
            <a:t>*</a:t>
          </a:r>
          <a:endParaRPr lang="zh-CN" altLang="en-US" sz="1800" dirty="0"/>
        </a:p>
      </cdr:txBody>
    </cdr:sp>
  </cdr:relSizeAnchor>
</c:userShapes>
</file>

<file path=ppt/drawings/drawing6.xml><?xml version="1.0" encoding="utf-8"?>
<c:userShapes xmlns:c="http://schemas.openxmlformats.org/drawingml/2006/chart">
  <cdr:relSizeAnchor xmlns:cdr="http://schemas.openxmlformats.org/drawingml/2006/chartDrawing">
    <cdr:from>
      <cdr:x>0.17111</cdr:x>
      <cdr:y>0.29041</cdr:y>
    </cdr:from>
    <cdr:to>
      <cdr:x>0.26367</cdr:x>
      <cdr:y>0.32055</cdr:y>
    </cdr:to>
    <cdr:sp macro="" textlink="">
      <cdr:nvSpPr>
        <cdr:cNvPr id="4" name="左中括号 3"/>
        <cdr:cNvSpPr/>
      </cdr:nvSpPr>
      <cdr:spPr>
        <a:xfrm xmlns:a="http://schemas.openxmlformats.org/drawingml/2006/main" rot="5400000">
          <a:off x="2103118" y="1104317"/>
          <a:ext cx="154746" cy="928468"/>
        </a:xfrm>
        <a:prstGeom xmlns:a="http://schemas.openxmlformats.org/drawingml/2006/main" prst="leftBracket">
          <a:avLst/>
        </a:prstGeom>
        <a:ln xmlns:a="http://schemas.openxmlformats.org/drawingml/2006/main" w="22225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zh-CN"/>
        </a:p>
      </cdr:txBody>
    </cdr:sp>
  </cdr:relSizeAnchor>
  <cdr:relSizeAnchor xmlns:cdr="http://schemas.openxmlformats.org/drawingml/2006/chartDrawing">
    <cdr:from>
      <cdr:x>0.20337</cdr:x>
      <cdr:y>0.22192</cdr:y>
    </cdr:from>
    <cdr:to>
      <cdr:x>0.25386</cdr:x>
      <cdr:y>0.29041</cdr:y>
    </cdr:to>
    <cdr:sp macro="" textlink="">
      <cdr:nvSpPr>
        <cdr:cNvPr id="5" name="文本框 4"/>
        <cdr:cNvSpPr txBox="1"/>
      </cdr:nvSpPr>
      <cdr:spPr>
        <a:xfrm xmlns:a="http://schemas.openxmlformats.org/drawingml/2006/main">
          <a:off x="2039815" y="1139483"/>
          <a:ext cx="506437" cy="35169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zh-CN" sz="1800" dirty="0"/>
            <a:t>*</a:t>
          </a:r>
          <a:endParaRPr lang="zh-CN" altLang="en-US" sz="1800" dirty="0"/>
        </a:p>
      </cdr:txBody>
    </cdr:sp>
  </cdr:relSizeAnchor>
  <cdr:relSizeAnchor xmlns:cdr="http://schemas.openxmlformats.org/drawingml/2006/chartDrawing">
    <cdr:from>
      <cdr:x>0.36595</cdr:x>
      <cdr:y>0.28788</cdr:y>
    </cdr:from>
    <cdr:to>
      <cdr:x>0.45852</cdr:x>
      <cdr:y>0.31802</cdr:y>
    </cdr:to>
    <cdr:sp macro="" textlink="">
      <cdr:nvSpPr>
        <cdr:cNvPr id="6" name="左中括号 5"/>
        <cdr:cNvSpPr/>
      </cdr:nvSpPr>
      <cdr:spPr>
        <a:xfrm xmlns:a="http://schemas.openxmlformats.org/drawingml/2006/main" rot="5400000">
          <a:off x="3670376" y="1067114"/>
          <a:ext cx="147989" cy="840817"/>
        </a:xfrm>
        <a:prstGeom xmlns:a="http://schemas.openxmlformats.org/drawingml/2006/main" prst="leftBracket">
          <a:avLst/>
        </a:prstGeom>
        <a:ln xmlns:a="http://schemas.openxmlformats.org/drawingml/2006/main" w="22225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zh-CN"/>
        </a:p>
      </cdr:txBody>
    </cdr:sp>
  </cdr:relSizeAnchor>
  <cdr:relSizeAnchor xmlns:cdr="http://schemas.openxmlformats.org/drawingml/2006/chartDrawing">
    <cdr:from>
      <cdr:x>0.39541</cdr:x>
      <cdr:y>0.21939</cdr:y>
    </cdr:from>
    <cdr:to>
      <cdr:x>0.4459</cdr:x>
      <cdr:y>0.28788</cdr:y>
    </cdr:to>
    <cdr:sp macro="" textlink="">
      <cdr:nvSpPr>
        <cdr:cNvPr id="7" name="文本框 2"/>
        <cdr:cNvSpPr txBox="1"/>
      </cdr:nvSpPr>
      <cdr:spPr>
        <a:xfrm xmlns:a="http://schemas.openxmlformats.org/drawingml/2006/main">
          <a:off x="3591549" y="1077239"/>
          <a:ext cx="458602" cy="33628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zh-CN" sz="1800" dirty="0"/>
            <a:t>*</a:t>
          </a:r>
          <a:endParaRPr lang="zh-CN" altLang="en-US" sz="1800" dirty="0"/>
        </a:p>
      </cdr:txBody>
    </cdr:sp>
  </cdr:relSizeAnchor>
</c:userShapes>
</file>

<file path=ppt/drawings/drawing7.xml><?xml version="1.0" encoding="utf-8"?>
<c:userShapes xmlns:c="http://schemas.openxmlformats.org/drawingml/2006/chart">
  <cdr:relSizeAnchor xmlns:cdr="http://schemas.openxmlformats.org/drawingml/2006/chartDrawing">
    <cdr:from>
      <cdr:x>0.82773</cdr:x>
      <cdr:y>0.23141</cdr:y>
    </cdr:from>
    <cdr:to>
      <cdr:x>0.87182</cdr:x>
      <cdr:y>0.3089</cdr:y>
    </cdr:to>
    <cdr:sp macro="" textlink="">
      <cdr:nvSpPr>
        <cdr:cNvPr id="2" name="文本框 1"/>
        <cdr:cNvSpPr txBox="1"/>
      </cdr:nvSpPr>
      <cdr:spPr>
        <a:xfrm xmlns:a="http://schemas.openxmlformats.org/drawingml/2006/main">
          <a:off x="10091652" y="1224742"/>
          <a:ext cx="537556" cy="41009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pPr algn="ctr" rtl="0"/>
          <a:r>
            <a:rPr lang="en-US" altLang="zh-CN" sz="1800" dirty="0"/>
            <a:t>*</a:t>
          </a:r>
        </a:p>
        <a:p xmlns:a="http://schemas.openxmlformats.org/drawingml/2006/main">
          <a:endParaRPr lang="zh-CN" altLang="en-US" sz="1100" dirty="0"/>
        </a:p>
      </cdr:txBody>
    </cdr:sp>
  </cdr:relSizeAnchor>
  <cdr:relSizeAnchor xmlns:cdr="http://schemas.openxmlformats.org/drawingml/2006/chartDrawing">
    <cdr:from>
      <cdr:x>0.61235</cdr:x>
      <cdr:y>0.18237</cdr:y>
    </cdr:from>
    <cdr:to>
      <cdr:x>0.65644</cdr:x>
      <cdr:y>0.25986</cdr:y>
    </cdr:to>
    <cdr:sp macro="" textlink="">
      <cdr:nvSpPr>
        <cdr:cNvPr id="3" name="文本框 1"/>
        <cdr:cNvSpPr txBox="1"/>
      </cdr:nvSpPr>
      <cdr:spPr>
        <a:xfrm xmlns:a="http://schemas.openxmlformats.org/drawingml/2006/main">
          <a:off x="7465753" y="965200"/>
          <a:ext cx="537556" cy="41009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 rtl="0"/>
          <a:r>
            <a:rPr lang="en-US" altLang="zh-CN" sz="1800" dirty="0"/>
            <a:t>*</a:t>
          </a:r>
        </a:p>
        <a:p xmlns:a="http://schemas.openxmlformats.org/drawingml/2006/main">
          <a:endParaRPr lang="zh-CN" altLang="en-US" sz="1100" dirty="0"/>
        </a:p>
      </cdr:txBody>
    </cdr:sp>
  </cdr:relSizeAnchor>
  <cdr:relSizeAnchor xmlns:cdr="http://schemas.openxmlformats.org/drawingml/2006/chartDrawing">
    <cdr:from>
      <cdr:x>0.69777</cdr:x>
      <cdr:y>0.1838</cdr:y>
    </cdr:from>
    <cdr:to>
      <cdr:x>0.74186</cdr:x>
      <cdr:y>0.26129</cdr:y>
    </cdr:to>
    <cdr:sp macro="" textlink="">
      <cdr:nvSpPr>
        <cdr:cNvPr id="4" name="文本框 1"/>
        <cdr:cNvSpPr txBox="1"/>
      </cdr:nvSpPr>
      <cdr:spPr>
        <a:xfrm xmlns:a="http://schemas.openxmlformats.org/drawingml/2006/main">
          <a:off x="8507224" y="972741"/>
          <a:ext cx="537556" cy="41009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 rtl="0"/>
          <a:r>
            <a:rPr lang="en-US" altLang="zh-CN" sz="1800" dirty="0"/>
            <a:t>*</a:t>
          </a:r>
        </a:p>
        <a:p xmlns:a="http://schemas.openxmlformats.org/drawingml/2006/main">
          <a:endParaRPr lang="zh-CN" altLang="en-US" sz="1100" dirty="0"/>
        </a:p>
      </cdr:txBody>
    </cdr:sp>
  </cdr:relSizeAnchor>
  <cdr:relSizeAnchor xmlns:cdr="http://schemas.openxmlformats.org/drawingml/2006/chartDrawing">
    <cdr:from>
      <cdr:x>0.13789</cdr:x>
      <cdr:y>0.28426</cdr:y>
    </cdr:from>
    <cdr:to>
      <cdr:x>0.18198</cdr:x>
      <cdr:y>0.36175</cdr:y>
    </cdr:to>
    <cdr:sp macro="" textlink="">
      <cdr:nvSpPr>
        <cdr:cNvPr id="5" name="文本框 1"/>
        <cdr:cNvSpPr txBox="1"/>
      </cdr:nvSpPr>
      <cdr:spPr>
        <a:xfrm xmlns:a="http://schemas.openxmlformats.org/drawingml/2006/main">
          <a:off x="1681185" y="1504437"/>
          <a:ext cx="537556" cy="41009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 rtl="0"/>
          <a:r>
            <a:rPr lang="en-US" altLang="zh-CN" sz="1800" dirty="0"/>
            <a:t>*</a:t>
          </a:r>
        </a:p>
        <a:p xmlns:a="http://schemas.openxmlformats.org/drawingml/2006/main">
          <a:endParaRPr lang="zh-CN" altLang="en-US" sz="1100" dirty="0"/>
        </a:p>
      </cdr:txBody>
    </cdr:sp>
  </cdr:relSizeAnchor>
  <cdr:relSizeAnchor xmlns:cdr="http://schemas.openxmlformats.org/drawingml/2006/chartDrawing">
    <cdr:from>
      <cdr:x>0.56813</cdr:x>
      <cdr:y>0.18392</cdr:y>
    </cdr:from>
    <cdr:to>
      <cdr:x>0.61223</cdr:x>
      <cdr:y>0.26141</cdr:y>
    </cdr:to>
    <cdr:sp macro="" textlink="">
      <cdr:nvSpPr>
        <cdr:cNvPr id="6" name="文本框 1"/>
        <cdr:cNvSpPr txBox="1"/>
      </cdr:nvSpPr>
      <cdr:spPr>
        <a:xfrm xmlns:a="http://schemas.openxmlformats.org/drawingml/2006/main">
          <a:off x="6926696" y="973397"/>
          <a:ext cx="537556" cy="41009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 rtl="0"/>
          <a:r>
            <a:rPr lang="en-US" altLang="zh-CN" sz="1800" dirty="0"/>
            <a:t>*</a:t>
          </a:r>
        </a:p>
        <a:p xmlns:a="http://schemas.openxmlformats.org/drawingml/2006/main">
          <a:endParaRPr lang="zh-CN" altLang="en-US" sz="1100" dirty="0"/>
        </a:p>
      </cdr:txBody>
    </cdr:sp>
  </cdr:relSizeAnchor>
  <cdr:relSizeAnchor xmlns:cdr="http://schemas.openxmlformats.org/drawingml/2006/chartDrawing">
    <cdr:from>
      <cdr:x>0.78468</cdr:x>
      <cdr:y>0.23168</cdr:y>
    </cdr:from>
    <cdr:to>
      <cdr:x>0.82877</cdr:x>
      <cdr:y>0.30916</cdr:y>
    </cdr:to>
    <cdr:sp macro="" textlink="">
      <cdr:nvSpPr>
        <cdr:cNvPr id="7" name="文本框 1"/>
        <cdr:cNvSpPr txBox="1"/>
      </cdr:nvSpPr>
      <cdr:spPr>
        <a:xfrm xmlns:a="http://schemas.openxmlformats.org/drawingml/2006/main">
          <a:off x="9566854" y="1226141"/>
          <a:ext cx="537556" cy="41009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 rtl="0"/>
          <a:r>
            <a:rPr lang="en-US" altLang="zh-CN" sz="1800" dirty="0"/>
            <a:t>*</a:t>
          </a:r>
        </a:p>
        <a:p xmlns:a="http://schemas.openxmlformats.org/drawingml/2006/main">
          <a:endParaRPr lang="zh-CN" altLang="en-US" sz="1100" dirty="0"/>
        </a:p>
      </cdr:txBody>
    </cdr:sp>
  </cdr:relSizeAnchor>
  <cdr:relSizeAnchor xmlns:cdr="http://schemas.openxmlformats.org/drawingml/2006/chartDrawing">
    <cdr:from>
      <cdr:x>0.26525</cdr:x>
      <cdr:y>0.28206</cdr:y>
    </cdr:from>
    <cdr:to>
      <cdr:x>0.30934</cdr:x>
      <cdr:y>0.35954</cdr:y>
    </cdr:to>
    <cdr:sp macro="" textlink="">
      <cdr:nvSpPr>
        <cdr:cNvPr id="8" name="文本框 1"/>
        <cdr:cNvSpPr txBox="1"/>
      </cdr:nvSpPr>
      <cdr:spPr>
        <a:xfrm xmlns:a="http://schemas.openxmlformats.org/drawingml/2006/main">
          <a:off x="3233892" y="1492763"/>
          <a:ext cx="537556" cy="41009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 rtl="0"/>
          <a:r>
            <a:rPr lang="en-US" altLang="zh-CN" sz="1800" dirty="0"/>
            <a:t>*</a:t>
          </a:r>
        </a:p>
        <a:p xmlns:a="http://schemas.openxmlformats.org/drawingml/2006/main">
          <a:endParaRPr lang="zh-CN" altLang="en-US" sz="1100" dirty="0"/>
        </a:p>
      </cdr:txBody>
    </cdr:sp>
  </cdr:relSizeAnchor>
  <cdr:relSizeAnchor xmlns:cdr="http://schemas.openxmlformats.org/drawingml/2006/chartDrawing">
    <cdr:from>
      <cdr:x>0.22442</cdr:x>
      <cdr:y>0.28279</cdr:y>
    </cdr:from>
    <cdr:to>
      <cdr:x>0.26851</cdr:x>
      <cdr:y>0.36028</cdr:y>
    </cdr:to>
    <cdr:sp macro="" textlink="">
      <cdr:nvSpPr>
        <cdr:cNvPr id="9" name="文本框 1"/>
        <cdr:cNvSpPr txBox="1"/>
      </cdr:nvSpPr>
      <cdr:spPr>
        <a:xfrm xmlns:a="http://schemas.openxmlformats.org/drawingml/2006/main">
          <a:off x="2736107" y="1496643"/>
          <a:ext cx="537556" cy="41009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 rtl="0"/>
          <a:r>
            <a:rPr lang="en-US" altLang="zh-CN" sz="1800" dirty="0"/>
            <a:t>*</a:t>
          </a:r>
        </a:p>
        <a:p xmlns:a="http://schemas.openxmlformats.org/drawingml/2006/main">
          <a:endParaRPr lang="zh-CN" altLang="en-US" sz="1100" dirty="0"/>
        </a:p>
      </cdr:txBody>
    </cdr:sp>
  </cdr:relSizeAnchor>
  <cdr:relSizeAnchor xmlns:cdr="http://schemas.openxmlformats.org/drawingml/2006/chartDrawing">
    <cdr:from>
      <cdr:x>0.1814</cdr:x>
      <cdr:y>0.28206</cdr:y>
    </cdr:from>
    <cdr:to>
      <cdr:x>0.22549</cdr:x>
      <cdr:y>0.35954</cdr:y>
    </cdr:to>
    <cdr:sp macro="" textlink="">
      <cdr:nvSpPr>
        <cdr:cNvPr id="10" name="文本框 1"/>
        <cdr:cNvSpPr txBox="1"/>
      </cdr:nvSpPr>
      <cdr:spPr>
        <a:xfrm xmlns:a="http://schemas.openxmlformats.org/drawingml/2006/main">
          <a:off x="2211581" y="1492763"/>
          <a:ext cx="537556" cy="41009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 rtl="0"/>
          <a:r>
            <a:rPr lang="en-US" altLang="zh-CN" sz="1800" dirty="0"/>
            <a:t>*</a:t>
          </a:r>
        </a:p>
        <a:p xmlns:a="http://schemas.openxmlformats.org/drawingml/2006/main">
          <a:endParaRPr lang="zh-CN" altLang="en-US" sz="1100" dirty="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703D1-BF31-4E89-A71A-080C8ADA8B72}" type="datetimeFigureOut">
              <a:rPr lang="zh-CN" altLang="en-US" smtClean="0"/>
              <a:t>2017/11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C811A2-7CE7-4AA9-AC6E-20C7F2243DF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389801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703D1-BF31-4E89-A71A-080C8ADA8B72}" type="datetimeFigureOut">
              <a:rPr lang="zh-CN" altLang="en-US" smtClean="0"/>
              <a:t>2017/11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C811A2-7CE7-4AA9-AC6E-20C7F2243DF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329839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703D1-BF31-4E89-A71A-080C8ADA8B72}" type="datetimeFigureOut">
              <a:rPr lang="zh-CN" altLang="en-US" smtClean="0"/>
              <a:t>2017/11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C811A2-7CE7-4AA9-AC6E-20C7F2243DF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488268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703D1-BF31-4E89-A71A-080C8ADA8B72}" type="datetimeFigureOut">
              <a:rPr lang="zh-CN" altLang="en-US" smtClean="0"/>
              <a:t>2017/11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C811A2-7CE7-4AA9-AC6E-20C7F2243DF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27566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703D1-BF31-4E89-A71A-080C8ADA8B72}" type="datetimeFigureOut">
              <a:rPr lang="zh-CN" altLang="en-US" smtClean="0"/>
              <a:t>2017/11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C811A2-7CE7-4AA9-AC6E-20C7F2243DF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07955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703D1-BF31-4E89-A71A-080C8ADA8B72}" type="datetimeFigureOut">
              <a:rPr lang="zh-CN" altLang="en-US" smtClean="0"/>
              <a:t>2017/11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C811A2-7CE7-4AA9-AC6E-20C7F2243DF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688695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703D1-BF31-4E89-A71A-080C8ADA8B72}" type="datetimeFigureOut">
              <a:rPr lang="zh-CN" altLang="en-US" smtClean="0"/>
              <a:t>2017/11/2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C811A2-7CE7-4AA9-AC6E-20C7F2243DF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55415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703D1-BF31-4E89-A71A-080C8ADA8B72}" type="datetimeFigureOut">
              <a:rPr lang="zh-CN" altLang="en-US" smtClean="0"/>
              <a:t>2017/11/2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C811A2-7CE7-4AA9-AC6E-20C7F2243DF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362710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703D1-BF31-4E89-A71A-080C8ADA8B72}" type="datetimeFigureOut">
              <a:rPr lang="zh-CN" altLang="en-US" smtClean="0"/>
              <a:t>2017/11/2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C811A2-7CE7-4AA9-AC6E-20C7F2243DF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87282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703D1-BF31-4E89-A71A-080C8ADA8B72}" type="datetimeFigureOut">
              <a:rPr lang="zh-CN" altLang="en-US" smtClean="0"/>
              <a:t>2017/11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C811A2-7CE7-4AA9-AC6E-20C7F2243DF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058588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703D1-BF31-4E89-A71A-080C8ADA8B72}" type="datetimeFigureOut">
              <a:rPr lang="zh-CN" altLang="en-US" smtClean="0"/>
              <a:t>2017/11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C811A2-7CE7-4AA9-AC6E-20C7F2243DF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723204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A703D1-BF31-4E89-A71A-080C8ADA8B72}" type="datetimeFigureOut">
              <a:rPr lang="zh-CN" altLang="en-US" smtClean="0"/>
              <a:t>2017/11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C811A2-7CE7-4AA9-AC6E-20C7F2243DF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85882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chart" Target="../charts/chart6.xml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6.emf"/><Relationship Id="rId18" Type="http://schemas.openxmlformats.org/officeDocument/2006/relationships/image" Target="../media/image21.png"/><Relationship Id="rId26" Type="http://schemas.openxmlformats.org/officeDocument/2006/relationships/image" Target="../media/image29.emf"/><Relationship Id="rId39" Type="http://schemas.openxmlformats.org/officeDocument/2006/relationships/image" Target="../media/image42.emf"/><Relationship Id="rId21" Type="http://schemas.openxmlformats.org/officeDocument/2006/relationships/image" Target="../media/image24.emf"/><Relationship Id="rId34" Type="http://schemas.openxmlformats.org/officeDocument/2006/relationships/image" Target="../media/image37.emf"/><Relationship Id="rId42" Type="http://schemas.openxmlformats.org/officeDocument/2006/relationships/image" Target="../media/image45.emf"/><Relationship Id="rId47" Type="http://schemas.openxmlformats.org/officeDocument/2006/relationships/image" Target="../media/image50.emf"/><Relationship Id="rId50" Type="http://schemas.openxmlformats.org/officeDocument/2006/relationships/image" Target="../media/image53.png"/><Relationship Id="rId55" Type="http://schemas.openxmlformats.org/officeDocument/2006/relationships/image" Target="../media/image58.emf"/><Relationship Id="rId63" Type="http://schemas.openxmlformats.org/officeDocument/2006/relationships/image" Target="../media/image66.emf"/><Relationship Id="rId68" Type="http://schemas.openxmlformats.org/officeDocument/2006/relationships/image" Target="../media/image71.png"/><Relationship Id="rId76" Type="http://schemas.openxmlformats.org/officeDocument/2006/relationships/image" Target="../media/image79.emf"/><Relationship Id="rId7" Type="http://schemas.openxmlformats.org/officeDocument/2006/relationships/image" Target="../media/image10.emf"/><Relationship Id="rId71" Type="http://schemas.openxmlformats.org/officeDocument/2006/relationships/image" Target="../media/image74.emf"/><Relationship Id="rId2" Type="http://schemas.openxmlformats.org/officeDocument/2006/relationships/image" Target="../media/image5.png"/><Relationship Id="rId16" Type="http://schemas.openxmlformats.org/officeDocument/2006/relationships/image" Target="../media/image19.emf"/><Relationship Id="rId29" Type="http://schemas.openxmlformats.org/officeDocument/2006/relationships/image" Target="../media/image32.emf"/><Relationship Id="rId11" Type="http://schemas.openxmlformats.org/officeDocument/2006/relationships/image" Target="../media/image14.png"/><Relationship Id="rId24" Type="http://schemas.openxmlformats.org/officeDocument/2006/relationships/image" Target="../media/image27.emf"/><Relationship Id="rId32" Type="http://schemas.openxmlformats.org/officeDocument/2006/relationships/image" Target="../media/image35.emf"/><Relationship Id="rId37" Type="http://schemas.openxmlformats.org/officeDocument/2006/relationships/image" Target="../media/image40.emf"/><Relationship Id="rId40" Type="http://schemas.openxmlformats.org/officeDocument/2006/relationships/image" Target="../media/image43.emf"/><Relationship Id="rId45" Type="http://schemas.openxmlformats.org/officeDocument/2006/relationships/image" Target="../media/image48.emf"/><Relationship Id="rId53" Type="http://schemas.openxmlformats.org/officeDocument/2006/relationships/image" Target="../media/image56.emf"/><Relationship Id="rId58" Type="http://schemas.openxmlformats.org/officeDocument/2006/relationships/image" Target="../media/image61.emf"/><Relationship Id="rId66" Type="http://schemas.openxmlformats.org/officeDocument/2006/relationships/image" Target="../media/image69.emf"/><Relationship Id="rId74" Type="http://schemas.openxmlformats.org/officeDocument/2006/relationships/image" Target="../media/image77.emf"/><Relationship Id="rId79" Type="http://schemas.openxmlformats.org/officeDocument/2006/relationships/image" Target="../media/image82.emf"/><Relationship Id="rId5" Type="http://schemas.openxmlformats.org/officeDocument/2006/relationships/image" Target="../media/image8.emf"/><Relationship Id="rId61" Type="http://schemas.openxmlformats.org/officeDocument/2006/relationships/image" Target="../media/image64.emf"/><Relationship Id="rId82" Type="http://schemas.openxmlformats.org/officeDocument/2006/relationships/image" Target="../media/image85.emf"/><Relationship Id="rId10" Type="http://schemas.openxmlformats.org/officeDocument/2006/relationships/image" Target="../media/image13.png"/><Relationship Id="rId19" Type="http://schemas.openxmlformats.org/officeDocument/2006/relationships/image" Target="../media/image22.png"/><Relationship Id="rId31" Type="http://schemas.openxmlformats.org/officeDocument/2006/relationships/image" Target="../media/image34.emf"/><Relationship Id="rId44" Type="http://schemas.openxmlformats.org/officeDocument/2006/relationships/image" Target="../media/image47.emf"/><Relationship Id="rId52" Type="http://schemas.openxmlformats.org/officeDocument/2006/relationships/image" Target="../media/image55.emf"/><Relationship Id="rId60" Type="http://schemas.openxmlformats.org/officeDocument/2006/relationships/image" Target="../media/image63.emf"/><Relationship Id="rId65" Type="http://schemas.openxmlformats.org/officeDocument/2006/relationships/image" Target="../media/image68.emf"/><Relationship Id="rId73" Type="http://schemas.openxmlformats.org/officeDocument/2006/relationships/image" Target="../media/image76.emf"/><Relationship Id="rId78" Type="http://schemas.openxmlformats.org/officeDocument/2006/relationships/image" Target="../media/image81.emf"/><Relationship Id="rId81" Type="http://schemas.openxmlformats.org/officeDocument/2006/relationships/image" Target="../media/image84.emf"/><Relationship Id="rId4" Type="http://schemas.openxmlformats.org/officeDocument/2006/relationships/image" Target="../media/image7.emf"/><Relationship Id="rId9" Type="http://schemas.openxmlformats.org/officeDocument/2006/relationships/image" Target="../media/image12.png"/><Relationship Id="rId14" Type="http://schemas.openxmlformats.org/officeDocument/2006/relationships/image" Target="../media/image17.emf"/><Relationship Id="rId22" Type="http://schemas.openxmlformats.org/officeDocument/2006/relationships/image" Target="../media/image25.emf"/><Relationship Id="rId27" Type="http://schemas.openxmlformats.org/officeDocument/2006/relationships/image" Target="../media/image30.emf"/><Relationship Id="rId30" Type="http://schemas.openxmlformats.org/officeDocument/2006/relationships/image" Target="../media/image33.emf"/><Relationship Id="rId35" Type="http://schemas.openxmlformats.org/officeDocument/2006/relationships/image" Target="../media/image38.emf"/><Relationship Id="rId43" Type="http://schemas.openxmlformats.org/officeDocument/2006/relationships/image" Target="../media/image46.emf"/><Relationship Id="rId48" Type="http://schemas.openxmlformats.org/officeDocument/2006/relationships/image" Target="../media/image51.emf"/><Relationship Id="rId56" Type="http://schemas.openxmlformats.org/officeDocument/2006/relationships/image" Target="../media/image59.emf"/><Relationship Id="rId64" Type="http://schemas.openxmlformats.org/officeDocument/2006/relationships/image" Target="../media/image67.emf"/><Relationship Id="rId69" Type="http://schemas.openxmlformats.org/officeDocument/2006/relationships/image" Target="../media/image72.emf"/><Relationship Id="rId77" Type="http://schemas.openxmlformats.org/officeDocument/2006/relationships/image" Target="../media/image80.emf"/><Relationship Id="rId8" Type="http://schemas.openxmlformats.org/officeDocument/2006/relationships/image" Target="../media/image11.emf"/><Relationship Id="rId51" Type="http://schemas.openxmlformats.org/officeDocument/2006/relationships/image" Target="../media/image54.emf"/><Relationship Id="rId72" Type="http://schemas.openxmlformats.org/officeDocument/2006/relationships/image" Target="../media/image75.emf"/><Relationship Id="rId80" Type="http://schemas.openxmlformats.org/officeDocument/2006/relationships/image" Target="../media/image83.emf"/><Relationship Id="rId3" Type="http://schemas.openxmlformats.org/officeDocument/2006/relationships/image" Target="../media/image6.emf"/><Relationship Id="rId12" Type="http://schemas.openxmlformats.org/officeDocument/2006/relationships/image" Target="../media/image15.emf"/><Relationship Id="rId17" Type="http://schemas.openxmlformats.org/officeDocument/2006/relationships/image" Target="../media/image20.emf"/><Relationship Id="rId25" Type="http://schemas.openxmlformats.org/officeDocument/2006/relationships/image" Target="../media/image28.emf"/><Relationship Id="rId33" Type="http://schemas.openxmlformats.org/officeDocument/2006/relationships/image" Target="../media/image36.emf"/><Relationship Id="rId38" Type="http://schemas.openxmlformats.org/officeDocument/2006/relationships/image" Target="../media/image41.emf"/><Relationship Id="rId46" Type="http://schemas.openxmlformats.org/officeDocument/2006/relationships/image" Target="../media/image49.emf"/><Relationship Id="rId59" Type="http://schemas.openxmlformats.org/officeDocument/2006/relationships/image" Target="../media/image62.emf"/><Relationship Id="rId67" Type="http://schemas.openxmlformats.org/officeDocument/2006/relationships/image" Target="../media/image70.png"/><Relationship Id="rId20" Type="http://schemas.openxmlformats.org/officeDocument/2006/relationships/image" Target="../media/image23.emf"/><Relationship Id="rId41" Type="http://schemas.openxmlformats.org/officeDocument/2006/relationships/image" Target="../media/image44.emf"/><Relationship Id="rId54" Type="http://schemas.openxmlformats.org/officeDocument/2006/relationships/image" Target="../media/image57.emf"/><Relationship Id="rId62" Type="http://schemas.openxmlformats.org/officeDocument/2006/relationships/image" Target="../media/image65.emf"/><Relationship Id="rId70" Type="http://schemas.openxmlformats.org/officeDocument/2006/relationships/image" Target="../media/image73.emf"/><Relationship Id="rId75" Type="http://schemas.openxmlformats.org/officeDocument/2006/relationships/image" Target="../media/image78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emf"/><Relationship Id="rId15" Type="http://schemas.openxmlformats.org/officeDocument/2006/relationships/image" Target="../media/image18.emf"/><Relationship Id="rId23" Type="http://schemas.openxmlformats.org/officeDocument/2006/relationships/image" Target="../media/image26.emf"/><Relationship Id="rId28" Type="http://schemas.openxmlformats.org/officeDocument/2006/relationships/image" Target="../media/image31.emf"/><Relationship Id="rId36" Type="http://schemas.openxmlformats.org/officeDocument/2006/relationships/image" Target="../media/image39.emf"/><Relationship Id="rId49" Type="http://schemas.openxmlformats.org/officeDocument/2006/relationships/image" Target="../media/image52.emf"/><Relationship Id="rId57" Type="http://schemas.openxmlformats.org/officeDocument/2006/relationships/image" Target="../media/image60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1"/>
          <p:cNvSpPr txBox="1">
            <a:spLocks noChangeArrowheads="1"/>
          </p:cNvSpPr>
          <p:nvPr/>
        </p:nvSpPr>
        <p:spPr bwMode="auto">
          <a:xfrm>
            <a:off x="1577975" y="1036638"/>
            <a:ext cx="2324100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14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 sz="14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 sz="14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 sz="14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 sz="14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defTabSz="6858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defTabSz="6858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defTabSz="6858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defTabSz="6858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20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2000" b="1" dirty="0">
                <a:latin typeface="Times New Roman" pitchFamily="18" charset="0"/>
                <a:cs typeface="Times New Roman" pitchFamily="18" charset="0"/>
              </a:rPr>
              <a:t>Materials </a:t>
            </a:r>
            <a:endParaRPr lang="zh-CN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22131" y="1518994"/>
            <a:ext cx="3348139" cy="1879841"/>
          </a:xfrm>
          <a:prstGeom prst="rect">
            <a:avLst/>
          </a:prstGeom>
          <a:effectLst>
            <a:softEdge rad="228600"/>
          </a:effectLst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75275" y="1518994"/>
            <a:ext cx="3340455" cy="1877051"/>
          </a:xfrm>
          <a:prstGeom prst="rect">
            <a:avLst/>
          </a:prstGeom>
          <a:effectLst>
            <a:softEdge rad="228600"/>
          </a:effectLst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24808" y="3380723"/>
            <a:ext cx="3350467" cy="1881148"/>
          </a:xfrm>
          <a:prstGeom prst="rect">
            <a:avLst/>
          </a:prstGeom>
          <a:effectLst>
            <a:softEdge rad="228600"/>
          </a:effectLst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65264" y="3396045"/>
            <a:ext cx="3350466" cy="1882676"/>
          </a:xfrm>
          <a:prstGeom prst="rect">
            <a:avLst/>
          </a:prstGeom>
          <a:effectLst>
            <a:softEdge rad="228600"/>
          </a:effectLst>
        </p:spPr>
      </p:pic>
      <p:sp>
        <p:nvSpPr>
          <p:cNvPr id="13" name="TextBox 8"/>
          <p:cNvSpPr txBox="1">
            <a:spLocks noChangeArrowheads="1"/>
          </p:cNvSpPr>
          <p:nvPr/>
        </p:nvSpPr>
        <p:spPr bwMode="auto">
          <a:xfrm>
            <a:off x="4137399" y="3072378"/>
            <a:ext cx="884238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14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 sz="14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 sz="14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 sz="14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 sz="14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defTabSz="6858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defTabSz="6858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defTabSz="6858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defTabSz="6858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 eaLnBrk="1" hangingPunct="1"/>
            <a:r>
              <a:rPr lang="en-US" altLang="zh-CN" b="1" dirty="0">
                <a:latin typeface="Times New Roman" pitchFamily="18" charset="0"/>
                <a:cs typeface="Times New Roman" pitchFamily="18" charset="0"/>
              </a:rPr>
              <a:t>CS1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TextBox 10"/>
          <p:cNvSpPr txBox="1">
            <a:spLocks noChangeArrowheads="1"/>
          </p:cNvSpPr>
          <p:nvPr/>
        </p:nvSpPr>
        <p:spPr bwMode="auto">
          <a:xfrm>
            <a:off x="7558462" y="3091428"/>
            <a:ext cx="884237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14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 sz="14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 sz="14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 sz="14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 sz="14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defTabSz="6858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defTabSz="6858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defTabSz="6858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defTabSz="6858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 eaLnBrk="1" hangingPunct="1"/>
            <a:r>
              <a:rPr lang="en-US" altLang="zh-CN" b="1">
                <a:latin typeface="Times New Roman" pitchFamily="18" charset="0"/>
                <a:cs typeface="Times New Roman" pitchFamily="18" charset="0"/>
              </a:rPr>
              <a:t>CS2</a:t>
            </a:r>
            <a:endParaRPr lang="zh-CN" altLang="en-US" b="1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" name="TextBox 11"/>
          <p:cNvSpPr txBox="1">
            <a:spLocks noChangeArrowheads="1"/>
          </p:cNvSpPr>
          <p:nvPr/>
        </p:nvSpPr>
        <p:spPr bwMode="auto">
          <a:xfrm>
            <a:off x="3956424" y="4837678"/>
            <a:ext cx="1468438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14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 sz="14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 sz="14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 sz="14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 sz="14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defTabSz="6858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defTabSz="6858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defTabSz="6858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defTabSz="6858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 eaLnBrk="1" hangingPunct="1"/>
            <a:r>
              <a:rPr lang="en-US" altLang="zh-CN" b="1" dirty="0">
                <a:latin typeface="Times New Roman" pitchFamily="18" charset="0"/>
                <a:cs typeface="Times New Roman" pitchFamily="18" charset="0"/>
              </a:rPr>
              <a:t>1/3 </a:t>
            </a:r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retrieval (example)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" name="TextBox 12"/>
          <p:cNvSpPr txBox="1">
            <a:spLocks noChangeArrowheads="1"/>
          </p:cNvSpPr>
          <p:nvPr/>
        </p:nvSpPr>
        <p:spPr bwMode="auto">
          <a:xfrm>
            <a:off x="7210799" y="4845616"/>
            <a:ext cx="1606630" cy="7386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14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 sz="14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 sz="14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 sz="14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 sz="14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defTabSz="6858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defTabSz="6858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defTabSz="6858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defTabSz="6858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algn="ctr" eaLnBrk="1" hangingPunct="1"/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2/3retrieval</a:t>
            </a:r>
          </a:p>
          <a:p>
            <a:pPr algn="ctr" eaLnBrk="1" hangingPunct="1"/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(example</a:t>
            </a:r>
            <a:r>
              <a:rPr lang="en-US" altLang="zh-CN" b="1" dirty="0">
                <a:latin typeface="Times New Roman" pitchFamily="18" charset="0"/>
                <a:cs typeface="Times New Roman" pitchFamily="18" charset="0"/>
              </a:rPr>
              <a:t>)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/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" name="矩形 6"/>
          <p:cNvSpPr>
            <a:spLocks noChangeArrowheads="1"/>
          </p:cNvSpPr>
          <p:nvPr/>
        </p:nvSpPr>
        <p:spPr bwMode="auto">
          <a:xfrm>
            <a:off x="4690643" y="5831536"/>
            <a:ext cx="3859019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Figure1 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(A)  Conditioned 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stimulus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0815556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图表 1">
            <a:extLst>
              <a:ext uri="{FF2B5EF4-FFF2-40B4-BE49-F238E27FC236}">
                <a16:creationId xmlns:a16="http://schemas.microsoft.com/office/drawing/2014/main" xmlns="" id="{00000000-0008-0000-0800-000006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2253809"/>
              </p:ext>
            </p:extLst>
          </p:nvPr>
        </p:nvGraphicFramePr>
        <p:xfrm>
          <a:off x="1634837" y="1230283"/>
          <a:ext cx="9083040" cy="49100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文本框 1"/>
          <p:cNvSpPr txBox="1"/>
          <p:nvPr/>
        </p:nvSpPr>
        <p:spPr>
          <a:xfrm>
            <a:off x="4208105" y="445284"/>
            <a:ext cx="556104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st of spontaneous reinstatement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1996751" y="5934670"/>
            <a:ext cx="827625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4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an differential skin conductance responses to the last trial of re-extinction and first trial of reinstatement in each group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* represent p&lt;0.05. Error bars represent standard errors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zh-CN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9000095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图表 1">
            <a:extLst>
              <a:ext uri="{FF2B5EF4-FFF2-40B4-BE49-F238E27FC236}">
                <a16:creationId xmlns:a16="http://schemas.microsoft.com/office/drawing/2014/main" xmlns="" id="{00000000-0008-0000-08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87819482"/>
              </p:ext>
            </p:extLst>
          </p:nvPr>
        </p:nvGraphicFramePr>
        <p:xfrm>
          <a:off x="0" y="455208"/>
          <a:ext cx="12192000" cy="52924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679511" y="5760312"/>
            <a:ext cx="1000241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5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ean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fferential skin conductance responses to CS during acquisition, reactivation, extinction, spontaneous recovery test and reinstatement test in each group.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 p&lt;0.05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etween acquisition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extinction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or between extinction and re-extinction within group).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rror bars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 standard errors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416020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矩形 6"/>
          <p:cNvSpPr>
            <a:spLocks noChangeArrowheads="1"/>
          </p:cNvSpPr>
          <p:nvPr/>
        </p:nvSpPr>
        <p:spPr bwMode="auto">
          <a:xfrm>
            <a:off x="2862842" y="5663682"/>
            <a:ext cx="8186870" cy="9233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Figure1 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(A-1)  Sequences of stimulus used as CS+ and retrieval cues. 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Colors were randomized among different conditions and six kinds of sequences were used to</a:t>
            </a:r>
          </a:p>
          <a:p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balance the color or shape that used as CS+ and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retrieval cues.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2" name="Group 4"/>
          <p:cNvGrpSpPr>
            <a:grpSpLocks noChangeAspect="1"/>
          </p:cNvGrpSpPr>
          <p:nvPr/>
        </p:nvGrpSpPr>
        <p:grpSpPr bwMode="auto">
          <a:xfrm>
            <a:off x="2257425" y="779463"/>
            <a:ext cx="7847013" cy="4884737"/>
            <a:chOff x="1422" y="491"/>
            <a:chExt cx="4943" cy="3077"/>
          </a:xfrm>
        </p:grpSpPr>
        <p:sp>
          <p:nvSpPr>
            <p:cNvPr id="3" name="AutoShape 3"/>
            <p:cNvSpPr>
              <a:spLocks noChangeAspect="1" noChangeArrowheads="1" noTextEdit="1"/>
            </p:cNvSpPr>
            <p:nvPr/>
          </p:nvSpPr>
          <p:spPr bwMode="auto">
            <a:xfrm>
              <a:off x="1422" y="491"/>
              <a:ext cx="4943" cy="30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" name="Rectangle 5"/>
            <p:cNvSpPr>
              <a:spLocks noChangeArrowheads="1"/>
            </p:cNvSpPr>
            <p:nvPr/>
          </p:nvSpPr>
          <p:spPr bwMode="auto">
            <a:xfrm>
              <a:off x="1715" y="699"/>
              <a:ext cx="654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Sequences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6" name="Rectangle 6"/>
            <p:cNvSpPr>
              <a:spLocks noChangeArrowheads="1"/>
            </p:cNvSpPr>
            <p:nvPr/>
          </p:nvSpPr>
          <p:spPr bwMode="auto">
            <a:xfrm>
              <a:off x="2282" y="699"/>
              <a:ext cx="92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7" name="Rectangle 7"/>
            <p:cNvSpPr>
              <a:spLocks noChangeArrowheads="1"/>
            </p:cNvSpPr>
            <p:nvPr/>
          </p:nvSpPr>
          <p:spPr bwMode="auto">
            <a:xfrm>
              <a:off x="2792" y="699"/>
              <a:ext cx="309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CS+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8" name="Rectangle 8"/>
            <p:cNvSpPr>
              <a:spLocks noChangeArrowheads="1"/>
            </p:cNvSpPr>
            <p:nvPr/>
          </p:nvSpPr>
          <p:spPr bwMode="auto">
            <a:xfrm>
              <a:off x="3031" y="699"/>
              <a:ext cx="92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9" name="Rectangle 9"/>
            <p:cNvSpPr>
              <a:spLocks noChangeArrowheads="1"/>
            </p:cNvSpPr>
            <p:nvPr/>
          </p:nvSpPr>
          <p:spPr bwMode="auto">
            <a:xfrm>
              <a:off x="4441" y="557"/>
              <a:ext cx="320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Retr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0" name="Rectangle 10"/>
            <p:cNvSpPr>
              <a:spLocks noChangeArrowheads="1"/>
            </p:cNvSpPr>
            <p:nvPr/>
          </p:nvSpPr>
          <p:spPr bwMode="auto">
            <a:xfrm>
              <a:off x="4692" y="557"/>
              <a:ext cx="330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ieval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1" name="Rectangle 11"/>
            <p:cNvSpPr>
              <a:spLocks noChangeArrowheads="1"/>
            </p:cNvSpPr>
            <p:nvPr/>
          </p:nvSpPr>
          <p:spPr bwMode="auto">
            <a:xfrm>
              <a:off x="4951" y="557"/>
              <a:ext cx="92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2" name="Rectangle 12"/>
            <p:cNvSpPr>
              <a:spLocks noChangeArrowheads="1"/>
            </p:cNvSpPr>
            <p:nvPr/>
          </p:nvSpPr>
          <p:spPr bwMode="auto">
            <a:xfrm>
              <a:off x="4983" y="557"/>
              <a:ext cx="254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cue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3" name="Rectangle 13"/>
            <p:cNvSpPr>
              <a:spLocks noChangeArrowheads="1"/>
            </p:cNvSpPr>
            <p:nvPr/>
          </p:nvSpPr>
          <p:spPr bwMode="auto">
            <a:xfrm>
              <a:off x="5169" y="557"/>
              <a:ext cx="92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4" name="Rectangle 14"/>
            <p:cNvSpPr>
              <a:spLocks noChangeArrowheads="1"/>
            </p:cNvSpPr>
            <p:nvPr/>
          </p:nvSpPr>
          <p:spPr bwMode="auto">
            <a:xfrm>
              <a:off x="1639" y="491"/>
              <a:ext cx="720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5" name="Rectangle 15"/>
            <p:cNvSpPr>
              <a:spLocks noChangeArrowheads="1"/>
            </p:cNvSpPr>
            <p:nvPr/>
          </p:nvSpPr>
          <p:spPr bwMode="auto">
            <a:xfrm>
              <a:off x="2359" y="491"/>
              <a:ext cx="4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6" name="Rectangle 16"/>
            <p:cNvSpPr>
              <a:spLocks noChangeArrowheads="1"/>
            </p:cNvSpPr>
            <p:nvPr/>
          </p:nvSpPr>
          <p:spPr bwMode="auto">
            <a:xfrm>
              <a:off x="2363" y="491"/>
              <a:ext cx="1102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7" name="Rectangle 17"/>
            <p:cNvSpPr>
              <a:spLocks noChangeArrowheads="1"/>
            </p:cNvSpPr>
            <p:nvPr/>
          </p:nvSpPr>
          <p:spPr bwMode="auto">
            <a:xfrm>
              <a:off x="3465" y="491"/>
              <a:ext cx="5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8" name="Rectangle 18"/>
            <p:cNvSpPr>
              <a:spLocks noChangeArrowheads="1"/>
            </p:cNvSpPr>
            <p:nvPr/>
          </p:nvSpPr>
          <p:spPr bwMode="auto">
            <a:xfrm>
              <a:off x="3470" y="491"/>
              <a:ext cx="2676" cy="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9" name="Rectangle 19"/>
            <p:cNvSpPr>
              <a:spLocks noChangeArrowheads="1"/>
            </p:cNvSpPr>
            <p:nvPr/>
          </p:nvSpPr>
          <p:spPr bwMode="auto">
            <a:xfrm>
              <a:off x="3783" y="830"/>
              <a:ext cx="763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1/3 retrieval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0" name="Rectangle 20"/>
            <p:cNvSpPr>
              <a:spLocks noChangeArrowheads="1"/>
            </p:cNvSpPr>
            <p:nvPr/>
          </p:nvSpPr>
          <p:spPr bwMode="auto">
            <a:xfrm>
              <a:off x="4454" y="830"/>
              <a:ext cx="92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1" name="Rectangle 21"/>
            <p:cNvSpPr>
              <a:spLocks noChangeArrowheads="1"/>
            </p:cNvSpPr>
            <p:nvPr/>
          </p:nvSpPr>
          <p:spPr bwMode="auto">
            <a:xfrm>
              <a:off x="5124" y="830"/>
              <a:ext cx="763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2/3 retrieval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2" name="Rectangle 22"/>
            <p:cNvSpPr>
              <a:spLocks noChangeArrowheads="1"/>
            </p:cNvSpPr>
            <p:nvPr/>
          </p:nvSpPr>
          <p:spPr bwMode="auto">
            <a:xfrm>
              <a:off x="5795" y="830"/>
              <a:ext cx="92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3" name="Rectangle 23"/>
            <p:cNvSpPr>
              <a:spLocks noChangeArrowheads="1"/>
            </p:cNvSpPr>
            <p:nvPr/>
          </p:nvSpPr>
          <p:spPr bwMode="auto">
            <a:xfrm>
              <a:off x="1967" y="1183"/>
              <a:ext cx="125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1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4" name="Rectangle 24"/>
            <p:cNvSpPr>
              <a:spLocks noChangeArrowheads="1"/>
            </p:cNvSpPr>
            <p:nvPr/>
          </p:nvSpPr>
          <p:spPr bwMode="auto">
            <a:xfrm>
              <a:off x="2031" y="1183"/>
              <a:ext cx="92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5" name="Rectangle 25"/>
            <p:cNvSpPr>
              <a:spLocks noChangeArrowheads="1"/>
            </p:cNvSpPr>
            <p:nvPr/>
          </p:nvSpPr>
          <p:spPr bwMode="auto">
            <a:xfrm>
              <a:off x="3287" y="1275"/>
              <a:ext cx="113" cy="1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400" b="1" i="0" u="none" strike="noStrike" cap="none" normalizeH="0" baseline="0" smtClean="0">
                  <a:ln>
                    <a:noFill/>
                  </a:ln>
                  <a:solidFill>
                    <a:srgbClr val="00B050"/>
                  </a:solidFill>
                  <a:effectLst/>
                  <a:latin typeface="宋体" pitchFamily="2" charset="-122"/>
                  <a:ea typeface="宋体" pitchFamily="2" charset="-122"/>
                  <a:cs typeface="宋体" pitchFamily="2" charset="-122"/>
                </a:rPr>
                <a:t>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6" name="Rectangle 26"/>
            <p:cNvSpPr>
              <a:spLocks noChangeArrowheads="1"/>
            </p:cNvSpPr>
            <p:nvPr/>
          </p:nvSpPr>
          <p:spPr bwMode="auto">
            <a:xfrm>
              <a:off x="3814" y="1238"/>
              <a:ext cx="219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or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7" name="Rectangle 27"/>
            <p:cNvSpPr>
              <a:spLocks noChangeArrowheads="1"/>
            </p:cNvSpPr>
            <p:nvPr/>
          </p:nvSpPr>
          <p:spPr bwMode="auto">
            <a:xfrm>
              <a:off x="4223" y="1238"/>
              <a:ext cx="219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or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8" name="Rectangle 28"/>
            <p:cNvSpPr>
              <a:spLocks noChangeArrowheads="1"/>
            </p:cNvSpPr>
            <p:nvPr/>
          </p:nvSpPr>
          <p:spPr bwMode="auto">
            <a:xfrm>
              <a:off x="4605" y="1238"/>
              <a:ext cx="92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9" name="Rectangle 29"/>
            <p:cNvSpPr>
              <a:spLocks noChangeArrowheads="1"/>
            </p:cNvSpPr>
            <p:nvPr/>
          </p:nvSpPr>
          <p:spPr bwMode="auto">
            <a:xfrm>
              <a:off x="5392" y="1233"/>
              <a:ext cx="186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or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0" name="Rectangle 30"/>
            <p:cNvSpPr>
              <a:spLocks noChangeArrowheads="1"/>
            </p:cNvSpPr>
            <p:nvPr/>
          </p:nvSpPr>
          <p:spPr bwMode="auto">
            <a:xfrm>
              <a:off x="6031" y="1233"/>
              <a:ext cx="92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1" name="Rectangle 31"/>
            <p:cNvSpPr>
              <a:spLocks noChangeArrowheads="1"/>
            </p:cNvSpPr>
            <p:nvPr/>
          </p:nvSpPr>
          <p:spPr bwMode="auto">
            <a:xfrm>
              <a:off x="1639" y="1041"/>
              <a:ext cx="720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096" name="Rectangle 32"/>
            <p:cNvSpPr>
              <a:spLocks noChangeArrowheads="1"/>
            </p:cNvSpPr>
            <p:nvPr/>
          </p:nvSpPr>
          <p:spPr bwMode="auto">
            <a:xfrm>
              <a:off x="2359" y="1041"/>
              <a:ext cx="4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097" name="Rectangle 33"/>
            <p:cNvSpPr>
              <a:spLocks noChangeArrowheads="1"/>
            </p:cNvSpPr>
            <p:nvPr/>
          </p:nvSpPr>
          <p:spPr bwMode="auto">
            <a:xfrm>
              <a:off x="2363" y="1041"/>
              <a:ext cx="1102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099" name="Rectangle 34"/>
            <p:cNvSpPr>
              <a:spLocks noChangeArrowheads="1"/>
            </p:cNvSpPr>
            <p:nvPr/>
          </p:nvSpPr>
          <p:spPr bwMode="auto">
            <a:xfrm>
              <a:off x="3465" y="1041"/>
              <a:ext cx="5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100" name="Rectangle 35"/>
            <p:cNvSpPr>
              <a:spLocks noChangeArrowheads="1"/>
            </p:cNvSpPr>
            <p:nvPr/>
          </p:nvSpPr>
          <p:spPr bwMode="auto">
            <a:xfrm>
              <a:off x="3470" y="1041"/>
              <a:ext cx="1303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101" name="Rectangle 36"/>
            <p:cNvSpPr>
              <a:spLocks noChangeArrowheads="1"/>
            </p:cNvSpPr>
            <p:nvPr/>
          </p:nvSpPr>
          <p:spPr bwMode="auto">
            <a:xfrm>
              <a:off x="4773" y="1041"/>
              <a:ext cx="4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102" name="Rectangle 37"/>
            <p:cNvSpPr>
              <a:spLocks noChangeArrowheads="1"/>
            </p:cNvSpPr>
            <p:nvPr/>
          </p:nvSpPr>
          <p:spPr bwMode="auto">
            <a:xfrm>
              <a:off x="4777" y="1041"/>
              <a:ext cx="1369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103" name="Rectangle 38"/>
            <p:cNvSpPr>
              <a:spLocks noChangeArrowheads="1"/>
            </p:cNvSpPr>
            <p:nvPr/>
          </p:nvSpPr>
          <p:spPr bwMode="auto">
            <a:xfrm>
              <a:off x="1967" y="1585"/>
              <a:ext cx="125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2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04" name="Rectangle 39"/>
            <p:cNvSpPr>
              <a:spLocks noChangeArrowheads="1"/>
            </p:cNvSpPr>
            <p:nvPr/>
          </p:nvSpPr>
          <p:spPr bwMode="auto">
            <a:xfrm>
              <a:off x="2031" y="1585"/>
              <a:ext cx="92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05" name="Rectangle 40"/>
            <p:cNvSpPr>
              <a:spLocks noChangeArrowheads="1"/>
            </p:cNvSpPr>
            <p:nvPr/>
          </p:nvSpPr>
          <p:spPr bwMode="auto">
            <a:xfrm>
              <a:off x="3288" y="1681"/>
              <a:ext cx="113" cy="1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400" b="1" i="0" u="none" strike="noStrike" cap="none" normalizeH="0" baseline="0" smtClean="0">
                  <a:ln>
                    <a:noFill/>
                  </a:ln>
                  <a:solidFill>
                    <a:srgbClr val="00B050"/>
                  </a:solidFill>
                  <a:effectLst/>
                  <a:latin typeface="宋体" pitchFamily="2" charset="-122"/>
                  <a:ea typeface="宋体" pitchFamily="2" charset="-122"/>
                  <a:cs typeface="宋体" pitchFamily="2" charset="-122"/>
                </a:rPr>
                <a:t>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06" name="Rectangle 41"/>
            <p:cNvSpPr>
              <a:spLocks noChangeArrowheads="1"/>
            </p:cNvSpPr>
            <p:nvPr/>
          </p:nvSpPr>
          <p:spPr bwMode="auto">
            <a:xfrm>
              <a:off x="3814" y="1640"/>
              <a:ext cx="219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or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07" name="Rectangle 42"/>
            <p:cNvSpPr>
              <a:spLocks noChangeArrowheads="1"/>
            </p:cNvSpPr>
            <p:nvPr/>
          </p:nvSpPr>
          <p:spPr bwMode="auto">
            <a:xfrm>
              <a:off x="4223" y="1640"/>
              <a:ext cx="219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or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08" name="Rectangle 43"/>
            <p:cNvSpPr>
              <a:spLocks noChangeArrowheads="1"/>
            </p:cNvSpPr>
            <p:nvPr/>
          </p:nvSpPr>
          <p:spPr bwMode="auto">
            <a:xfrm>
              <a:off x="4605" y="1640"/>
              <a:ext cx="92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09" name="Rectangle 44"/>
            <p:cNvSpPr>
              <a:spLocks noChangeArrowheads="1"/>
            </p:cNvSpPr>
            <p:nvPr/>
          </p:nvSpPr>
          <p:spPr bwMode="auto">
            <a:xfrm>
              <a:off x="5362" y="1635"/>
              <a:ext cx="219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or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10" name="Rectangle 45"/>
            <p:cNvSpPr>
              <a:spLocks noChangeArrowheads="1"/>
            </p:cNvSpPr>
            <p:nvPr/>
          </p:nvSpPr>
          <p:spPr bwMode="auto">
            <a:xfrm>
              <a:off x="6054" y="1635"/>
              <a:ext cx="92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11" name="Rectangle 46"/>
            <p:cNvSpPr>
              <a:spLocks noChangeArrowheads="1"/>
            </p:cNvSpPr>
            <p:nvPr/>
          </p:nvSpPr>
          <p:spPr bwMode="auto">
            <a:xfrm>
              <a:off x="1967" y="1977"/>
              <a:ext cx="125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3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12" name="Rectangle 47"/>
            <p:cNvSpPr>
              <a:spLocks noChangeArrowheads="1"/>
            </p:cNvSpPr>
            <p:nvPr/>
          </p:nvSpPr>
          <p:spPr bwMode="auto">
            <a:xfrm>
              <a:off x="2031" y="1977"/>
              <a:ext cx="92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13" name="Rectangle 48"/>
            <p:cNvSpPr>
              <a:spLocks noChangeArrowheads="1"/>
            </p:cNvSpPr>
            <p:nvPr/>
          </p:nvSpPr>
          <p:spPr bwMode="auto">
            <a:xfrm>
              <a:off x="3287" y="2077"/>
              <a:ext cx="113" cy="1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400" b="1" i="0" u="none" strike="noStrike" cap="none" normalizeH="0" baseline="0" smtClean="0">
                  <a:ln>
                    <a:noFill/>
                  </a:ln>
                  <a:solidFill>
                    <a:srgbClr val="00B050"/>
                  </a:solidFill>
                  <a:effectLst/>
                  <a:latin typeface="宋体" pitchFamily="2" charset="-122"/>
                  <a:ea typeface="宋体" pitchFamily="2" charset="-122"/>
                  <a:cs typeface="宋体" pitchFamily="2" charset="-122"/>
                </a:rPr>
                <a:t>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14" name="Rectangle 49"/>
            <p:cNvSpPr>
              <a:spLocks noChangeArrowheads="1"/>
            </p:cNvSpPr>
            <p:nvPr/>
          </p:nvSpPr>
          <p:spPr bwMode="auto">
            <a:xfrm>
              <a:off x="3814" y="2032"/>
              <a:ext cx="219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or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15" name="Rectangle 50"/>
            <p:cNvSpPr>
              <a:spLocks noChangeArrowheads="1"/>
            </p:cNvSpPr>
            <p:nvPr/>
          </p:nvSpPr>
          <p:spPr bwMode="auto">
            <a:xfrm>
              <a:off x="4223" y="2032"/>
              <a:ext cx="219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or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16" name="Rectangle 51"/>
            <p:cNvSpPr>
              <a:spLocks noChangeArrowheads="1"/>
            </p:cNvSpPr>
            <p:nvPr/>
          </p:nvSpPr>
          <p:spPr bwMode="auto">
            <a:xfrm>
              <a:off x="4605" y="2032"/>
              <a:ext cx="92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17" name="Rectangle 52"/>
            <p:cNvSpPr>
              <a:spLocks noChangeArrowheads="1"/>
            </p:cNvSpPr>
            <p:nvPr/>
          </p:nvSpPr>
          <p:spPr bwMode="auto">
            <a:xfrm>
              <a:off x="5100" y="2032"/>
              <a:ext cx="92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18" name="Rectangle 53"/>
            <p:cNvSpPr>
              <a:spLocks noChangeArrowheads="1"/>
            </p:cNvSpPr>
            <p:nvPr/>
          </p:nvSpPr>
          <p:spPr bwMode="auto">
            <a:xfrm>
              <a:off x="5345" y="2032"/>
              <a:ext cx="219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or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19" name="Rectangle 54"/>
            <p:cNvSpPr>
              <a:spLocks noChangeArrowheads="1"/>
            </p:cNvSpPr>
            <p:nvPr/>
          </p:nvSpPr>
          <p:spPr bwMode="auto">
            <a:xfrm>
              <a:off x="5753" y="2032"/>
              <a:ext cx="92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20" name="Rectangle 55"/>
            <p:cNvSpPr>
              <a:spLocks noChangeArrowheads="1"/>
            </p:cNvSpPr>
            <p:nvPr/>
          </p:nvSpPr>
          <p:spPr bwMode="auto">
            <a:xfrm>
              <a:off x="6014" y="2032"/>
              <a:ext cx="92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21" name="Rectangle 56"/>
            <p:cNvSpPr>
              <a:spLocks noChangeArrowheads="1"/>
            </p:cNvSpPr>
            <p:nvPr/>
          </p:nvSpPr>
          <p:spPr bwMode="auto">
            <a:xfrm>
              <a:off x="1967" y="2370"/>
              <a:ext cx="125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4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22" name="Rectangle 57"/>
            <p:cNvSpPr>
              <a:spLocks noChangeArrowheads="1"/>
            </p:cNvSpPr>
            <p:nvPr/>
          </p:nvSpPr>
          <p:spPr bwMode="auto">
            <a:xfrm>
              <a:off x="2031" y="2370"/>
              <a:ext cx="92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23" name="Rectangle 58"/>
            <p:cNvSpPr>
              <a:spLocks noChangeArrowheads="1"/>
            </p:cNvSpPr>
            <p:nvPr/>
          </p:nvSpPr>
          <p:spPr bwMode="auto">
            <a:xfrm>
              <a:off x="2764" y="2480"/>
              <a:ext cx="113" cy="1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400" b="1" i="0" u="none" strike="noStrike" cap="none" normalizeH="0" baseline="0" smtClean="0">
                  <a:ln>
                    <a:noFill/>
                  </a:ln>
                  <a:solidFill>
                    <a:srgbClr val="00B050"/>
                  </a:solidFill>
                  <a:effectLst/>
                  <a:latin typeface="宋体" pitchFamily="2" charset="-122"/>
                  <a:ea typeface="宋体" pitchFamily="2" charset="-122"/>
                  <a:cs typeface="宋体" pitchFamily="2" charset="-122"/>
                </a:rPr>
                <a:t>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24" name="Rectangle 59"/>
            <p:cNvSpPr>
              <a:spLocks noChangeArrowheads="1"/>
            </p:cNvSpPr>
            <p:nvPr/>
          </p:nvSpPr>
          <p:spPr bwMode="auto">
            <a:xfrm>
              <a:off x="2991" y="2480"/>
              <a:ext cx="113" cy="1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400" b="1" i="0" u="none" strike="noStrike" cap="none" normalizeH="0" baseline="0" smtClean="0">
                  <a:ln>
                    <a:noFill/>
                  </a:ln>
                  <a:solidFill>
                    <a:srgbClr val="00B050"/>
                  </a:solidFill>
                  <a:effectLst/>
                  <a:latin typeface="宋体" pitchFamily="2" charset="-122"/>
                  <a:ea typeface="宋体" pitchFamily="2" charset="-122"/>
                  <a:cs typeface="宋体" pitchFamily="2" charset="-122"/>
                </a:rPr>
                <a:t>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25" name="Rectangle 60"/>
            <p:cNvSpPr>
              <a:spLocks noChangeArrowheads="1"/>
            </p:cNvSpPr>
            <p:nvPr/>
          </p:nvSpPr>
          <p:spPr bwMode="auto">
            <a:xfrm>
              <a:off x="3245" y="2480"/>
              <a:ext cx="113" cy="1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400" b="1" i="0" u="none" strike="noStrike" cap="none" normalizeH="0" baseline="0" smtClean="0">
                  <a:ln>
                    <a:noFill/>
                  </a:ln>
                  <a:solidFill>
                    <a:srgbClr val="00B050"/>
                  </a:solidFill>
                  <a:effectLst/>
                  <a:latin typeface="宋体" pitchFamily="2" charset="-122"/>
                  <a:ea typeface="宋体" pitchFamily="2" charset="-122"/>
                  <a:cs typeface="宋体" pitchFamily="2" charset="-122"/>
                </a:rPr>
                <a:t>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26" name="Rectangle 61"/>
            <p:cNvSpPr>
              <a:spLocks noChangeArrowheads="1"/>
            </p:cNvSpPr>
            <p:nvPr/>
          </p:nvSpPr>
          <p:spPr bwMode="auto">
            <a:xfrm>
              <a:off x="3826" y="2443"/>
              <a:ext cx="219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or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27" name="Rectangle 62"/>
            <p:cNvSpPr>
              <a:spLocks noChangeArrowheads="1"/>
            </p:cNvSpPr>
            <p:nvPr/>
          </p:nvSpPr>
          <p:spPr bwMode="auto">
            <a:xfrm>
              <a:off x="4198" y="2443"/>
              <a:ext cx="219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or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28" name="Rectangle 63"/>
            <p:cNvSpPr>
              <a:spLocks noChangeArrowheads="1"/>
            </p:cNvSpPr>
            <p:nvPr/>
          </p:nvSpPr>
          <p:spPr bwMode="auto">
            <a:xfrm>
              <a:off x="4582" y="2443"/>
              <a:ext cx="92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29" name="Rectangle 64"/>
            <p:cNvSpPr>
              <a:spLocks noChangeArrowheads="1"/>
            </p:cNvSpPr>
            <p:nvPr/>
          </p:nvSpPr>
          <p:spPr bwMode="auto">
            <a:xfrm>
              <a:off x="5059" y="2447"/>
              <a:ext cx="92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30" name="Rectangle 65"/>
            <p:cNvSpPr>
              <a:spLocks noChangeArrowheads="1"/>
            </p:cNvSpPr>
            <p:nvPr/>
          </p:nvSpPr>
          <p:spPr bwMode="auto">
            <a:xfrm>
              <a:off x="5296" y="2447"/>
              <a:ext cx="92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31" name="Rectangle 66"/>
            <p:cNvSpPr>
              <a:spLocks noChangeArrowheads="1"/>
            </p:cNvSpPr>
            <p:nvPr/>
          </p:nvSpPr>
          <p:spPr bwMode="auto">
            <a:xfrm>
              <a:off x="5360" y="2447"/>
              <a:ext cx="219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or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32" name="Rectangle 67"/>
            <p:cNvSpPr>
              <a:spLocks noChangeArrowheads="1"/>
            </p:cNvSpPr>
            <p:nvPr/>
          </p:nvSpPr>
          <p:spPr bwMode="auto">
            <a:xfrm>
              <a:off x="6045" y="2447"/>
              <a:ext cx="92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33" name="Rectangle 68"/>
            <p:cNvSpPr>
              <a:spLocks noChangeArrowheads="1"/>
            </p:cNvSpPr>
            <p:nvPr/>
          </p:nvSpPr>
          <p:spPr bwMode="auto">
            <a:xfrm>
              <a:off x="1967" y="2767"/>
              <a:ext cx="125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5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34" name="Rectangle 69"/>
            <p:cNvSpPr>
              <a:spLocks noChangeArrowheads="1"/>
            </p:cNvSpPr>
            <p:nvPr/>
          </p:nvSpPr>
          <p:spPr bwMode="auto">
            <a:xfrm>
              <a:off x="2031" y="2767"/>
              <a:ext cx="92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35" name="Rectangle 70"/>
            <p:cNvSpPr>
              <a:spLocks noChangeArrowheads="1"/>
            </p:cNvSpPr>
            <p:nvPr/>
          </p:nvSpPr>
          <p:spPr bwMode="auto">
            <a:xfrm>
              <a:off x="2777" y="2877"/>
              <a:ext cx="113" cy="1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400" b="1" i="0" u="none" strike="noStrike" cap="none" normalizeH="0" baseline="0" smtClean="0">
                  <a:ln>
                    <a:noFill/>
                  </a:ln>
                  <a:solidFill>
                    <a:srgbClr val="00B050"/>
                  </a:solidFill>
                  <a:effectLst/>
                  <a:latin typeface="宋体" pitchFamily="2" charset="-122"/>
                  <a:ea typeface="宋体" pitchFamily="2" charset="-122"/>
                  <a:cs typeface="宋体" pitchFamily="2" charset="-122"/>
                </a:rPr>
                <a:t>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36" name="Rectangle 71"/>
            <p:cNvSpPr>
              <a:spLocks noChangeArrowheads="1"/>
            </p:cNvSpPr>
            <p:nvPr/>
          </p:nvSpPr>
          <p:spPr bwMode="auto">
            <a:xfrm>
              <a:off x="3004" y="2877"/>
              <a:ext cx="113" cy="1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400" b="1" i="0" u="none" strike="noStrike" cap="none" normalizeH="0" baseline="0" smtClean="0">
                  <a:ln>
                    <a:noFill/>
                  </a:ln>
                  <a:solidFill>
                    <a:srgbClr val="00B050"/>
                  </a:solidFill>
                  <a:effectLst/>
                  <a:latin typeface="宋体" pitchFamily="2" charset="-122"/>
                  <a:ea typeface="宋体" pitchFamily="2" charset="-122"/>
                  <a:cs typeface="宋体" pitchFamily="2" charset="-122"/>
                </a:rPr>
                <a:t>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37" name="Rectangle 72"/>
            <p:cNvSpPr>
              <a:spLocks noChangeArrowheads="1"/>
            </p:cNvSpPr>
            <p:nvPr/>
          </p:nvSpPr>
          <p:spPr bwMode="auto">
            <a:xfrm>
              <a:off x="3245" y="2877"/>
              <a:ext cx="113" cy="1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400" b="1" i="0" u="none" strike="noStrike" cap="none" normalizeH="0" baseline="0" smtClean="0">
                  <a:ln>
                    <a:noFill/>
                  </a:ln>
                  <a:solidFill>
                    <a:srgbClr val="00B050"/>
                  </a:solidFill>
                  <a:effectLst/>
                  <a:latin typeface="宋体" pitchFamily="2" charset="-122"/>
                  <a:ea typeface="宋体" pitchFamily="2" charset="-122"/>
                  <a:cs typeface="宋体" pitchFamily="2" charset="-122"/>
                </a:rPr>
                <a:t>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38" name="Rectangle 73"/>
            <p:cNvSpPr>
              <a:spLocks noChangeArrowheads="1"/>
            </p:cNvSpPr>
            <p:nvPr/>
          </p:nvSpPr>
          <p:spPr bwMode="auto">
            <a:xfrm>
              <a:off x="3826" y="2839"/>
              <a:ext cx="219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or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39" name="Rectangle 74"/>
            <p:cNvSpPr>
              <a:spLocks noChangeArrowheads="1"/>
            </p:cNvSpPr>
            <p:nvPr/>
          </p:nvSpPr>
          <p:spPr bwMode="auto">
            <a:xfrm>
              <a:off x="4198" y="2839"/>
              <a:ext cx="219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or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40" name="Rectangle 75"/>
            <p:cNvSpPr>
              <a:spLocks noChangeArrowheads="1"/>
            </p:cNvSpPr>
            <p:nvPr/>
          </p:nvSpPr>
          <p:spPr bwMode="auto">
            <a:xfrm>
              <a:off x="4582" y="2839"/>
              <a:ext cx="92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41" name="Rectangle 76"/>
            <p:cNvSpPr>
              <a:spLocks noChangeArrowheads="1"/>
            </p:cNvSpPr>
            <p:nvPr/>
          </p:nvSpPr>
          <p:spPr bwMode="auto">
            <a:xfrm>
              <a:off x="5095" y="2844"/>
              <a:ext cx="92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42" name="Rectangle 77"/>
            <p:cNvSpPr>
              <a:spLocks noChangeArrowheads="1"/>
            </p:cNvSpPr>
            <p:nvPr/>
          </p:nvSpPr>
          <p:spPr bwMode="auto">
            <a:xfrm>
              <a:off x="5332" y="2844"/>
              <a:ext cx="125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o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43" name="Rectangle 78"/>
            <p:cNvSpPr>
              <a:spLocks noChangeArrowheads="1"/>
            </p:cNvSpPr>
            <p:nvPr/>
          </p:nvSpPr>
          <p:spPr bwMode="auto">
            <a:xfrm>
              <a:off x="5397" y="2844"/>
              <a:ext cx="92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44" name="Rectangle 79"/>
            <p:cNvSpPr>
              <a:spLocks noChangeArrowheads="1"/>
            </p:cNvSpPr>
            <p:nvPr/>
          </p:nvSpPr>
          <p:spPr bwMode="auto">
            <a:xfrm>
              <a:off x="5430" y="2844"/>
              <a:ext cx="152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r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45" name="Rectangle 80"/>
            <p:cNvSpPr>
              <a:spLocks noChangeArrowheads="1"/>
            </p:cNvSpPr>
            <p:nvPr/>
          </p:nvSpPr>
          <p:spPr bwMode="auto">
            <a:xfrm>
              <a:off x="6021" y="2844"/>
              <a:ext cx="92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46" name="Rectangle 81"/>
            <p:cNvSpPr>
              <a:spLocks noChangeArrowheads="1"/>
            </p:cNvSpPr>
            <p:nvPr/>
          </p:nvSpPr>
          <p:spPr bwMode="auto">
            <a:xfrm>
              <a:off x="1967" y="3163"/>
              <a:ext cx="125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6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47" name="Rectangle 82"/>
            <p:cNvSpPr>
              <a:spLocks noChangeArrowheads="1"/>
            </p:cNvSpPr>
            <p:nvPr/>
          </p:nvSpPr>
          <p:spPr bwMode="auto">
            <a:xfrm>
              <a:off x="2031" y="3163"/>
              <a:ext cx="92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48" name="Rectangle 83"/>
            <p:cNvSpPr>
              <a:spLocks noChangeArrowheads="1"/>
            </p:cNvSpPr>
            <p:nvPr/>
          </p:nvSpPr>
          <p:spPr bwMode="auto">
            <a:xfrm>
              <a:off x="3271" y="3263"/>
              <a:ext cx="113" cy="1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400" b="1" i="0" u="none" strike="noStrike" cap="none" normalizeH="0" baseline="0" smtClean="0">
                  <a:ln>
                    <a:noFill/>
                  </a:ln>
                  <a:solidFill>
                    <a:srgbClr val="00B050"/>
                  </a:solidFill>
                  <a:effectLst/>
                  <a:latin typeface="宋体" pitchFamily="2" charset="-122"/>
                  <a:ea typeface="宋体" pitchFamily="2" charset="-122"/>
                  <a:cs typeface="宋体" pitchFamily="2" charset="-122"/>
                </a:rPr>
                <a:t>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49" name="Rectangle 84"/>
            <p:cNvSpPr>
              <a:spLocks noChangeArrowheads="1"/>
            </p:cNvSpPr>
            <p:nvPr/>
          </p:nvSpPr>
          <p:spPr bwMode="auto">
            <a:xfrm>
              <a:off x="3826" y="3235"/>
              <a:ext cx="219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or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50" name="Rectangle 85"/>
            <p:cNvSpPr>
              <a:spLocks noChangeArrowheads="1"/>
            </p:cNvSpPr>
            <p:nvPr/>
          </p:nvSpPr>
          <p:spPr bwMode="auto">
            <a:xfrm>
              <a:off x="4198" y="3235"/>
              <a:ext cx="219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or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51" name="Rectangle 86"/>
            <p:cNvSpPr>
              <a:spLocks noChangeArrowheads="1"/>
            </p:cNvSpPr>
            <p:nvPr/>
          </p:nvSpPr>
          <p:spPr bwMode="auto">
            <a:xfrm>
              <a:off x="4582" y="3235"/>
              <a:ext cx="92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52" name="Rectangle 87"/>
            <p:cNvSpPr>
              <a:spLocks noChangeArrowheads="1"/>
            </p:cNvSpPr>
            <p:nvPr/>
          </p:nvSpPr>
          <p:spPr bwMode="auto">
            <a:xfrm>
              <a:off x="5064" y="3235"/>
              <a:ext cx="92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53" name="Rectangle 88"/>
            <p:cNvSpPr>
              <a:spLocks noChangeArrowheads="1"/>
            </p:cNvSpPr>
            <p:nvPr/>
          </p:nvSpPr>
          <p:spPr bwMode="auto">
            <a:xfrm>
              <a:off x="5328" y="3235"/>
              <a:ext cx="92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54" name="Rectangle 89"/>
            <p:cNvSpPr>
              <a:spLocks noChangeArrowheads="1"/>
            </p:cNvSpPr>
            <p:nvPr/>
          </p:nvSpPr>
          <p:spPr bwMode="auto">
            <a:xfrm>
              <a:off x="5392" y="3235"/>
              <a:ext cx="219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or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55" name="Rectangle 90"/>
            <p:cNvSpPr>
              <a:spLocks noChangeArrowheads="1"/>
            </p:cNvSpPr>
            <p:nvPr/>
          </p:nvSpPr>
          <p:spPr bwMode="auto">
            <a:xfrm>
              <a:off x="5777" y="3235"/>
              <a:ext cx="92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56" name="Rectangle 91"/>
            <p:cNvSpPr>
              <a:spLocks noChangeArrowheads="1"/>
            </p:cNvSpPr>
            <p:nvPr/>
          </p:nvSpPr>
          <p:spPr bwMode="auto">
            <a:xfrm>
              <a:off x="6026" y="3235"/>
              <a:ext cx="92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宋体" pitchFamily="2" charset="-122"/>
                </a:rPr>
                <a:t>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157" name="Rectangle 92"/>
            <p:cNvSpPr>
              <a:spLocks noChangeArrowheads="1"/>
            </p:cNvSpPr>
            <p:nvPr/>
          </p:nvSpPr>
          <p:spPr bwMode="auto">
            <a:xfrm>
              <a:off x="1632" y="3431"/>
              <a:ext cx="727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158" name="Rectangle 93"/>
            <p:cNvSpPr>
              <a:spLocks noChangeArrowheads="1"/>
            </p:cNvSpPr>
            <p:nvPr/>
          </p:nvSpPr>
          <p:spPr bwMode="auto">
            <a:xfrm>
              <a:off x="2352" y="3431"/>
              <a:ext cx="5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159" name="Rectangle 94"/>
            <p:cNvSpPr>
              <a:spLocks noChangeArrowheads="1"/>
            </p:cNvSpPr>
            <p:nvPr/>
          </p:nvSpPr>
          <p:spPr bwMode="auto">
            <a:xfrm>
              <a:off x="2357" y="3431"/>
              <a:ext cx="1108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160" name="Rectangle 95"/>
            <p:cNvSpPr>
              <a:spLocks noChangeArrowheads="1"/>
            </p:cNvSpPr>
            <p:nvPr/>
          </p:nvSpPr>
          <p:spPr bwMode="auto">
            <a:xfrm>
              <a:off x="3458" y="3431"/>
              <a:ext cx="5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161" name="Rectangle 96"/>
            <p:cNvSpPr>
              <a:spLocks noChangeArrowheads="1"/>
            </p:cNvSpPr>
            <p:nvPr/>
          </p:nvSpPr>
          <p:spPr bwMode="auto">
            <a:xfrm>
              <a:off x="3463" y="3431"/>
              <a:ext cx="1310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162" name="Rectangle 97"/>
            <p:cNvSpPr>
              <a:spLocks noChangeArrowheads="1"/>
            </p:cNvSpPr>
            <p:nvPr/>
          </p:nvSpPr>
          <p:spPr bwMode="auto">
            <a:xfrm>
              <a:off x="4766" y="3431"/>
              <a:ext cx="5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163" name="Rectangle 98"/>
            <p:cNvSpPr>
              <a:spLocks noChangeArrowheads="1"/>
            </p:cNvSpPr>
            <p:nvPr/>
          </p:nvSpPr>
          <p:spPr bwMode="auto">
            <a:xfrm>
              <a:off x="4771" y="3431"/>
              <a:ext cx="1375" cy="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164" name="Rectangle 99"/>
            <p:cNvSpPr>
              <a:spLocks noChangeArrowheads="1"/>
            </p:cNvSpPr>
            <p:nvPr/>
          </p:nvSpPr>
          <p:spPr bwMode="auto">
            <a:xfrm>
              <a:off x="1478" y="3442"/>
              <a:ext cx="79" cy="15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ea typeface="宋体" pitchFamily="2" charset="-122"/>
                  <a:cs typeface="宋体" pitchFamily="2" charset="-122"/>
                </a:rPr>
                <a:t> 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pic>
          <p:nvPicPr>
            <p:cNvPr id="1124" name="Picture 100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37" y="1136"/>
              <a:ext cx="750" cy="2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25" name="Picture 101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32" y="1136"/>
              <a:ext cx="182" cy="2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26" name="Picture 102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32" y="1136"/>
              <a:ext cx="182" cy="2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27" name="Picture 103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01" y="1121"/>
              <a:ext cx="215" cy="2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28" name="Picture 104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01" y="1121"/>
              <a:ext cx="215" cy="2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29" name="Picture 105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10" y="1145"/>
              <a:ext cx="196" cy="2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30" name="Picture 106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10" y="1145"/>
              <a:ext cx="196" cy="2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31" name="Picture 107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87" y="1126"/>
              <a:ext cx="505" cy="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32" name="Picture 108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515" y="1130"/>
              <a:ext cx="517" cy="2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33" name="Picture 109"/>
            <p:cNvPicPr>
              <a:picLocks noChangeAspect="1" noChangeArrowheads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36" y="1534"/>
              <a:ext cx="751" cy="2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34" name="Picture 110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32" y="1538"/>
              <a:ext cx="182" cy="2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35" name="Picture 111"/>
            <p:cNvPicPr>
              <a:picLocks noChangeAspect="1" noChangeArrowheads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32" y="1538"/>
              <a:ext cx="182" cy="2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36" name="Picture 112"/>
            <p:cNvPicPr>
              <a:picLocks noChangeAspect="1" noChangeArrowheads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01" y="1523"/>
              <a:ext cx="215" cy="2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37" name="Picture 113"/>
            <p:cNvPicPr>
              <a:picLocks noChangeAspect="1" noChangeArrowheads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01" y="1523"/>
              <a:ext cx="215" cy="2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38" name="Picture 114"/>
            <p:cNvPicPr>
              <a:picLocks noChangeAspect="1" noChangeArrowheads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10" y="1547"/>
              <a:ext cx="196" cy="2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39" name="Picture 115"/>
            <p:cNvPicPr>
              <a:picLocks noChangeAspect="1" noChangeArrowheads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10" y="1547"/>
              <a:ext cx="196" cy="2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40" name="Picture 116"/>
            <p:cNvPicPr>
              <a:picLocks noChangeAspect="1" noChangeArrowheads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65" y="1529"/>
              <a:ext cx="496" cy="2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41" name="Picture 117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550" y="1529"/>
              <a:ext cx="505" cy="2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42" name="Picture 118"/>
            <p:cNvPicPr>
              <a:picLocks noChangeAspect="1" noChangeArrowheads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37" y="1922"/>
              <a:ext cx="750" cy="2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43" name="Picture 119"/>
            <p:cNvPicPr>
              <a:picLocks noChangeAspect="1" noChangeArrowheads="1"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32" y="1928"/>
              <a:ext cx="182" cy="2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44" name="Picture 120"/>
            <p:cNvPicPr>
              <a:picLocks noChangeAspect="1" noChangeArrowheads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32" y="1928"/>
              <a:ext cx="182" cy="2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45" name="Picture 121"/>
            <p:cNvPicPr>
              <a:picLocks noChangeAspect="1" noChangeArrowheads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01" y="1915"/>
              <a:ext cx="215" cy="2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46" name="Picture 122"/>
            <p:cNvPicPr>
              <a:picLocks noChangeAspect="1" noChangeArrowheads="1"/>
            </p:cNvPicPr>
            <p:nvPr/>
          </p:nvPicPr>
          <p:blipFill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01" y="1915"/>
              <a:ext cx="215" cy="2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47" name="Picture 123"/>
            <p:cNvPicPr>
              <a:picLocks noChangeAspect="1" noChangeArrowheads="1"/>
            </p:cNvPicPr>
            <p:nvPr/>
          </p:nvPicPr>
          <p:blipFill>
            <a:blip r:embed="rId2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10" y="1940"/>
              <a:ext cx="196" cy="2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48" name="Picture 124"/>
            <p:cNvPicPr>
              <a:picLocks noChangeAspect="1" noChangeArrowheads="1"/>
            </p:cNvPicPr>
            <p:nvPr/>
          </p:nvPicPr>
          <p:blipFill>
            <a:blip r:embed="rId2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10" y="1940"/>
              <a:ext cx="196" cy="2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49" name="Picture 125"/>
            <p:cNvPicPr>
              <a:picLocks noChangeAspect="1" noChangeArrowheads="1"/>
            </p:cNvPicPr>
            <p:nvPr/>
          </p:nvPicPr>
          <p:blipFill>
            <a:blip r:embed="rId2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904" y="1940"/>
              <a:ext cx="197" cy="2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50" name="Picture 126"/>
            <p:cNvPicPr>
              <a:picLocks noChangeAspect="1" noChangeArrowheads="1"/>
            </p:cNvPicPr>
            <p:nvPr/>
          </p:nvPicPr>
          <p:blipFill>
            <a:blip r:embed="rId2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904" y="1940"/>
              <a:ext cx="197" cy="2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51" name="Picture 127"/>
            <p:cNvPicPr>
              <a:picLocks noChangeAspect="1" noChangeArrowheads="1"/>
            </p:cNvPicPr>
            <p:nvPr/>
          </p:nvPicPr>
          <p:blipFill>
            <a:blip r:embed="rId2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65" y="1928"/>
              <a:ext cx="182" cy="2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52" name="Picture 128"/>
            <p:cNvPicPr>
              <a:picLocks noChangeAspect="1" noChangeArrowheads="1"/>
            </p:cNvPicPr>
            <p:nvPr/>
          </p:nvPicPr>
          <p:blipFill>
            <a:blip r:embed="rId2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65" y="1928"/>
              <a:ext cx="182" cy="2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53" name="Picture 129"/>
            <p:cNvPicPr>
              <a:picLocks noChangeAspect="1" noChangeArrowheads="1"/>
            </p:cNvPicPr>
            <p:nvPr/>
          </p:nvPicPr>
          <p:blipFill>
            <a:blip r:embed="rId3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534" y="1915"/>
              <a:ext cx="215" cy="2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54" name="Picture 130"/>
            <p:cNvPicPr>
              <a:picLocks noChangeAspect="1" noChangeArrowheads="1"/>
            </p:cNvPicPr>
            <p:nvPr/>
          </p:nvPicPr>
          <p:blipFill>
            <a:blip r:embed="rId3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534" y="1915"/>
              <a:ext cx="215" cy="2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55" name="Picture 131"/>
            <p:cNvPicPr>
              <a:picLocks noChangeAspect="1" noChangeArrowheads="1"/>
            </p:cNvPicPr>
            <p:nvPr/>
          </p:nvPicPr>
          <p:blipFill>
            <a:blip r:embed="rId3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819" y="1940"/>
              <a:ext cx="197" cy="2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56" name="Picture 132"/>
            <p:cNvPicPr>
              <a:picLocks noChangeAspect="1" noChangeArrowheads="1"/>
            </p:cNvPicPr>
            <p:nvPr/>
          </p:nvPicPr>
          <p:blipFill>
            <a:blip r:embed="rId3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819" y="1940"/>
              <a:ext cx="197" cy="2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57" name="Picture 133"/>
            <p:cNvPicPr>
              <a:picLocks noChangeAspect="1" noChangeArrowheads="1"/>
            </p:cNvPicPr>
            <p:nvPr/>
          </p:nvPicPr>
          <p:blipFill>
            <a:blip r:embed="rId3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78" y="2348"/>
              <a:ext cx="186" cy="2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58" name="Picture 134"/>
            <p:cNvPicPr>
              <a:picLocks noChangeAspect="1" noChangeArrowheads="1"/>
            </p:cNvPicPr>
            <p:nvPr/>
          </p:nvPicPr>
          <p:blipFill>
            <a:blip r:embed="rId3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78" y="2348"/>
              <a:ext cx="186" cy="2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59" name="Picture 135"/>
            <p:cNvPicPr>
              <a:picLocks noChangeAspect="1" noChangeArrowheads="1"/>
            </p:cNvPicPr>
            <p:nvPr/>
          </p:nvPicPr>
          <p:blipFill>
            <a:blip r:embed="rId3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820" y="2326"/>
              <a:ext cx="172" cy="2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60" name="Picture 136"/>
            <p:cNvPicPr>
              <a:picLocks noChangeAspect="1" noChangeArrowheads="1"/>
            </p:cNvPicPr>
            <p:nvPr/>
          </p:nvPicPr>
          <p:blipFill>
            <a:blip r:embed="rId3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820" y="2326"/>
              <a:ext cx="172" cy="2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61" name="Picture 137"/>
            <p:cNvPicPr>
              <a:picLocks noChangeAspect="1" noChangeArrowheads="1"/>
            </p:cNvPicPr>
            <p:nvPr/>
          </p:nvPicPr>
          <p:blipFill>
            <a:blip r:embed="rId3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48" y="2307"/>
              <a:ext cx="198" cy="2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62" name="Picture 138"/>
            <p:cNvPicPr>
              <a:picLocks noChangeAspect="1" noChangeArrowheads="1"/>
            </p:cNvPicPr>
            <p:nvPr/>
          </p:nvPicPr>
          <p:blipFill>
            <a:blip r:embed="rId3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48" y="2307"/>
              <a:ext cx="198" cy="2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63" name="Picture 139"/>
            <p:cNvPicPr>
              <a:picLocks noChangeAspect="1" noChangeArrowheads="1"/>
            </p:cNvPicPr>
            <p:nvPr/>
          </p:nvPicPr>
          <p:blipFill>
            <a:blip r:embed="rId4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54" y="2312"/>
              <a:ext cx="173" cy="2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64" name="Picture 140"/>
            <p:cNvPicPr>
              <a:picLocks noChangeAspect="1" noChangeArrowheads="1"/>
            </p:cNvPicPr>
            <p:nvPr/>
          </p:nvPicPr>
          <p:blipFill>
            <a:blip r:embed="rId4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54" y="2312"/>
              <a:ext cx="173" cy="2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65" name="Picture 141"/>
            <p:cNvPicPr>
              <a:picLocks noChangeAspect="1" noChangeArrowheads="1"/>
            </p:cNvPicPr>
            <p:nvPr/>
          </p:nvPicPr>
          <p:blipFill>
            <a:blip r:embed="rId4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13" y="2335"/>
              <a:ext cx="186" cy="2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66" name="Picture 142"/>
            <p:cNvPicPr>
              <a:picLocks noChangeAspect="1" noChangeArrowheads="1"/>
            </p:cNvPicPr>
            <p:nvPr/>
          </p:nvPicPr>
          <p:blipFill>
            <a:blip r:embed="rId4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13" y="2335"/>
              <a:ext cx="186" cy="2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67" name="Picture 143"/>
            <p:cNvPicPr>
              <a:picLocks noChangeAspect="1" noChangeArrowheads="1"/>
            </p:cNvPicPr>
            <p:nvPr/>
          </p:nvPicPr>
          <p:blipFill>
            <a:blip r:embed="rId4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386" y="2293"/>
              <a:ext cx="199" cy="2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68" name="Picture 144"/>
            <p:cNvPicPr>
              <a:picLocks noChangeAspect="1" noChangeArrowheads="1"/>
            </p:cNvPicPr>
            <p:nvPr/>
          </p:nvPicPr>
          <p:blipFill>
            <a:blip r:embed="rId4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386" y="2293"/>
              <a:ext cx="199" cy="2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69" name="Picture 145"/>
            <p:cNvPicPr>
              <a:picLocks noChangeAspect="1" noChangeArrowheads="1"/>
            </p:cNvPicPr>
            <p:nvPr/>
          </p:nvPicPr>
          <p:blipFill>
            <a:blip r:embed="rId4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74" y="2339"/>
              <a:ext cx="185" cy="2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70" name="Picture 146"/>
            <p:cNvPicPr>
              <a:picLocks noChangeAspect="1" noChangeArrowheads="1"/>
            </p:cNvPicPr>
            <p:nvPr/>
          </p:nvPicPr>
          <p:blipFill>
            <a:blip r:embed="rId4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74" y="2339"/>
              <a:ext cx="185" cy="2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71" name="Picture 147"/>
            <p:cNvPicPr>
              <a:picLocks noChangeAspect="1" noChangeArrowheads="1"/>
            </p:cNvPicPr>
            <p:nvPr/>
          </p:nvPicPr>
          <p:blipFill>
            <a:blip r:embed="rId4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24" y="2316"/>
              <a:ext cx="173" cy="2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72" name="Picture 148"/>
            <p:cNvPicPr>
              <a:picLocks noChangeAspect="1" noChangeArrowheads="1"/>
            </p:cNvPicPr>
            <p:nvPr/>
          </p:nvPicPr>
          <p:blipFill>
            <a:blip r:embed="rId4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24" y="2316"/>
              <a:ext cx="173" cy="2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73" name="Picture 149"/>
            <p:cNvPicPr>
              <a:picLocks noChangeAspect="1" noChangeArrowheads="1"/>
            </p:cNvPicPr>
            <p:nvPr/>
          </p:nvPicPr>
          <p:blipFill>
            <a:blip r:embed="rId5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548" y="2288"/>
              <a:ext cx="493" cy="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74" name="Picture 150"/>
            <p:cNvPicPr>
              <a:picLocks noChangeAspect="1" noChangeArrowheads="1"/>
            </p:cNvPicPr>
            <p:nvPr/>
          </p:nvPicPr>
          <p:blipFill>
            <a:blip r:embed="rId5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78" y="2704"/>
              <a:ext cx="198" cy="2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75" name="Picture 151"/>
            <p:cNvPicPr>
              <a:picLocks noChangeAspect="1" noChangeArrowheads="1"/>
            </p:cNvPicPr>
            <p:nvPr/>
          </p:nvPicPr>
          <p:blipFill>
            <a:blip r:embed="rId5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78" y="2704"/>
              <a:ext cx="198" cy="2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76" name="Picture 152"/>
            <p:cNvPicPr>
              <a:picLocks noChangeAspect="1" noChangeArrowheads="1"/>
            </p:cNvPicPr>
            <p:nvPr/>
          </p:nvPicPr>
          <p:blipFill>
            <a:blip r:embed="rId5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832" y="2722"/>
              <a:ext cx="172" cy="2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77" name="Picture 153"/>
            <p:cNvPicPr>
              <a:picLocks noChangeAspect="1" noChangeArrowheads="1"/>
            </p:cNvPicPr>
            <p:nvPr/>
          </p:nvPicPr>
          <p:blipFill>
            <a:blip r:embed="rId5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832" y="2722"/>
              <a:ext cx="172" cy="2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78" name="Picture 154"/>
            <p:cNvPicPr>
              <a:picLocks noChangeAspect="1" noChangeArrowheads="1"/>
            </p:cNvPicPr>
            <p:nvPr/>
          </p:nvPicPr>
          <p:blipFill>
            <a:blip r:embed="rId5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60" y="2746"/>
              <a:ext cx="186" cy="2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79" name="Picture 155"/>
            <p:cNvPicPr>
              <a:picLocks noChangeAspect="1" noChangeArrowheads="1"/>
            </p:cNvPicPr>
            <p:nvPr/>
          </p:nvPicPr>
          <p:blipFill>
            <a:blip r:embed="rId5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60" y="2746"/>
              <a:ext cx="186" cy="2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80" name="Picture 156"/>
            <p:cNvPicPr>
              <a:picLocks noChangeAspect="1" noChangeArrowheads="1"/>
            </p:cNvPicPr>
            <p:nvPr/>
          </p:nvPicPr>
          <p:blipFill>
            <a:blip r:embed="rId5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54" y="2708"/>
              <a:ext cx="173" cy="2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81" name="Picture 157"/>
            <p:cNvPicPr>
              <a:picLocks noChangeAspect="1" noChangeArrowheads="1"/>
            </p:cNvPicPr>
            <p:nvPr/>
          </p:nvPicPr>
          <p:blipFill>
            <a:blip r:embed="rId5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54" y="2708"/>
              <a:ext cx="173" cy="2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82" name="Picture 158"/>
            <p:cNvPicPr>
              <a:picLocks noChangeAspect="1" noChangeArrowheads="1"/>
            </p:cNvPicPr>
            <p:nvPr/>
          </p:nvPicPr>
          <p:blipFill>
            <a:blip r:embed="rId5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13" y="2731"/>
              <a:ext cx="186" cy="2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83" name="Picture 159"/>
            <p:cNvPicPr>
              <a:picLocks noChangeAspect="1" noChangeArrowheads="1"/>
            </p:cNvPicPr>
            <p:nvPr/>
          </p:nvPicPr>
          <p:blipFill>
            <a:blip r:embed="rId6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13" y="2731"/>
              <a:ext cx="186" cy="2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84" name="Picture 160"/>
            <p:cNvPicPr>
              <a:picLocks noChangeAspect="1" noChangeArrowheads="1"/>
            </p:cNvPicPr>
            <p:nvPr/>
          </p:nvPicPr>
          <p:blipFill>
            <a:blip r:embed="rId6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386" y="2689"/>
              <a:ext cx="199" cy="2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85" name="Picture 161"/>
            <p:cNvPicPr>
              <a:picLocks noChangeAspect="1" noChangeArrowheads="1"/>
            </p:cNvPicPr>
            <p:nvPr/>
          </p:nvPicPr>
          <p:blipFill>
            <a:blip r:embed="rId6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386" y="2689"/>
              <a:ext cx="199" cy="2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86" name="Picture 162"/>
            <p:cNvPicPr>
              <a:picLocks noChangeAspect="1" noChangeArrowheads="1"/>
            </p:cNvPicPr>
            <p:nvPr/>
          </p:nvPicPr>
          <p:blipFill>
            <a:blip r:embed="rId6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97" y="2694"/>
              <a:ext cx="198" cy="2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87" name="Picture 163"/>
            <p:cNvPicPr>
              <a:picLocks noChangeAspect="1" noChangeArrowheads="1"/>
            </p:cNvPicPr>
            <p:nvPr/>
          </p:nvPicPr>
          <p:blipFill>
            <a:blip r:embed="rId6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97" y="2694"/>
              <a:ext cx="198" cy="2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88" name="Picture 164"/>
            <p:cNvPicPr>
              <a:picLocks noChangeAspect="1" noChangeArrowheads="1"/>
            </p:cNvPicPr>
            <p:nvPr/>
          </p:nvPicPr>
          <p:blipFill>
            <a:blip r:embed="rId6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60" y="2712"/>
              <a:ext cx="173" cy="2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89" name="Picture 165"/>
            <p:cNvPicPr>
              <a:picLocks noChangeAspect="1" noChangeArrowheads="1"/>
            </p:cNvPicPr>
            <p:nvPr/>
          </p:nvPicPr>
          <p:blipFill>
            <a:blip r:embed="rId6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60" y="2712"/>
              <a:ext cx="173" cy="2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90" name="Picture 166"/>
            <p:cNvPicPr>
              <a:picLocks noChangeAspect="1" noChangeArrowheads="1"/>
            </p:cNvPicPr>
            <p:nvPr/>
          </p:nvPicPr>
          <p:blipFill>
            <a:blip r:embed="rId6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553" y="2685"/>
              <a:ext cx="467" cy="27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91" name="Picture 167"/>
            <p:cNvPicPr>
              <a:picLocks noChangeAspect="1" noChangeArrowheads="1"/>
            </p:cNvPicPr>
            <p:nvPr/>
          </p:nvPicPr>
          <p:blipFill>
            <a:blip r:embed="rId6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53" y="3108"/>
              <a:ext cx="713" cy="2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92" name="Picture 168"/>
            <p:cNvPicPr>
              <a:picLocks noChangeAspect="1" noChangeArrowheads="1"/>
            </p:cNvPicPr>
            <p:nvPr/>
          </p:nvPicPr>
          <p:blipFill>
            <a:blip r:embed="rId6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54" y="3105"/>
              <a:ext cx="173" cy="2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93" name="Picture 169"/>
            <p:cNvPicPr>
              <a:picLocks noChangeAspect="1" noChangeArrowheads="1"/>
            </p:cNvPicPr>
            <p:nvPr/>
          </p:nvPicPr>
          <p:blipFill>
            <a:blip r:embed="rId7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54" y="3105"/>
              <a:ext cx="173" cy="2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94" name="Picture 170"/>
            <p:cNvPicPr>
              <a:picLocks noChangeAspect="1" noChangeArrowheads="1"/>
            </p:cNvPicPr>
            <p:nvPr/>
          </p:nvPicPr>
          <p:blipFill>
            <a:blip r:embed="rId7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13" y="3127"/>
              <a:ext cx="186" cy="2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95" name="Picture 171"/>
            <p:cNvPicPr>
              <a:picLocks noChangeAspect="1" noChangeArrowheads="1"/>
            </p:cNvPicPr>
            <p:nvPr/>
          </p:nvPicPr>
          <p:blipFill>
            <a:blip r:embed="rId7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13" y="3127"/>
              <a:ext cx="186" cy="2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96" name="Picture 172"/>
            <p:cNvPicPr>
              <a:picLocks noChangeAspect="1" noChangeArrowheads="1"/>
            </p:cNvPicPr>
            <p:nvPr/>
          </p:nvPicPr>
          <p:blipFill>
            <a:blip r:embed="rId7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386" y="3086"/>
              <a:ext cx="199" cy="2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97" name="Picture 173"/>
            <p:cNvPicPr>
              <a:picLocks noChangeAspect="1" noChangeArrowheads="1"/>
            </p:cNvPicPr>
            <p:nvPr/>
          </p:nvPicPr>
          <p:blipFill>
            <a:blip r:embed="rId7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386" y="3086"/>
              <a:ext cx="199" cy="2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98" name="Picture 174"/>
            <p:cNvPicPr>
              <a:picLocks noChangeAspect="1" noChangeArrowheads="1"/>
            </p:cNvPicPr>
            <p:nvPr/>
          </p:nvPicPr>
          <p:blipFill>
            <a:blip r:embed="rId7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91" y="3105"/>
              <a:ext cx="173" cy="2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99" name="Picture 175"/>
            <p:cNvPicPr>
              <a:picLocks noChangeAspect="1" noChangeArrowheads="1"/>
            </p:cNvPicPr>
            <p:nvPr/>
          </p:nvPicPr>
          <p:blipFill>
            <a:blip r:embed="rId7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91" y="3105"/>
              <a:ext cx="173" cy="2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200" name="Picture 176"/>
            <p:cNvPicPr>
              <a:picLocks noChangeAspect="1" noChangeArrowheads="1"/>
            </p:cNvPicPr>
            <p:nvPr/>
          </p:nvPicPr>
          <p:blipFill>
            <a:blip r:embed="rId7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29" y="3086"/>
              <a:ext cx="199" cy="2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201" name="Picture 177"/>
            <p:cNvPicPr>
              <a:picLocks noChangeAspect="1" noChangeArrowheads="1"/>
            </p:cNvPicPr>
            <p:nvPr/>
          </p:nvPicPr>
          <p:blipFill>
            <a:blip r:embed="rId7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29" y="3086"/>
              <a:ext cx="199" cy="2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202" name="Picture 178"/>
            <p:cNvPicPr>
              <a:picLocks noChangeAspect="1" noChangeArrowheads="1"/>
            </p:cNvPicPr>
            <p:nvPr/>
          </p:nvPicPr>
          <p:blipFill>
            <a:blip r:embed="rId7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579" y="3086"/>
              <a:ext cx="198" cy="2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203" name="Picture 179"/>
            <p:cNvPicPr>
              <a:picLocks noChangeAspect="1" noChangeArrowheads="1"/>
            </p:cNvPicPr>
            <p:nvPr/>
          </p:nvPicPr>
          <p:blipFill>
            <a:blip r:embed="rId8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579" y="3086"/>
              <a:ext cx="198" cy="2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204" name="Picture 180"/>
            <p:cNvPicPr>
              <a:picLocks noChangeAspect="1" noChangeArrowheads="1"/>
            </p:cNvPicPr>
            <p:nvPr/>
          </p:nvPicPr>
          <p:blipFill>
            <a:blip r:embed="rId8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843" y="3127"/>
              <a:ext cx="185" cy="2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205" name="Picture 181"/>
            <p:cNvPicPr>
              <a:picLocks noChangeAspect="1" noChangeArrowheads="1"/>
            </p:cNvPicPr>
            <p:nvPr/>
          </p:nvPicPr>
          <p:blipFill>
            <a:blip r:embed="rId8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843" y="3127"/>
              <a:ext cx="185" cy="2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2711022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2" name="表格 9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06420485"/>
              </p:ext>
            </p:extLst>
          </p:nvPr>
        </p:nvGraphicFramePr>
        <p:xfrm>
          <a:off x="2915598" y="1749668"/>
          <a:ext cx="6989885" cy="2523394"/>
        </p:xfrm>
        <a:graphic>
          <a:graphicData uri="http://schemas.openxmlformats.org/drawingml/2006/table">
            <a:tbl>
              <a:tblPr firstRow="1" firstCol="1" bandRow="1"/>
              <a:tblGrid>
                <a:gridCol w="1251650"/>
                <a:gridCol w="2673905"/>
                <a:gridCol w="1311527"/>
                <a:gridCol w="1752803"/>
              </a:tblGrid>
              <a:tr h="739797"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dirty="0">
                          <a:effectLst/>
                          <a:latin typeface="Times New Roman"/>
                          <a:ea typeface="宋体"/>
                          <a:cs typeface="Times New Roman"/>
                        </a:rPr>
                        <a:t>Group</a:t>
                      </a:r>
                      <a:endParaRPr lang="zh-CN" sz="1800" dirty="0">
                        <a:effectLst/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dirty="0">
                          <a:effectLst/>
                          <a:latin typeface="Times New Roman"/>
                          <a:ea typeface="宋体"/>
                          <a:cs typeface="Times New Roman"/>
                        </a:rPr>
                        <a:t>Conditions</a:t>
                      </a:r>
                      <a:endParaRPr lang="zh-CN" sz="1800" dirty="0">
                        <a:effectLst/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>
                          <a:effectLst/>
                          <a:latin typeface="Times New Roman"/>
                          <a:ea typeface="宋体"/>
                          <a:cs typeface="Times New Roman"/>
                        </a:rPr>
                        <a:t>N (male)</a:t>
                      </a:r>
                      <a:endParaRPr lang="zh-CN" sz="1800">
                        <a:effectLst/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>
                          <a:effectLst/>
                          <a:latin typeface="Times New Roman"/>
                          <a:ea typeface="宋体"/>
                          <a:cs typeface="Times New Roman"/>
                        </a:rPr>
                        <a:t>N (female)</a:t>
                      </a:r>
                      <a:endParaRPr lang="zh-CN" sz="1800">
                        <a:effectLst/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08712"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>
                          <a:effectLst/>
                          <a:latin typeface="Times New Roman"/>
                          <a:ea typeface="宋体"/>
                          <a:cs typeface="Times New Roman"/>
                        </a:rPr>
                        <a:t>1</a:t>
                      </a:r>
                      <a:endParaRPr lang="zh-CN" sz="1800">
                        <a:effectLst/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dirty="0">
                          <a:effectLst/>
                          <a:latin typeface="Times New Roman"/>
                          <a:ea typeface="宋体"/>
                          <a:cs typeface="Times New Roman"/>
                        </a:rPr>
                        <a:t>no retrieval</a:t>
                      </a:r>
                      <a:endParaRPr lang="zh-CN" sz="1800" dirty="0">
                        <a:effectLst/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>
                          <a:effectLst/>
                          <a:latin typeface="Times New Roman"/>
                          <a:ea typeface="宋体"/>
                          <a:cs typeface="Times New Roman"/>
                        </a:rPr>
                        <a:t>9</a:t>
                      </a:r>
                      <a:endParaRPr lang="zh-CN" sz="1800">
                        <a:effectLst/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>
                          <a:effectLst/>
                          <a:latin typeface="Times New Roman"/>
                          <a:ea typeface="宋体"/>
                          <a:cs typeface="Times New Roman"/>
                        </a:rPr>
                        <a:t>11</a:t>
                      </a:r>
                      <a:endParaRPr lang="zh-CN" sz="1800">
                        <a:effectLst/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415034"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>
                          <a:effectLst/>
                          <a:latin typeface="Times New Roman"/>
                          <a:ea typeface="宋体"/>
                          <a:cs typeface="Times New Roman"/>
                        </a:rPr>
                        <a:t>2</a:t>
                      </a:r>
                      <a:endParaRPr lang="zh-CN" sz="1800">
                        <a:effectLst/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>
                          <a:effectLst/>
                          <a:latin typeface="Times New Roman"/>
                          <a:ea typeface="宋体"/>
                          <a:cs typeface="Times New Roman"/>
                        </a:rPr>
                        <a:t>1/3 repetition retrieval </a:t>
                      </a:r>
                      <a:endParaRPr lang="zh-CN" sz="1800">
                        <a:effectLst/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>
                          <a:effectLst/>
                          <a:latin typeface="Times New Roman"/>
                          <a:ea typeface="宋体"/>
                          <a:cs typeface="Times New Roman"/>
                        </a:rPr>
                        <a:t>8</a:t>
                      </a:r>
                      <a:endParaRPr lang="zh-CN" sz="1800">
                        <a:effectLst/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>
                          <a:effectLst/>
                          <a:latin typeface="Times New Roman"/>
                          <a:ea typeface="宋体"/>
                          <a:cs typeface="Times New Roman"/>
                        </a:rPr>
                        <a:t>12</a:t>
                      </a:r>
                      <a:endParaRPr lang="zh-CN" sz="1800">
                        <a:effectLst/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15034"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>
                          <a:effectLst/>
                          <a:latin typeface="Times New Roman"/>
                          <a:ea typeface="宋体"/>
                          <a:cs typeface="Times New Roman"/>
                        </a:rPr>
                        <a:t>3</a:t>
                      </a:r>
                      <a:endParaRPr lang="zh-CN" sz="1800">
                        <a:effectLst/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>
                          <a:effectLst/>
                          <a:latin typeface="Times New Roman"/>
                          <a:ea typeface="宋体"/>
                          <a:cs typeface="Times New Roman"/>
                        </a:rPr>
                        <a:t>2/3 repetition retrieval</a:t>
                      </a:r>
                      <a:endParaRPr lang="zh-CN" sz="1800">
                        <a:effectLst/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>
                          <a:effectLst/>
                          <a:latin typeface="Times New Roman"/>
                          <a:ea typeface="宋体"/>
                          <a:cs typeface="Times New Roman"/>
                        </a:rPr>
                        <a:t>8</a:t>
                      </a:r>
                      <a:endParaRPr lang="zh-CN" sz="1800">
                        <a:effectLst/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>
                          <a:effectLst/>
                          <a:latin typeface="Times New Roman"/>
                          <a:ea typeface="宋体"/>
                          <a:cs typeface="Times New Roman"/>
                        </a:rPr>
                        <a:t>12</a:t>
                      </a:r>
                      <a:endParaRPr lang="zh-CN" sz="1800">
                        <a:effectLst/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44817"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dirty="0">
                          <a:effectLst/>
                          <a:latin typeface="Times New Roman"/>
                          <a:ea typeface="宋体"/>
                          <a:cs typeface="Times New Roman"/>
                        </a:rPr>
                        <a:t>4</a:t>
                      </a:r>
                      <a:endParaRPr lang="zh-CN" sz="1800" dirty="0">
                        <a:effectLst/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dirty="0">
                          <a:effectLst/>
                          <a:latin typeface="Times New Roman"/>
                          <a:ea typeface="宋体"/>
                          <a:cs typeface="Times New Roman"/>
                        </a:rPr>
                        <a:t>whole repetition retrieval</a:t>
                      </a:r>
                      <a:endParaRPr lang="zh-CN" sz="1800" dirty="0">
                        <a:effectLst/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>
                          <a:effectLst/>
                          <a:latin typeface="Times New Roman"/>
                          <a:ea typeface="宋体"/>
                          <a:cs typeface="Times New Roman"/>
                        </a:rPr>
                        <a:t>8</a:t>
                      </a:r>
                      <a:endParaRPr lang="zh-CN" sz="1800">
                        <a:effectLst/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2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dirty="0">
                          <a:effectLst/>
                          <a:latin typeface="Times New Roman"/>
                          <a:ea typeface="宋体"/>
                          <a:cs typeface="Times New Roman"/>
                        </a:rPr>
                        <a:t>12</a:t>
                      </a:r>
                      <a:endParaRPr lang="zh-CN" sz="1800" dirty="0">
                        <a:effectLst/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93" name="Rectangle 90"/>
          <p:cNvSpPr>
            <a:spLocks noChangeArrowheads="1"/>
          </p:cNvSpPr>
          <p:nvPr/>
        </p:nvSpPr>
        <p:spPr bwMode="auto">
          <a:xfrm>
            <a:off x="3017660" y="1136174"/>
            <a:ext cx="6627503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357188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1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umber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participants in each group after exclusion </a:t>
            </a:r>
          </a:p>
          <a:p>
            <a:pPr marL="0" marR="0" lvl="0" indent="357188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en-US" altLang="zh-C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1456092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782375" y="741261"/>
            <a:ext cx="10581629" cy="4268859"/>
            <a:chOff x="577102" y="1447475"/>
            <a:chExt cx="10581629" cy="4268859"/>
          </a:xfrm>
        </p:grpSpPr>
        <p:grpSp>
          <p:nvGrpSpPr>
            <p:cNvPr id="3" name="组合 2"/>
            <p:cNvGrpSpPr/>
            <p:nvPr/>
          </p:nvGrpSpPr>
          <p:grpSpPr>
            <a:xfrm>
              <a:off x="577102" y="1447475"/>
              <a:ext cx="10581629" cy="4268859"/>
              <a:chOff x="330359" y="1418109"/>
              <a:chExt cx="10581629" cy="4268859"/>
            </a:xfrm>
          </p:grpSpPr>
          <p:grpSp>
            <p:nvGrpSpPr>
              <p:cNvPr id="5" name="组合 4"/>
              <p:cNvGrpSpPr/>
              <p:nvPr/>
            </p:nvGrpSpPr>
            <p:grpSpPr>
              <a:xfrm>
                <a:off x="330359" y="2050681"/>
                <a:ext cx="1963183" cy="3632200"/>
                <a:chOff x="354831" y="2260601"/>
                <a:chExt cx="1963183" cy="3632200"/>
              </a:xfrm>
            </p:grpSpPr>
            <p:sp>
              <p:nvSpPr>
                <p:cNvPr id="47" name="矩形 46"/>
                <p:cNvSpPr/>
                <p:nvPr/>
              </p:nvSpPr>
              <p:spPr>
                <a:xfrm>
                  <a:off x="354831" y="2260601"/>
                  <a:ext cx="1705650" cy="3632200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48" name="文本框 47"/>
                <p:cNvSpPr txBox="1"/>
                <p:nvPr/>
              </p:nvSpPr>
              <p:spPr>
                <a:xfrm>
                  <a:off x="364098" y="3263815"/>
                  <a:ext cx="1953916" cy="147732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endParaRPr lang="en-US" altLang="zh-CN" dirty="0"/>
                </a:p>
                <a:p>
                  <a:r>
                    <a:rPr lang="en-US" altLang="zh-CN" sz="2400" dirty="0"/>
                    <a:t>20CSs+</a:t>
                  </a:r>
                </a:p>
                <a:p>
                  <a:r>
                    <a:rPr lang="en-US" altLang="zh-CN" sz="2400" dirty="0"/>
                    <a:t>(</a:t>
                  </a:r>
                  <a:r>
                    <a:rPr lang="en-US" altLang="zh-CN" sz="2400" dirty="0" smtClean="0"/>
                    <a:t>60% Shock</a:t>
                  </a:r>
                  <a:r>
                    <a:rPr lang="en-US" altLang="zh-CN" sz="2400" dirty="0"/>
                    <a:t>)</a:t>
                  </a:r>
                </a:p>
                <a:p>
                  <a:r>
                    <a:rPr lang="en-US" altLang="zh-CN" sz="2400" dirty="0"/>
                    <a:t>8CSs-</a:t>
                  </a:r>
                </a:p>
              </p:txBody>
            </p:sp>
            <p:sp>
              <p:nvSpPr>
                <p:cNvPr id="49" name="文本框 48"/>
                <p:cNvSpPr txBox="1"/>
                <p:nvPr/>
              </p:nvSpPr>
              <p:spPr>
                <a:xfrm>
                  <a:off x="644132" y="2458856"/>
                  <a:ext cx="1284951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b="1" dirty="0"/>
                    <a:t>Acquisition</a:t>
                  </a:r>
                  <a:endParaRPr lang="zh-CN" altLang="en-US" b="1" dirty="0"/>
                </a:p>
              </p:txBody>
            </p:sp>
          </p:grpSp>
          <p:grpSp>
            <p:nvGrpSpPr>
              <p:cNvPr id="6" name="组合 5"/>
              <p:cNvGrpSpPr/>
              <p:nvPr/>
            </p:nvGrpSpPr>
            <p:grpSpPr>
              <a:xfrm>
                <a:off x="2233309" y="2054768"/>
                <a:ext cx="3281118" cy="3632200"/>
                <a:chOff x="2233309" y="2054768"/>
                <a:chExt cx="3281118" cy="3632200"/>
              </a:xfrm>
            </p:grpSpPr>
            <p:sp>
              <p:nvSpPr>
                <p:cNvPr id="33" name="矩形 32"/>
                <p:cNvSpPr/>
                <p:nvPr/>
              </p:nvSpPr>
              <p:spPr>
                <a:xfrm>
                  <a:off x="2233309" y="2054768"/>
                  <a:ext cx="3281118" cy="3632200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grpSp>
              <p:nvGrpSpPr>
                <p:cNvPr id="34" name="组合 33"/>
                <p:cNvGrpSpPr/>
                <p:nvPr/>
              </p:nvGrpSpPr>
              <p:grpSpPr>
                <a:xfrm>
                  <a:off x="2335758" y="2960621"/>
                  <a:ext cx="2900186" cy="2001125"/>
                  <a:chOff x="2555354" y="3188939"/>
                  <a:chExt cx="2900186" cy="2001125"/>
                </a:xfrm>
              </p:grpSpPr>
              <p:sp>
                <p:nvSpPr>
                  <p:cNvPr id="37" name="文本框 36"/>
                  <p:cNvSpPr txBox="1"/>
                  <p:nvPr/>
                </p:nvSpPr>
                <p:spPr>
                  <a:xfrm>
                    <a:off x="2555354" y="3422390"/>
                    <a:ext cx="750315" cy="156966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2400" dirty="0"/>
                      <a:t>No</a:t>
                    </a:r>
                  </a:p>
                  <a:p>
                    <a:r>
                      <a:rPr lang="en-US" altLang="zh-CN" sz="2400" dirty="0"/>
                      <a:t>1/3</a:t>
                    </a:r>
                  </a:p>
                  <a:p>
                    <a:r>
                      <a:rPr lang="en-US" altLang="zh-CN" sz="2400" dirty="0"/>
                      <a:t>2/3</a:t>
                    </a:r>
                  </a:p>
                  <a:p>
                    <a:r>
                      <a:rPr lang="en-US" altLang="zh-CN" sz="2400" dirty="0"/>
                      <a:t>3/3</a:t>
                    </a:r>
                  </a:p>
                </p:txBody>
              </p:sp>
              <p:cxnSp>
                <p:nvCxnSpPr>
                  <p:cNvPr id="38" name="直接箭头连接符 37"/>
                  <p:cNvCxnSpPr/>
                  <p:nvPr/>
                </p:nvCxnSpPr>
                <p:spPr>
                  <a:xfrm>
                    <a:off x="3341527" y="4236434"/>
                    <a:ext cx="578427" cy="0"/>
                  </a:xfrm>
                  <a:prstGeom prst="straightConnector1">
                    <a:avLst/>
                  </a:prstGeom>
                  <a:ln w="254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39" name="组合 38"/>
                  <p:cNvGrpSpPr/>
                  <p:nvPr/>
                </p:nvGrpSpPr>
                <p:grpSpPr>
                  <a:xfrm>
                    <a:off x="4220873" y="4124592"/>
                    <a:ext cx="1019175" cy="155136"/>
                    <a:chOff x="4650848" y="4112063"/>
                    <a:chExt cx="1019175" cy="155136"/>
                  </a:xfrm>
                </p:grpSpPr>
                <p:cxnSp>
                  <p:nvCxnSpPr>
                    <p:cNvPr id="44" name="直接连接符 43"/>
                    <p:cNvCxnSpPr/>
                    <p:nvPr/>
                  </p:nvCxnSpPr>
                  <p:spPr>
                    <a:xfrm>
                      <a:off x="4650848" y="4189631"/>
                      <a:ext cx="1016527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5" name="直接连接符 44"/>
                    <p:cNvCxnSpPr/>
                    <p:nvPr/>
                  </p:nvCxnSpPr>
                  <p:spPr>
                    <a:xfrm flipV="1">
                      <a:off x="4650848" y="4112063"/>
                      <a:ext cx="0" cy="155136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6" name="直接连接符 45"/>
                    <p:cNvCxnSpPr/>
                    <p:nvPr/>
                  </p:nvCxnSpPr>
                  <p:spPr>
                    <a:xfrm flipV="1">
                      <a:off x="5670023" y="4112063"/>
                      <a:ext cx="0" cy="155136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40" name="文本框 39"/>
                  <p:cNvSpPr txBox="1"/>
                  <p:nvPr/>
                </p:nvSpPr>
                <p:spPr>
                  <a:xfrm>
                    <a:off x="3207010" y="3836324"/>
                    <a:ext cx="881768" cy="4001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2000" dirty="0"/>
                      <a:t>10min</a:t>
                    </a:r>
                  </a:p>
                </p:txBody>
              </p:sp>
              <p:cxnSp>
                <p:nvCxnSpPr>
                  <p:cNvPr id="41" name="直接连接符 40"/>
                  <p:cNvCxnSpPr/>
                  <p:nvPr/>
                </p:nvCxnSpPr>
                <p:spPr>
                  <a:xfrm>
                    <a:off x="4088778" y="3188939"/>
                    <a:ext cx="0" cy="2001125"/>
                  </a:xfrm>
                  <a:prstGeom prst="line">
                    <a:avLst/>
                  </a:prstGeom>
                  <a:ln w="158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2" name="文本框 41"/>
                  <p:cNvSpPr txBox="1"/>
                  <p:nvPr/>
                </p:nvSpPr>
                <p:spPr>
                  <a:xfrm>
                    <a:off x="4372027" y="4214690"/>
                    <a:ext cx="1083513" cy="4001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2000" dirty="0"/>
                      <a:t>9CSs-</a:t>
                    </a:r>
                  </a:p>
                </p:txBody>
              </p:sp>
              <p:sp>
                <p:nvSpPr>
                  <p:cNvPr id="43" name="文本框 42"/>
                  <p:cNvSpPr txBox="1"/>
                  <p:nvPr/>
                </p:nvSpPr>
                <p:spPr>
                  <a:xfrm>
                    <a:off x="4372027" y="3820298"/>
                    <a:ext cx="1034177" cy="4001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2000" dirty="0"/>
                      <a:t>8CSs+</a:t>
                    </a:r>
                  </a:p>
                </p:txBody>
              </p:sp>
            </p:grpSp>
            <p:sp>
              <p:nvSpPr>
                <p:cNvPr id="35" name="文本框 34"/>
                <p:cNvSpPr txBox="1"/>
                <p:nvPr/>
              </p:nvSpPr>
              <p:spPr>
                <a:xfrm>
                  <a:off x="2372523" y="2234483"/>
                  <a:ext cx="1127046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b="1" dirty="0"/>
                    <a:t>Retrieval</a:t>
                  </a:r>
                  <a:endParaRPr lang="zh-CN" altLang="en-US" b="1" dirty="0"/>
                </a:p>
              </p:txBody>
            </p:sp>
            <p:sp>
              <p:nvSpPr>
                <p:cNvPr id="36" name="文本框 35"/>
                <p:cNvSpPr txBox="1"/>
                <p:nvPr/>
              </p:nvSpPr>
              <p:spPr>
                <a:xfrm>
                  <a:off x="4007777" y="2234483"/>
                  <a:ext cx="1164257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b="1" dirty="0"/>
                    <a:t>Extinction</a:t>
                  </a:r>
                  <a:endParaRPr lang="zh-CN" altLang="en-US" b="1" dirty="0"/>
                </a:p>
              </p:txBody>
            </p:sp>
          </p:grpSp>
          <p:grpSp>
            <p:nvGrpSpPr>
              <p:cNvPr id="7" name="组合 6"/>
              <p:cNvGrpSpPr/>
              <p:nvPr/>
            </p:nvGrpSpPr>
            <p:grpSpPr>
              <a:xfrm>
                <a:off x="5681800" y="2050681"/>
                <a:ext cx="5230188" cy="3632200"/>
                <a:chOff x="5681800" y="2050681"/>
                <a:chExt cx="5230188" cy="3632200"/>
              </a:xfrm>
            </p:grpSpPr>
            <p:grpSp>
              <p:nvGrpSpPr>
                <p:cNvPr id="11" name="组合 10"/>
                <p:cNvGrpSpPr/>
                <p:nvPr/>
              </p:nvGrpSpPr>
              <p:grpSpPr>
                <a:xfrm>
                  <a:off x="5681800" y="2050681"/>
                  <a:ext cx="5230188" cy="3632200"/>
                  <a:chOff x="5681800" y="2050681"/>
                  <a:chExt cx="5230188" cy="3632200"/>
                </a:xfrm>
              </p:grpSpPr>
              <p:sp>
                <p:nvSpPr>
                  <p:cNvPr id="13" name="矩形 12"/>
                  <p:cNvSpPr/>
                  <p:nvPr/>
                </p:nvSpPr>
                <p:spPr>
                  <a:xfrm>
                    <a:off x="5681800" y="2050681"/>
                    <a:ext cx="5230188" cy="3632200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grpSp>
                <p:nvGrpSpPr>
                  <p:cNvPr id="14" name="组合 13"/>
                  <p:cNvGrpSpPr/>
                  <p:nvPr/>
                </p:nvGrpSpPr>
                <p:grpSpPr>
                  <a:xfrm>
                    <a:off x="6135354" y="3866781"/>
                    <a:ext cx="1019175" cy="155136"/>
                    <a:chOff x="4650848" y="4112063"/>
                    <a:chExt cx="1019175" cy="155136"/>
                  </a:xfrm>
                </p:grpSpPr>
                <p:cxnSp>
                  <p:nvCxnSpPr>
                    <p:cNvPr id="30" name="直接连接符 29"/>
                    <p:cNvCxnSpPr/>
                    <p:nvPr/>
                  </p:nvCxnSpPr>
                  <p:spPr>
                    <a:xfrm>
                      <a:off x="4650848" y="4186691"/>
                      <a:ext cx="1016527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1" name="直接连接符 30"/>
                    <p:cNvCxnSpPr/>
                    <p:nvPr/>
                  </p:nvCxnSpPr>
                  <p:spPr>
                    <a:xfrm flipV="1">
                      <a:off x="4650848" y="4112063"/>
                      <a:ext cx="0" cy="155136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2" name="直接连接符 31"/>
                    <p:cNvCxnSpPr/>
                    <p:nvPr/>
                  </p:nvCxnSpPr>
                  <p:spPr>
                    <a:xfrm flipV="1">
                      <a:off x="5670023" y="4112063"/>
                      <a:ext cx="0" cy="155136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15" name="文本框 14"/>
                  <p:cNvSpPr txBox="1"/>
                  <p:nvPr/>
                </p:nvSpPr>
                <p:spPr>
                  <a:xfrm>
                    <a:off x="7247494" y="3525188"/>
                    <a:ext cx="594273" cy="4001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2000" dirty="0"/>
                      <a:t>18s</a:t>
                    </a:r>
                  </a:p>
                </p:txBody>
              </p:sp>
              <p:sp>
                <p:nvSpPr>
                  <p:cNvPr id="16" name="文本框 15"/>
                  <p:cNvSpPr txBox="1"/>
                  <p:nvPr/>
                </p:nvSpPr>
                <p:spPr>
                  <a:xfrm>
                    <a:off x="7999240" y="3755879"/>
                    <a:ext cx="705354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2400" dirty="0"/>
                      <a:t>4US</a:t>
                    </a:r>
                  </a:p>
                </p:txBody>
              </p:sp>
              <p:cxnSp>
                <p:nvCxnSpPr>
                  <p:cNvPr id="17" name="直接箭头连接符 16"/>
                  <p:cNvCxnSpPr/>
                  <p:nvPr/>
                </p:nvCxnSpPr>
                <p:spPr>
                  <a:xfrm>
                    <a:off x="8746102" y="3978902"/>
                    <a:ext cx="578427" cy="0"/>
                  </a:xfrm>
                  <a:prstGeom prst="straightConnector1">
                    <a:avLst/>
                  </a:prstGeom>
                  <a:ln w="254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18" name="组合 17"/>
                  <p:cNvGrpSpPr/>
                  <p:nvPr/>
                </p:nvGrpSpPr>
                <p:grpSpPr>
                  <a:xfrm>
                    <a:off x="9548721" y="3873973"/>
                    <a:ext cx="1019175" cy="155136"/>
                    <a:chOff x="4650848" y="4112063"/>
                    <a:chExt cx="1019175" cy="155136"/>
                  </a:xfrm>
                </p:grpSpPr>
                <p:cxnSp>
                  <p:nvCxnSpPr>
                    <p:cNvPr id="27" name="直接连接符 26"/>
                    <p:cNvCxnSpPr/>
                    <p:nvPr/>
                  </p:nvCxnSpPr>
                  <p:spPr>
                    <a:xfrm>
                      <a:off x="4650848" y="4189631"/>
                      <a:ext cx="1016527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8" name="直接连接符 27"/>
                    <p:cNvCxnSpPr/>
                    <p:nvPr/>
                  </p:nvCxnSpPr>
                  <p:spPr>
                    <a:xfrm flipV="1">
                      <a:off x="4650848" y="4112063"/>
                      <a:ext cx="0" cy="155136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9" name="直接连接符 28"/>
                    <p:cNvCxnSpPr/>
                    <p:nvPr/>
                  </p:nvCxnSpPr>
                  <p:spPr>
                    <a:xfrm flipV="1">
                      <a:off x="5670023" y="4112063"/>
                      <a:ext cx="0" cy="155136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19" name="直接连接符 18"/>
                  <p:cNvCxnSpPr/>
                  <p:nvPr/>
                </p:nvCxnSpPr>
                <p:spPr>
                  <a:xfrm>
                    <a:off x="7860466" y="2923294"/>
                    <a:ext cx="0" cy="2001125"/>
                  </a:xfrm>
                  <a:prstGeom prst="line">
                    <a:avLst/>
                  </a:prstGeom>
                  <a:ln w="158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0" name="文本框 19"/>
                  <p:cNvSpPr txBox="1"/>
                  <p:nvPr/>
                </p:nvSpPr>
                <p:spPr>
                  <a:xfrm>
                    <a:off x="8474932" y="2313373"/>
                    <a:ext cx="2243638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b="1" dirty="0"/>
                      <a:t>Reinstatement Test</a:t>
                    </a:r>
                    <a:endParaRPr lang="zh-CN" altLang="en-US" b="1" dirty="0"/>
                  </a:p>
                </p:txBody>
              </p:sp>
              <p:sp>
                <p:nvSpPr>
                  <p:cNvPr id="21" name="文本框 20"/>
                  <p:cNvSpPr txBox="1"/>
                  <p:nvPr/>
                </p:nvSpPr>
                <p:spPr>
                  <a:xfrm>
                    <a:off x="6085436" y="2151336"/>
                    <a:ext cx="1478583" cy="92333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b="1" dirty="0"/>
                      <a:t>Spontaneous</a:t>
                    </a:r>
                  </a:p>
                  <a:p>
                    <a:pPr algn="ctr"/>
                    <a:r>
                      <a:rPr lang="en-US" altLang="zh-CN" b="1" dirty="0"/>
                      <a:t>Recovery</a:t>
                    </a:r>
                  </a:p>
                  <a:p>
                    <a:pPr algn="ctr"/>
                    <a:r>
                      <a:rPr lang="en-US" altLang="zh-CN" b="1" dirty="0"/>
                      <a:t>Test</a:t>
                    </a:r>
                    <a:endParaRPr lang="zh-CN" altLang="en-US" b="1" dirty="0"/>
                  </a:p>
                </p:txBody>
              </p:sp>
              <p:sp>
                <p:nvSpPr>
                  <p:cNvPr id="22" name="文本框 21"/>
                  <p:cNvSpPr txBox="1"/>
                  <p:nvPr/>
                </p:nvSpPr>
                <p:spPr>
                  <a:xfrm>
                    <a:off x="9711556" y="3571213"/>
                    <a:ext cx="930933" cy="4001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2000" dirty="0"/>
                      <a:t>9CSs+</a:t>
                    </a:r>
                  </a:p>
                </p:txBody>
              </p:sp>
              <p:sp>
                <p:nvSpPr>
                  <p:cNvPr id="23" name="文本框 22"/>
                  <p:cNvSpPr txBox="1"/>
                  <p:nvPr/>
                </p:nvSpPr>
                <p:spPr>
                  <a:xfrm>
                    <a:off x="6207501" y="3496163"/>
                    <a:ext cx="1002569" cy="4001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2000" dirty="0"/>
                      <a:t>8CSs+</a:t>
                    </a:r>
                  </a:p>
                </p:txBody>
              </p:sp>
              <p:sp>
                <p:nvSpPr>
                  <p:cNvPr id="24" name="文本框 23"/>
                  <p:cNvSpPr txBox="1"/>
                  <p:nvPr/>
                </p:nvSpPr>
                <p:spPr>
                  <a:xfrm>
                    <a:off x="6245560" y="4034213"/>
                    <a:ext cx="1020648" cy="4001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2000" dirty="0"/>
                      <a:t>8CSs-</a:t>
                    </a:r>
                  </a:p>
                </p:txBody>
              </p:sp>
              <p:sp>
                <p:nvSpPr>
                  <p:cNvPr id="25" name="文本框 24"/>
                  <p:cNvSpPr txBox="1"/>
                  <p:nvPr/>
                </p:nvSpPr>
                <p:spPr>
                  <a:xfrm>
                    <a:off x="9737071" y="3978902"/>
                    <a:ext cx="1020648" cy="4001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2000" dirty="0"/>
                      <a:t>9CSs-</a:t>
                    </a:r>
                  </a:p>
                </p:txBody>
              </p:sp>
              <p:sp>
                <p:nvSpPr>
                  <p:cNvPr id="26" name="文本框 25"/>
                  <p:cNvSpPr txBox="1"/>
                  <p:nvPr/>
                </p:nvSpPr>
                <p:spPr>
                  <a:xfrm>
                    <a:off x="8701034" y="3608006"/>
                    <a:ext cx="881768" cy="4001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2000" dirty="0"/>
                      <a:t>5min</a:t>
                    </a:r>
                  </a:p>
                </p:txBody>
              </p:sp>
            </p:grpSp>
            <p:cxnSp>
              <p:nvCxnSpPr>
                <p:cNvPr id="12" name="直接箭头连接符 11"/>
                <p:cNvCxnSpPr/>
                <p:nvPr/>
              </p:nvCxnSpPr>
              <p:spPr>
                <a:xfrm>
                  <a:off x="7370056" y="3941409"/>
                  <a:ext cx="387927" cy="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8" name="文本框 7"/>
              <p:cNvSpPr txBox="1"/>
              <p:nvPr/>
            </p:nvSpPr>
            <p:spPr>
              <a:xfrm>
                <a:off x="777565" y="1492604"/>
                <a:ext cx="1127046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400" b="1" dirty="0"/>
                  <a:t>Day1</a:t>
                </a:r>
                <a:endParaRPr lang="zh-CN" altLang="en-US" sz="2400" b="1" dirty="0"/>
              </a:p>
            </p:txBody>
          </p:sp>
          <p:sp>
            <p:nvSpPr>
              <p:cNvPr id="9" name="文本框 8"/>
              <p:cNvSpPr txBox="1"/>
              <p:nvPr/>
            </p:nvSpPr>
            <p:spPr>
              <a:xfrm>
                <a:off x="3542473" y="1492604"/>
                <a:ext cx="1127046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400" b="1" dirty="0"/>
                  <a:t>Day2</a:t>
                </a:r>
                <a:endParaRPr lang="zh-CN" altLang="en-US" sz="2400" b="1" dirty="0"/>
              </a:p>
            </p:txBody>
          </p:sp>
          <p:sp>
            <p:nvSpPr>
              <p:cNvPr id="10" name="文本框 9"/>
              <p:cNvSpPr txBox="1"/>
              <p:nvPr/>
            </p:nvSpPr>
            <p:spPr>
              <a:xfrm>
                <a:off x="7788394" y="1418109"/>
                <a:ext cx="1127046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400" b="1" dirty="0"/>
                  <a:t>Day3</a:t>
                </a:r>
                <a:endParaRPr lang="zh-CN" altLang="en-US" sz="2400" b="1" dirty="0"/>
              </a:p>
            </p:txBody>
          </p:sp>
        </p:grpSp>
        <p:sp>
          <p:nvSpPr>
            <p:cNvPr id="4" name="闪电形 3"/>
            <p:cNvSpPr/>
            <p:nvPr/>
          </p:nvSpPr>
          <p:spPr>
            <a:xfrm flipH="1">
              <a:off x="8536724" y="3122240"/>
              <a:ext cx="292087" cy="638629"/>
            </a:xfrm>
            <a:prstGeom prst="lightningBolt">
              <a:avLst/>
            </a:prstGeom>
            <a:solidFill>
              <a:srgbClr val="FFFF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50" name="TextBox 49"/>
          <p:cNvSpPr txBox="1"/>
          <p:nvPr/>
        </p:nvSpPr>
        <p:spPr>
          <a:xfrm>
            <a:off x="1595483" y="5240000"/>
            <a:ext cx="9499022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1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 Schematic representation of the experimental design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zh-CN" dirty="0"/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During acquisition, 20 trials of CS were presented to participants with a reinforcement ratio of 60%, which were: 12 CS+ accompanied by an electric shock; 8 CS+ without an electric shock; 8 CS− without an electric shock. During extinction, 8 CS+ and 9 CS− were presented, all with no shock. The first CS− trial in each phase was disregarded due to the orientation response at the beginning of the session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6738771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图表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57014889"/>
              </p:ext>
            </p:extLst>
          </p:nvPr>
        </p:nvGraphicFramePr>
        <p:xfrm>
          <a:off x="0" y="1716881"/>
          <a:ext cx="12192000" cy="34242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文本框 1"/>
          <p:cNvSpPr txBox="1"/>
          <p:nvPr/>
        </p:nvSpPr>
        <p:spPr>
          <a:xfrm>
            <a:off x="2799184" y="428415"/>
            <a:ext cx="625151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               no retrieval  group (n=20)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352939" y="5225143"/>
            <a:ext cx="1017036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 to D) Mean skin conductance responses to the CS+ and CS− trials during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cquisition, reactivation, extinction, and spontaneous recovery test and reinstatement test in each group. The lighting symbol represents the un-signaled electric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ocks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reinstatement test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9065345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图表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52099269"/>
              </p:ext>
            </p:extLst>
          </p:nvPr>
        </p:nvGraphicFramePr>
        <p:xfrm>
          <a:off x="0" y="1739106"/>
          <a:ext cx="12142787" cy="34051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文本框 1"/>
          <p:cNvSpPr txBox="1"/>
          <p:nvPr/>
        </p:nvSpPr>
        <p:spPr>
          <a:xfrm>
            <a:off x="2528596" y="456407"/>
            <a:ext cx="71099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            1/3  </a:t>
            </a:r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utation retrieval  group (n=20)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352939" y="5225143"/>
            <a:ext cx="1017036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 to D) Mean skin conductance responses to the CS+ and CS− trials during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cquisition, reactivation, extinction, and spontaneous recovery test and reinstatement test in each group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lighting symbol represents the un-signaled electric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ocks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reinstatement test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0226257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图表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49803398"/>
              </p:ext>
            </p:extLst>
          </p:nvPr>
        </p:nvGraphicFramePr>
        <p:xfrm>
          <a:off x="0" y="1726406"/>
          <a:ext cx="12192000" cy="34051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文本框 1"/>
          <p:cNvSpPr txBox="1"/>
          <p:nvPr/>
        </p:nvSpPr>
        <p:spPr>
          <a:xfrm>
            <a:off x="2519266" y="464945"/>
            <a:ext cx="736185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            2/3 </a:t>
            </a:r>
            <a:r>
              <a:rPr lang="en-US" altLang="zh-CN" dirty="0" smtClean="0"/>
              <a:t> </a:t>
            </a:r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utation retrieval  group (n=20)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352939" y="5225143"/>
            <a:ext cx="1017036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 to D) Mean skin conductance responses to the CS+ and CS− trials during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cquisition, reactivation, extinction, and spontaneous recovery test and reinstatement test in each group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lighting symbol represents the un-signaled electric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ocks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reinstatement test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6935520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图表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92341720"/>
              </p:ext>
            </p:extLst>
          </p:nvPr>
        </p:nvGraphicFramePr>
        <p:xfrm>
          <a:off x="0" y="1712118"/>
          <a:ext cx="12192000" cy="34337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文本框 1"/>
          <p:cNvSpPr txBox="1"/>
          <p:nvPr/>
        </p:nvSpPr>
        <p:spPr>
          <a:xfrm>
            <a:off x="2556588" y="465738"/>
            <a:ext cx="715657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                    whole </a:t>
            </a:r>
            <a:r>
              <a:rPr lang="en-US" altLang="zh-CN" dirty="0" smtClean="0"/>
              <a:t> </a:t>
            </a:r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trieval  group (n=20)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352939" y="5225143"/>
            <a:ext cx="1017036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 to D) Mean skin conductance responses to the CS+ and CS− trials during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cquisition, reactivation, extinction, and spontaneous recovery test and reinstatement test in each group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lighting symbol represents the un-signaled electric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ocks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reinstatement test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1229061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图表 1">
            <a:extLst>
              <a:ext uri="{FF2B5EF4-FFF2-40B4-BE49-F238E27FC236}">
                <a16:creationId xmlns:a16="http://schemas.microsoft.com/office/drawing/2014/main" xmlns="" id="{00000000-0008-0000-08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23995254"/>
              </p:ext>
            </p:extLst>
          </p:nvPr>
        </p:nvGraphicFramePr>
        <p:xfrm>
          <a:off x="969819" y="648392"/>
          <a:ext cx="10069484" cy="51040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文本框 1"/>
          <p:cNvSpPr txBox="1"/>
          <p:nvPr/>
        </p:nvSpPr>
        <p:spPr>
          <a:xfrm>
            <a:off x="4047519" y="105944"/>
            <a:ext cx="51244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st of spontaneous recovery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1819469" y="5738112"/>
            <a:ext cx="885475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3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ean differential skin conductance responses to the last trial of extinction and first trial of spontaneous recovery in each group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* represent p&lt;0.05. Error bars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</a:t>
            </a:r>
          </a:p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andard errors.</a:t>
            </a:r>
            <a:endParaRPr lang="zh-CN" altLang="zh-CN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160092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水滴">
    <a:dk1>
      <a:sysClr val="windowText" lastClr="000000"/>
    </a:dk1>
    <a:lt1>
      <a:sysClr val="window" lastClr="FFFFFF"/>
    </a:lt1>
    <a:dk2>
      <a:srgbClr val="355071"/>
    </a:dk2>
    <a:lt2>
      <a:srgbClr val="AABED7"/>
    </a:lt2>
    <a:accent1>
      <a:srgbClr val="2FA3EE"/>
    </a:accent1>
    <a:accent2>
      <a:srgbClr val="4BCAAD"/>
    </a:accent2>
    <a:accent3>
      <a:srgbClr val="86C157"/>
    </a:accent3>
    <a:accent4>
      <a:srgbClr val="D99C3F"/>
    </a:accent4>
    <a:accent5>
      <a:srgbClr val="CE6633"/>
    </a:accent5>
    <a:accent6>
      <a:srgbClr val="A35DD1"/>
    </a:accent6>
    <a:hlink>
      <a:srgbClr val="56BCFE"/>
    </a:hlink>
    <a:folHlink>
      <a:srgbClr val="97C5E3"/>
    </a:folHlink>
  </a:clrScheme>
  <a:fontScheme name="水滴">
    <a:majorFont>
      <a:latin typeface="Tw Cen M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Tw Cen M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水滴">
    <a:fillStyleLst>
      <a:solidFill>
        <a:schemeClr val="phClr"/>
      </a:solidFill>
      <a:solidFill>
        <a:schemeClr val="phClr">
          <a:tint val="69000"/>
          <a:satMod val="105000"/>
          <a:lumMod val="110000"/>
        </a:schemeClr>
      </a:solidFill>
      <a:gradFill rotWithShape="1">
        <a:gsLst>
          <a:gs pos="0">
            <a:schemeClr val="phClr">
              <a:tint val="94000"/>
              <a:satMod val="100000"/>
              <a:lumMod val="108000"/>
            </a:schemeClr>
          </a:gs>
          <a:gs pos="50000">
            <a:schemeClr val="phClr">
              <a:tint val="98000"/>
              <a:shade val="100000"/>
              <a:satMod val="100000"/>
              <a:lumMod val="100000"/>
            </a:schemeClr>
          </a:gs>
          <a:gs pos="100000">
            <a:schemeClr val="phClr">
              <a:shade val="72000"/>
              <a:satMod val="120000"/>
              <a:lumMod val="100000"/>
            </a:schemeClr>
          </a:gs>
        </a:gsLst>
        <a:lin ang="5400000" scaled="0"/>
      </a:gradFill>
    </a:fillStyleLst>
    <a:lnStyleLst>
      <a:ln w="9525" cap="flat" cmpd="sng" algn="ctr">
        <a:solidFill>
          <a:schemeClr val="phClr">
            <a:shade val="60000"/>
          </a:schemeClr>
        </a:solidFill>
        <a:prstDash val="solid"/>
      </a:ln>
      <a:ln w="15875" cap="flat" cmpd="sng" algn="ctr">
        <a:solidFill>
          <a:schemeClr val="phClr"/>
        </a:solidFill>
        <a:prstDash val="solid"/>
      </a:ln>
      <a:ln w="22225" cap="flat" cmpd="sng" algn="ctr">
        <a:solidFill>
          <a:schemeClr val="phClr"/>
        </a:solidFill>
        <a:prstDash val="solid"/>
      </a:ln>
    </a:lnStyleLst>
    <a:effectStyleLst>
      <a:effectStyle>
        <a:effectLst/>
      </a:effectStyle>
      <a:effectStyle>
        <a:effectLst>
          <a:outerShdw blurRad="50800" dist="25400" dir="5400000" rotWithShape="0">
            <a:srgbClr val="000000">
              <a:alpha val="28000"/>
            </a:srgbClr>
          </a:outerShdw>
        </a:effectLst>
      </a:effectStyle>
      <a:effectStyle>
        <a:effectLst>
          <a:outerShdw blurRad="63500" dist="25400" dir="5400000" algn="ctr" rotWithShape="0">
            <a:srgbClr val="000000">
              <a:alpha val="69000"/>
            </a:srgbClr>
          </a:outerShdw>
        </a:effectLst>
        <a:scene3d>
          <a:camera prst="orthographicFront">
            <a:rot lat="0" lon="0" rev="0"/>
          </a:camera>
          <a:lightRig rig="balanced" dir="t">
            <a:rot lat="0" lon="0" rev="1200000"/>
          </a:lightRig>
        </a:scene3d>
        <a:sp3d prstMaterial="plastic">
          <a:bevelT w="254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90000"/>
              <a:lumMod val="110000"/>
            </a:schemeClr>
          </a:gs>
          <a:gs pos="100000">
            <a:schemeClr val="phClr">
              <a:shade val="64000"/>
              <a:lumMod val="88000"/>
            </a:schemeClr>
          </a:gs>
        </a:gsLst>
        <a:lin ang="5400000" scaled="0"/>
      </a:gradFill>
      <a:gradFill rotWithShape="1">
        <a:gsLst>
          <a:gs pos="0">
            <a:schemeClr val="phClr">
              <a:tint val="84000"/>
              <a:shade val="100000"/>
              <a:hueMod val="130000"/>
              <a:satMod val="150000"/>
              <a:lumMod val="112000"/>
            </a:schemeClr>
          </a:gs>
          <a:gs pos="100000">
            <a:schemeClr val="phClr">
              <a:shade val="92000"/>
              <a:satMod val="140000"/>
              <a:lumMod val="11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水滴">
    <a:dk1>
      <a:sysClr val="windowText" lastClr="000000"/>
    </a:dk1>
    <a:lt1>
      <a:sysClr val="window" lastClr="FFFFFF"/>
    </a:lt1>
    <a:dk2>
      <a:srgbClr val="355071"/>
    </a:dk2>
    <a:lt2>
      <a:srgbClr val="AABED7"/>
    </a:lt2>
    <a:accent1>
      <a:srgbClr val="2FA3EE"/>
    </a:accent1>
    <a:accent2>
      <a:srgbClr val="4BCAAD"/>
    </a:accent2>
    <a:accent3>
      <a:srgbClr val="86C157"/>
    </a:accent3>
    <a:accent4>
      <a:srgbClr val="D99C3F"/>
    </a:accent4>
    <a:accent5>
      <a:srgbClr val="CE6633"/>
    </a:accent5>
    <a:accent6>
      <a:srgbClr val="A35DD1"/>
    </a:accent6>
    <a:hlink>
      <a:srgbClr val="56BCFE"/>
    </a:hlink>
    <a:folHlink>
      <a:srgbClr val="97C5E3"/>
    </a:folHlink>
  </a:clrScheme>
  <a:fontScheme name="水滴">
    <a:majorFont>
      <a:latin typeface="Tw Cen M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Tw Cen M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水滴">
    <a:fillStyleLst>
      <a:solidFill>
        <a:schemeClr val="phClr"/>
      </a:solidFill>
      <a:solidFill>
        <a:schemeClr val="phClr">
          <a:tint val="69000"/>
          <a:satMod val="105000"/>
          <a:lumMod val="110000"/>
        </a:schemeClr>
      </a:solidFill>
      <a:gradFill rotWithShape="1">
        <a:gsLst>
          <a:gs pos="0">
            <a:schemeClr val="phClr">
              <a:tint val="94000"/>
              <a:satMod val="100000"/>
              <a:lumMod val="108000"/>
            </a:schemeClr>
          </a:gs>
          <a:gs pos="50000">
            <a:schemeClr val="phClr">
              <a:tint val="98000"/>
              <a:shade val="100000"/>
              <a:satMod val="100000"/>
              <a:lumMod val="100000"/>
            </a:schemeClr>
          </a:gs>
          <a:gs pos="100000">
            <a:schemeClr val="phClr">
              <a:shade val="72000"/>
              <a:satMod val="120000"/>
              <a:lumMod val="100000"/>
            </a:schemeClr>
          </a:gs>
        </a:gsLst>
        <a:lin ang="5400000" scaled="0"/>
      </a:gradFill>
    </a:fillStyleLst>
    <a:lnStyleLst>
      <a:ln w="9525" cap="flat" cmpd="sng" algn="ctr">
        <a:solidFill>
          <a:schemeClr val="phClr">
            <a:shade val="60000"/>
          </a:schemeClr>
        </a:solidFill>
        <a:prstDash val="solid"/>
      </a:ln>
      <a:ln w="15875" cap="flat" cmpd="sng" algn="ctr">
        <a:solidFill>
          <a:schemeClr val="phClr"/>
        </a:solidFill>
        <a:prstDash val="solid"/>
      </a:ln>
      <a:ln w="22225" cap="flat" cmpd="sng" algn="ctr">
        <a:solidFill>
          <a:schemeClr val="phClr"/>
        </a:solidFill>
        <a:prstDash val="solid"/>
      </a:ln>
    </a:lnStyleLst>
    <a:effectStyleLst>
      <a:effectStyle>
        <a:effectLst/>
      </a:effectStyle>
      <a:effectStyle>
        <a:effectLst>
          <a:outerShdw blurRad="50800" dist="25400" dir="5400000" rotWithShape="0">
            <a:srgbClr val="000000">
              <a:alpha val="28000"/>
            </a:srgbClr>
          </a:outerShdw>
        </a:effectLst>
      </a:effectStyle>
      <a:effectStyle>
        <a:effectLst>
          <a:outerShdw blurRad="63500" dist="25400" dir="5400000" algn="ctr" rotWithShape="0">
            <a:srgbClr val="000000">
              <a:alpha val="69000"/>
            </a:srgbClr>
          </a:outerShdw>
        </a:effectLst>
        <a:scene3d>
          <a:camera prst="orthographicFront">
            <a:rot lat="0" lon="0" rev="0"/>
          </a:camera>
          <a:lightRig rig="balanced" dir="t">
            <a:rot lat="0" lon="0" rev="1200000"/>
          </a:lightRig>
        </a:scene3d>
        <a:sp3d prstMaterial="plastic">
          <a:bevelT w="254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90000"/>
              <a:lumMod val="110000"/>
            </a:schemeClr>
          </a:gs>
          <a:gs pos="100000">
            <a:schemeClr val="phClr">
              <a:shade val="64000"/>
              <a:lumMod val="88000"/>
            </a:schemeClr>
          </a:gs>
        </a:gsLst>
        <a:lin ang="5400000" scaled="0"/>
      </a:gradFill>
      <a:gradFill rotWithShape="1">
        <a:gsLst>
          <a:gs pos="0">
            <a:schemeClr val="phClr">
              <a:tint val="84000"/>
              <a:shade val="100000"/>
              <a:hueMod val="130000"/>
              <a:satMod val="150000"/>
              <a:lumMod val="112000"/>
            </a:schemeClr>
          </a:gs>
          <a:gs pos="100000">
            <a:schemeClr val="phClr">
              <a:shade val="92000"/>
              <a:satMod val="140000"/>
              <a:lumMod val="11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水滴">
    <a:dk1>
      <a:sysClr val="windowText" lastClr="000000"/>
    </a:dk1>
    <a:lt1>
      <a:sysClr val="window" lastClr="FFFFFF"/>
    </a:lt1>
    <a:dk2>
      <a:srgbClr val="355071"/>
    </a:dk2>
    <a:lt2>
      <a:srgbClr val="AABED7"/>
    </a:lt2>
    <a:accent1>
      <a:srgbClr val="2FA3EE"/>
    </a:accent1>
    <a:accent2>
      <a:srgbClr val="4BCAAD"/>
    </a:accent2>
    <a:accent3>
      <a:srgbClr val="86C157"/>
    </a:accent3>
    <a:accent4>
      <a:srgbClr val="D99C3F"/>
    </a:accent4>
    <a:accent5>
      <a:srgbClr val="CE6633"/>
    </a:accent5>
    <a:accent6>
      <a:srgbClr val="A35DD1"/>
    </a:accent6>
    <a:hlink>
      <a:srgbClr val="56BCFE"/>
    </a:hlink>
    <a:folHlink>
      <a:srgbClr val="97C5E3"/>
    </a:folHlink>
  </a:clrScheme>
  <a:fontScheme name="水滴">
    <a:majorFont>
      <a:latin typeface="Tw Cen M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Tw Cen M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水滴">
    <a:fillStyleLst>
      <a:solidFill>
        <a:schemeClr val="phClr"/>
      </a:solidFill>
      <a:solidFill>
        <a:schemeClr val="phClr">
          <a:tint val="69000"/>
          <a:satMod val="105000"/>
          <a:lumMod val="110000"/>
        </a:schemeClr>
      </a:solidFill>
      <a:gradFill rotWithShape="1">
        <a:gsLst>
          <a:gs pos="0">
            <a:schemeClr val="phClr">
              <a:tint val="94000"/>
              <a:satMod val="100000"/>
              <a:lumMod val="108000"/>
            </a:schemeClr>
          </a:gs>
          <a:gs pos="50000">
            <a:schemeClr val="phClr">
              <a:tint val="98000"/>
              <a:shade val="100000"/>
              <a:satMod val="100000"/>
              <a:lumMod val="100000"/>
            </a:schemeClr>
          </a:gs>
          <a:gs pos="100000">
            <a:schemeClr val="phClr">
              <a:shade val="72000"/>
              <a:satMod val="120000"/>
              <a:lumMod val="100000"/>
            </a:schemeClr>
          </a:gs>
        </a:gsLst>
        <a:lin ang="5400000" scaled="0"/>
      </a:gradFill>
    </a:fillStyleLst>
    <a:lnStyleLst>
      <a:ln w="9525" cap="flat" cmpd="sng" algn="ctr">
        <a:solidFill>
          <a:schemeClr val="phClr">
            <a:shade val="60000"/>
          </a:schemeClr>
        </a:solidFill>
        <a:prstDash val="solid"/>
      </a:ln>
      <a:ln w="15875" cap="flat" cmpd="sng" algn="ctr">
        <a:solidFill>
          <a:schemeClr val="phClr"/>
        </a:solidFill>
        <a:prstDash val="solid"/>
      </a:ln>
      <a:ln w="22225" cap="flat" cmpd="sng" algn="ctr">
        <a:solidFill>
          <a:schemeClr val="phClr"/>
        </a:solidFill>
        <a:prstDash val="solid"/>
      </a:ln>
    </a:lnStyleLst>
    <a:effectStyleLst>
      <a:effectStyle>
        <a:effectLst/>
      </a:effectStyle>
      <a:effectStyle>
        <a:effectLst>
          <a:outerShdw blurRad="50800" dist="25400" dir="5400000" rotWithShape="0">
            <a:srgbClr val="000000">
              <a:alpha val="28000"/>
            </a:srgbClr>
          </a:outerShdw>
        </a:effectLst>
      </a:effectStyle>
      <a:effectStyle>
        <a:effectLst>
          <a:outerShdw blurRad="63500" dist="25400" dir="5400000" algn="ctr" rotWithShape="0">
            <a:srgbClr val="000000">
              <a:alpha val="69000"/>
            </a:srgbClr>
          </a:outerShdw>
        </a:effectLst>
        <a:scene3d>
          <a:camera prst="orthographicFront">
            <a:rot lat="0" lon="0" rev="0"/>
          </a:camera>
          <a:lightRig rig="balanced" dir="t">
            <a:rot lat="0" lon="0" rev="1200000"/>
          </a:lightRig>
        </a:scene3d>
        <a:sp3d prstMaterial="plastic">
          <a:bevelT w="254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90000"/>
              <a:lumMod val="110000"/>
            </a:schemeClr>
          </a:gs>
          <a:gs pos="100000">
            <a:schemeClr val="phClr">
              <a:shade val="64000"/>
              <a:lumMod val="88000"/>
            </a:schemeClr>
          </a:gs>
        </a:gsLst>
        <a:lin ang="5400000" scaled="0"/>
      </a:gradFill>
      <a:gradFill rotWithShape="1">
        <a:gsLst>
          <a:gs pos="0">
            <a:schemeClr val="phClr">
              <a:tint val="84000"/>
              <a:shade val="100000"/>
              <a:hueMod val="130000"/>
              <a:satMod val="150000"/>
              <a:lumMod val="112000"/>
            </a:schemeClr>
          </a:gs>
          <a:gs pos="100000">
            <a:schemeClr val="phClr">
              <a:shade val="92000"/>
              <a:satMod val="140000"/>
              <a:lumMod val="11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水滴">
    <a:dk1>
      <a:sysClr val="windowText" lastClr="000000"/>
    </a:dk1>
    <a:lt1>
      <a:sysClr val="window" lastClr="FFFFFF"/>
    </a:lt1>
    <a:dk2>
      <a:srgbClr val="355071"/>
    </a:dk2>
    <a:lt2>
      <a:srgbClr val="AABED7"/>
    </a:lt2>
    <a:accent1>
      <a:srgbClr val="2FA3EE"/>
    </a:accent1>
    <a:accent2>
      <a:srgbClr val="4BCAAD"/>
    </a:accent2>
    <a:accent3>
      <a:srgbClr val="86C157"/>
    </a:accent3>
    <a:accent4>
      <a:srgbClr val="D99C3F"/>
    </a:accent4>
    <a:accent5>
      <a:srgbClr val="CE6633"/>
    </a:accent5>
    <a:accent6>
      <a:srgbClr val="A35DD1"/>
    </a:accent6>
    <a:hlink>
      <a:srgbClr val="56BCFE"/>
    </a:hlink>
    <a:folHlink>
      <a:srgbClr val="97C5E3"/>
    </a:folHlink>
  </a:clrScheme>
  <a:fontScheme name="水滴">
    <a:majorFont>
      <a:latin typeface="Tw Cen M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Tw Cen M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水滴">
    <a:fillStyleLst>
      <a:solidFill>
        <a:schemeClr val="phClr"/>
      </a:solidFill>
      <a:solidFill>
        <a:schemeClr val="phClr">
          <a:tint val="69000"/>
          <a:satMod val="105000"/>
          <a:lumMod val="110000"/>
        </a:schemeClr>
      </a:solidFill>
      <a:gradFill rotWithShape="1">
        <a:gsLst>
          <a:gs pos="0">
            <a:schemeClr val="phClr">
              <a:tint val="94000"/>
              <a:satMod val="100000"/>
              <a:lumMod val="108000"/>
            </a:schemeClr>
          </a:gs>
          <a:gs pos="50000">
            <a:schemeClr val="phClr">
              <a:tint val="98000"/>
              <a:shade val="100000"/>
              <a:satMod val="100000"/>
              <a:lumMod val="100000"/>
            </a:schemeClr>
          </a:gs>
          <a:gs pos="100000">
            <a:schemeClr val="phClr">
              <a:shade val="72000"/>
              <a:satMod val="120000"/>
              <a:lumMod val="100000"/>
            </a:schemeClr>
          </a:gs>
        </a:gsLst>
        <a:lin ang="5400000" scaled="0"/>
      </a:gradFill>
    </a:fillStyleLst>
    <a:lnStyleLst>
      <a:ln w="9525" cap="flat" cmpd="sng" algn="ctr">
        <a:solidFill>
          <a:schemeClr val="phClr">
            <a:shade val="60000"/>
          </a:schemeClr>
        </a:solidFill>
        <a:prstDash val="solid"/>
      </a:ln>
      <a:ln w="15875" cap="flat" cmpd="sng" algn="ctr">
        <a:solidFill>
          <a:schemeClr val="phClr"/>
        </a:solidFill>
        <a:prstDash val="solid"/>
      </a:ln>
      <a:ln w="22225" cap="flat" cmpd="sng" algn="ctr">
        <a:solidFill>
          <a:schemeClr val="phClr"/>
        </a:solidFill>
        <a:prstDash val="solid"/>
      </a:ln>
    </a:lnStyleLst>
    <a:effectStyleLst>
      <a:effectStyle>
        <a:effectLst/>
      </a:effectStyle>
      <a:effectStyle>
        <a:effectLst>
          <a:outerShdw blurRad="50800" dist="25400" dir="5400000" rotWithShape="0">
            <a:srgbClr val="000000">
              <a:alpha val="28000"/>
            </a:srgbClr>
          </a:outerShdw>
        </a:effectLst>
      </a:effectStyle>
      <a:effectStyle>
        <a:effectLst>
          <a:outerShdw blurRad="63500" dist="25400" dir="5400000" algn="ctr" rotWithShape="0">
            <a:srgbClr val="000000">
              <a:alpha val="69000"/>
            </a:srgbClr>
          </a:outerShdw>
        </a:effectLst>
        <a:scene3d>
          <a:camera prst="orthographicFront">
            <a:rot lat="0" lon="0" rev="0"/>
          </a:camera>
          <a:lightRig rig="balanced" dir="t">
            <a:rot lat="0" lon="0" rev="1200000"/>
          </a:lightRig>
        </a:scene3d>
        <a:sp3d prstMaterial="plastic">
          <a:bevelT w="254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90000"/>
              <a:lumMod val="110000"/>
            </a:schemeClr>
          </a:gs>
          <a:gs pos="100000">
            <a:schemeClr val="phClr">
              <a:shade val="64000"/>
              <a:lumMod val="88000"/>
            </a:schemeClr>
          </a:gs>
        </a:gsLst>
        <a:lin ang="5400000" scaled="0"/>
      </a:gradFill>
      <a:gradFill rotWithShape="1">
        <a:gsLst>
          <a:gs pos="0">
            <a:schemeClr val="phClr">
              <a:tint val="84000"/>
              <a:shade val="100000"/>
              <a:hueMod val="130000"/>
              <a:satMod val="150000"/>
              <a:lumMod val="112000"/>
            </a:schemeClr>
          </a:gs>
          <a:gs pos="100000">
            <a:schemeClr val="phClr">
              <a:shade val="92000"/>
              <a:satMod val="140000"/>
              <a:lumMod val="110000"/>
            </a:schemeClr>
          </a:gs>
        </a:gsLst>
        <a:lin ang="5400000" scaled="0"/>
      </a:gradFill>
    </a:bgFillStyleLst>
  </a:fmtScheme>
</a:themeOverride>
</file>

<file path=ppt/theme/themeOverride5.xml><?xml version="1.0" encoding="utf-8"?>
<a:themeOverride xmlns:a="http://schemas.openxmlformats.org/drawingml/2006/main">
  <a:clrScheme name="水滴">
    <a:dk1>
      <a:sysClr val="windowText" lastClr="000000"/>
    </a:dk1>
    <a:lt1>
      <a:sysClr val="window" lastClr="FFFFFF"/>
    </a:lt1>
    <a:dk2>
      <a:srgbClr val="355071"/>
    </a:dk2>
    <a:lt2>
      <a:srgbClr val="AABED7"/>
    </a:lt2>
    <a:accent1>
      <a:srgbClr val="2FA3EE"/>
    </a:accent1>
    <a:accent2>
      <a:srgbClr val="4BCAAD"/>
    </a:accent2>
    <a:accent3>
      <a:srgbClr val="86C157"/>
    </a:accent3>
    <a:accent4>
      <a:srgbClr val="D99C3F"/>
    </a:accent4>
    <a:accent5>
      <a:srgbClr val="CE6633"/>
    </a:accent5>
    <a:accent6>
      <a:srgbClr val="A35DD1"/>
    </a:accent6>
    <a:hlink>
      <a:srgbClr val="56BCFE"/>
    </a:hlink>
    <a:folHlink>
      <a:srgbClr val="97C5E3"/>
    </a:folHlink>
  </a:clrScheme>
  <a:fontScheme name="水滴">
    <a:majorFont>
      <a:latin typeface="Tw Cen M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Tw Cen M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水滴">
    <a:fillStyleLst>
      <a:solidFill>
        <a:schemeClr val="phClr"/>
      </a:solidFill>
      <a:solidFill>
        <a:schemeClr val="phClr">
          <a:tint val="69000"/>
          <a:satMod val="105000"/>
          <a:lumMod val="110000"/>
        </a:schemeClr>
      </a:solidFill>
      <a:gradFill rotWithShape="1">
        <a:gsLst>
          <a:gs pos="0">
            <a:schemeClr val="phClr">
              <a:tint val="94000"/>
              <a:satMod val="100000"/>
              <a:lumMod val="108000"/>
            </a:schemeClr>
          </a:gs>
          <a:gs pos="50000">
            <a:schemeClr val="phClr">
              <a:tint val="98000"/>
              <a:shade val="100000"/>
              <a:satMod val="100000"/>
              <a:lumMod val="100000"/>
            </a:schemeClr>
          </a:gs>
          <a:gs pos="100000">
            <a:schemeClr val="phClr">
              <a:shade val="72000"/>
              <a:satMod val="120000"/>
              <a:lumMod val="100000"/>
            </a:schemeClr>
          </a:gs>
        </a:gsLst>
        <a:lin ang="5400000" scaled="0"/>
      </a:gradFill>
    </a:fillStyleLst>
    <a:lnStyleLst>
      <a:ln w="9525" cap="flat" cmpd="sng" algn="ctr">
        <a:solidFill>
          <a:schemeClr val="phClr">
            <a:shade val="60000"/>
          </a:schemeClr>
        </a:solidFill>
        <a:prstDash val="solid"/>
      </a:ln>
      <a:ln w="15875" cap="flat" cmpd="sng" algn="ctr">
        <a:solidFill>
          <a:schemeClr val="phClr"/>
        </a:solidFill>
        <a:prstDash val="solid"/>
      </a:ln>
      <a:ln w="22225" cap="flat" cmpd="sng" algn="ctr">
        <a:solidFill>
          <a:schemeClr val="phClr"/>
        </a:solidFill>
        <a:prstDash val="solid"/>
      </a:ln>
    </a:lnStyleLst>
    <a:effectStyleLst>
      <a:effectStyle>
        <a:effectLst/>
      </a:effectStyle>
      <a:effectStyle>
        <a:effectLst>
          <a:outerShdw blurRad="50800" dist="25400" dir="5400000" rotWithShape="0">
            <a:srgbClr val="000000">
              <a:alpha val="28000"/>
            </a:srgbClr>
          </a:outerShdw>
        </a:effectLst>
      </a:effectStyle>
      <a:effectStyle>
        <a:effectLst>
          <a:outerShdw blurRad="63500" dist="25400" dir="5400000" algn="ctr" rotWithShape="0">
            <a:srgbClr val="000000">
              <a:alpha val="69000"/>
            </a:srgbClr>
          </a:outerShdw>
        </a:effectLst>
        <a:scene3d>
          <a:camera prst="orthographicFront">
            <a:rot lat="0" lon="0" rev="0"/>
          </a:camera>
          <a:lightRig rig="balanced" dir="t">
            <a:rot lat="0" lon="0" rev="1200000"/>
          </a:lightRig>
        </a:scene3d>
        <a:sp3d prstMaterial="plastic">
          <a:bevelT w="254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90000"/>
              <a:lumMod val="110000"/>
            </a:schemeClr>
          </a:gs>
          <a:gs pos="100000">
            <a:schemeClr val="phClr">
              <a:shade val="64000"/>
              <a:lumMod val="88000"/>
            </a:schemeClr>
          </a:gs>
        </a:gsLst>
        <a:lin ang="5400000" scaled="0"/>
      </a:gradFill>
      <a:gradFill rotWithShape="1">
        <a:gsLst>
          <a:gs pos="0">
            <a:schemeClr val="phClr">
              <a:tint val="84000"/>
              <a:shade val="100000"/>
              <a:hueMod val="130000"/>
              <a:satMod val="150000"/>
              <a:lumMod val="112000"/>
            </a:schemeClr>
          </a:gs>
          <a:gs pos="100000">
            <a:schemeClr val="phClr">
              <a:shade val="92000"/>
              <a:satMod val="140000"/>
              <a:lumMod val="110000"/>
            </a:schemeClr>
          </a:gs>
        </a:gsLst>
        <a:lin ang="5400000" scaled="0"/>
      </a:gradFill>
    </a:bgFillStyleLst>
  </a:fmtScheme>
</a:themeOverride>
</file>

<file path=ppt/theme/themeOverride6.xml><?xml version="1.0" encoding="utf-8"?>
<a:themeOverride xmlns:a="http://schemas.openxmlformats.org/drawingml/2006/main">
  <a:clrScheme name="水滴">
    <a:dk1>
      <a:sysClr val="windowText" lastClr="000000"/>
    </a:dk1>
    <a:lt1>
      <a:sysClr val="window" lastClr="FFFFFF"/>
    </a:lt1>
    <a:dk2>
      <a:srgbClr val="355071"/>
    </a:dk2>
    <a:lt2>
      <a:srgbClr val="AABED7"/>
    </a:lt2>
    <a:accent1>
      <a:srgbClr val="2FA3EE"/>
    </a:accent1>
    <a:accent2>
      <a:srgbClr val="4BCAAD"/>
    </a:accent2>
    <a:accent3>
      <a:srgbClr val="86C157"/>
    </a:accent3>
    <a:accent4>
      <a:srgbClr val="D99C3F"/>
    </a:accent4>
    <a:accent5>
      <a:srgbClr val="CE6633"/>
    </a:accent5>
    <a:accent6>
      <a:srgbClr val="A35DD1"/>
    </a:accent6>
    <a:hlink>
      <a:srgbClr val="56BCFE"/>
    </a:hlink>
    <a:folHlink>
      <a:srgbClr val="97C5E3"/>
    </a:folHlink>
  </a:clrScheme>
  <a:fontScheme name="水滴">
    <a:majorFont>
      <a:latin typeface="Tw Cen M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Tw Cen M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水滴">
    <a:fillStyleLst>
      <a:solidFill>
        <a:schemeClr val="phClr"/>
      </a:solidFill>
      <a:solidFill>
        <a:schemeClr val="phClr">
          <a:tint val="69000"/>
          <a:satMod val="105000"/>
          <a:lumMod val="110000"/>
        </a:schemeClr>
      </a:solidFill>
      <a:gradFill rotWithShape="1">
        <a:gsLst>
          <a:gs pos="0">
            <a:schemeClr val="phClr">
              <a:tint val="94000"/>
              <a:satMod val="100000"/>
              <a:lumMod val="108000"/>
            </a:schemeClr>
          </a:gs>
          <a:gs pos="50000">
            <a:schemeClr val="phClr">
              <a:tint val="98000"/>
              <a:shade val="100000"/>
              <a:satMod val="100000"/>
              <a:lumMod val="100000"/>
            </a:schemeClr>
          </a:gs>
          <a:gs pos="100000">
            <a:schemeClr val="phClr">
              <a:shade val="72000"/>
              <a:satMod val="120000"/>
              <a:lumMod val="100000"/>
            </a:schemeClr>
          </a:gs>
        </a:gsLst>
        <a:lin ang="5400000" scaled="0"/>
      </a:gradFill>
    </a:fillStyleLst>
    <a:lnStyleLst>
      <a:ln w="9525" cap="flat" cmpd="sng" algn="ctr">
        <a:solidFill>
          <a:schemeClr val="phClr">
            <a:shade val="60000"/>
          </a:schemeClr>
        </a:solidFill>
        <a:prstDash val="solid"/>
      </a:ln>
      <a:ln w="15875" cap="flat" cmpd="sng" algn="ctr">
        <a:solidFill>
          <a:schemeClr val="phClr"/>
        </a:solidFill>
        <a:prstDash val="solid"/>
      </a:ln>
      <a:ln w="22225" cap="flat" cmpd="sng" algn="ctr">
        <a:solidFill>
          <a:schemeClr val="phClr"/>
        </a:solidFill>
        <a:prstDash val="solid"/>
      </a:ln>
    </a:lnStyleLst>
    <a:effectStyleLst>
      <a:effectStyle>
        <a:effectLst/>
      </a:effectStyle>
      <a:effectStyle>
        <a:effectLst>
          <a:outerShdw blurRad="50800" dist="25400" dir="5400000" rotWithShape="0">
            <a:srgbClr val="000000">
              <a:alpha val="28000"/>
            </a:srgbClr>
          </a:outerShdw>
        </a:effectLst>
      </a:effectStyle>
      <a:effectStyle>
        <a:effectLst>
          <a:outerShdw blurRad="63500" dist="25400" dir="5400000" algn="ctr" rotWithShape="0">
            <a:srgbClr val="000000">
              <a:alpha val="69000"/>
            </a:srgbClr>
          </a:outerShdw>
        </a:effectLst>
        <a:scene3d>
          <a:camera prst="orthographicFront">
            <a:rot lat="0" lon="0" rev="0"/>
          </a:camera>
          <a:lightRig rig="balanced" dir="t">
            <a:rot lat="0" lon="0" rev="1200000"/>
          </a:lightRig>
        </a:scene3d>
        <a:sp3d prstMaterial="plastic">
          <a:bevelT w="254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90000"/>
              <a:lumMod val="110000"/>
            </a:schemeClr>
          </a:gs>
          <a:gs pos="100000">
            <a:schemeClr val="phClr">
              <a:shade val="64000"/>
              <a:lumMod val="88000"/>
            </a:schemeClr>
          </a:gs>
        </a:gsLst>
        <a:lin ang="5400000" scaled="0"/>
      </a:gradFill>
      <a:gradFill rotWithShape="1">
        <a:gsLst>
          <a:gs pos="0">
            <a:schemeClr val="phClr">
              <a:tint val="84000"/>
              <a:shade val="100000"/>
              <a:hueMod val="130000"/>
              <a:satMod val="150000"/>
              <a:lumMod val="112000"/>
            </a:schemeClr>
          </a:gs>
          <a:gs pos="100000">
            <a:schemeClr val="phClr">
              <a:shade val="92000"/>
              <a:satMod val="140000"/>
              <a:lumMod val="110000"/>
            </a:schemeClr>
          </a:gs>
        </a:gsLst>
        <a:lin ang="5400000" scaled="0"/>
      </a:gradFill>
    </a:bgFillStyleLst>
  </a:fmtScheme>
</a:themeOverride>
</file>

<file path=ppt/theme/themeOverride7.xml><?xml version="1.0" encoding="utf-8"?>
<a:themeOverride xmlns:a="http://schemas.openxmlformats.org/drawingml/2006/main">
  <a:clrScheme name="水滴">
    <a:dk1>
      <a:sysClr val="windowText" lastClr="000000"/>
    </a:dk1>
    <a:lt1>
      <a:sysClr val="window" lastClr="FFFFFF"/>
    </a:lt1>
    <a:dk2>
      <a:srgbClr val="355071"/>
    </a:dk2>
    <a:lt2>
      <a:srgbClr val="AABED7"/>
    </a:lt2>
    <a:accent1>
      <a:srgbClr val="2FA3EE"/>
    </a:accent1>
    <a:accent2>
      <a:srgbClr val="4BCAAD"/>
    </a:accent2>
    <a:accent3>
      <a:srgbClr val="86C157"/>
    </a:accent3>
    <a:accent4>
      <a:srgbClr val="D99C3F"/>
    </a:accent4>
    <a:accent5>
      <a:srgbClr val="CE6633"/>
    </a:accent5>
    <a:accent6>
      <a:srgbClr val="A35DD1"/>
    </a:accent6>
    <a:hlink>
      <a:srgbClr val="56BCFE"/>
    </a:hlink>
    <a:folHlink>
      <a:srgbClr val="97C5E3"/>
    </a:folHlink>
  </a:clrScheme>
  <a:fontScheme name="水滴">
    <a:majorFont>
      <a:latin typeface="Tw Cen M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Tw Cen M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水滴">
    <a:fillStyleLst>
      <a:solidFill>
        <a:schemeClr val="phClr"/>
      </a:solidFill>
      <a:solidFill>
        <a:schemeClr val="phClr">
          <a:tint val="69000"/>
          <a:satMod val="105000"/>
          <a:lumMod val="110000"/>
        </a:schemeClr>
      </a:solidFill>
      <a:gradFill rotWithShape="1">
        <a:gsLst>
          <a:gs pos="0">
            <a:schemeClr val="phClr">
              <a:tint val="94000"/>
              <a:satMod val="100000"/>
              <a:lumMod val="108000"/>
            </a:schemeClr>
          </a:gs>
          <a:gs pos="50000">
            <a:schemeClr val="phClr">
              <a:tint val="98000"/>
              <a:shade val="100000"/>
              <a:satMod val="100000"/>
              <a:lumMod val="100000"/>
            </a:schemeClr>
          </a:gs>
          <a:gs pos="100000">
            <a:schemeClr val="phClr">
              <a:shade val="72000"/>
              <a:satMod val="120000"/>
              <a:lumMod val="100000"/>
            </a:schemeClr>
          </a:gs>
        </a:gsLst>
        <a:lin ang="5400000" scaled="0"/>
      </a:gradFill>
    </a:fillStyleLst>
    <a:lnStyleLst>
      <a:ln w="9525" cap="flat" cmpd="sng" algn="ctr">
        <a:solidFill>
          <a:schemeClr val="phClr">
            <a:shade val="60000"/>
          </a:schemeClr>
        </a:solidFill>
        <a:prstDash val="solid"/>
      </a:ln>
      <a:ln w="15875" cap="flat" cmpd="sng" algn="ctr">
        <a:solidFill>
          <a:schemeClr val="phClr"/>
        </a:solidFill>
        <a:prstDash val="solid"/>
      </a:ln>
      <a:ln w="22225" cap="flat" cmpd="sng" algn="ctr">
        <a:solidFill>
          <a:schemeClr val="phClr"/>
        </a:solidFill>
        <a:prstDash val="solid"/>
      </a:ln>
    </a:lnStyleLst>
    <a:effectStyleLst>
      <a:effectStyle>
        <a:effectLst/>
      </a:effectStyle>
      <a:effectStyle>
        <a:effectLst>
          <a:outerShdw blurRad="50800" dist="25400" dir="5400000" rotWithShape="0">
            <a:srgbClr val="000000">
              <a:alpha val="28000"/>
            </a:srgbClr>
          </a:outerShdw>
        </a:effectLst>
      </a:effectStyle>
      <a:effectStyle>
        <a:effectLst>
          <a:outerShdw blurRad="63500" dist="25400" dir="5400000" algn="ctr" rotWithShape="0">
            <a:srgbClr val="000000">
              <a:alpha val="69000"/>
            </a:srgbClr>
          </a:outerShdw>
        </a:effectLst>
        <a:scene3d>
          <a:camera prst="orthographicFront">
            <a:rot lat="0" lon="0" rev="0"/>
          </a:camera>
          <a:lightRig rig="balanced" dir="t">
            <a:rot lat="0" lon="0" rev="1200000"/>
          </a:lightRig>
        </a:scene3d>
        <a:sp3d prstMaterial="plastic">
          <a:bevelT w="254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90000"/>
              <a:lumMod val="110000"/>
            </a:schemeClr>
          </a:gs>
          <a:gs pos="100000">
            <a:schemeClr val="phClr">
              <a:shade val="64000"/>
              <a:lumMod val="88000"/>
            </a:schemeClr>
          </a:gs>
        </a:gsLst>
        <a:lin ang="5400000" scaled="0"/>
      </a:gradFill>
      <a:gradFill rotWithShape="1">
        <a:gsLst>
          <a:gs pos="0">
            <a:schemeClr val="phClr">
              <a:tint val="84000"/>
              <a:shade val="100000"/>
              <a:hueMod val="130000"/>
              <a:satMod val="150000"/>
              <a:lumMod val="112000"/>
            </a:schemeClr>
          </a:gs>
          <a:gs pos="100000">
            <a:schemeClr val="phClr">
              <a:shade val="92000"/>
              <a:satMod val="140000"/>
              <a:lumMod val="110000"/>
            </a:schemeClr>
          </a:gs>
        </a:gsLst>
        <a:lin ang="5400000" scaled="0"/>
      </a:gradFill>
    </a:bgFillStyleLst>
  </a:fmtScheme>
</a:themeOverrid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E8C78F21B45EF479F5CA629480F6AA8" ma:contentTypeVersion="7" ma:contentTypeDescription="Create a new document." ma:contentTypeScope="" ma:versionID="f671af6365ac414c1b586ce32e882c71">
  <xsd:schema xmlns:xsd="http://www.w3.org/2001/XMLSchema" xmlns:p="http://schemas.microsoft.com/office/2006/metadata/properties" xmlns:ns2="e0c5cd90-fa0d-4391-bd91-b400daf014db" targetNamespace="http://schemas.microsoft.com/office/2006/metadata/properties" ma:root="true" ma:fieldsID="9d3cfad310efeeb70853a035efe4057c" ns2:_="">
    <xsd:import namespace="e0c5cd90-fa0d-4391-bd91-b400daf014db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e0c5cd90-fa0d-4391-bd91-b400daf014db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3.xml><?xml version="1.0" encoding="utf-8"?>
<p:properties xmlns:p="http://schemas.microsoft.com/office/2006/metadata/properties" xmlns:xsi="http://www.w3.org/2001/XMLSchema-instance">
  <documentManagement>
    <FileFormat xmlns="e0c5cd90-fa0d-4391-bd91-b400daf014db">PPTX</FileFormat>
    <DocumentId xmlns="e0c5cd90-fa0d-4391-bd91-b400daf014db">Presentation 1.PPTX</DocumentId>
    <IsDeleted xmlns="e0c5cd90-fa0d-4391-bd91-b400daf014db">false</IsDeleted>
    <DocumentType xmlns="e0c5cd90-fa0d-4391-bd91-b400daf014db">Presentation</DocumentType>
    <Checked_x0020_Out_x0020_To xmlns="e0c5cd90-fa0d-4391-bd91-b400daf014db">
      <UserInfo>
        <DisplayName/>
        <AccountId xsi:nil="true"/>
        <AccountType/>
      </UserInfo>
    </Checked_x0020_Out_x0020_To>
    <TitleName xmlns="e0c5cd90-fa0d-4391-bd91-b400daf014db">Presentation 1.PPTX</TitleName>
    <StageName xmlns="e0c5cd90-fa0d-4391-bd91-b400daf014db" xsi:nil="true"/>
  </documentManagement>
</p:properties>
</file>

<file path=customXml/itemProps1.xml><?xml version="1.0" encoding="utf-8"?>
<ds:datastoreItem xmlns:ds="http://schemas.openxmlformats.org/officeDocument/2006/customXml" ds:itemID="{B78F17DF-FAD3-4470-B48E-2C2C2EA7F13F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F05C606D-7E4D-4AC2-8CE7-CB86EFA801EC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e0c5cd90-fa0d-4391-bd91-b400daf014db"/>
    <ds:schemaRef ds:uri="http://schemas.microsoft.com/office/2006/documentManagement/types"/>
    <ds:schemaRef ds:uri="http://schemas.openxmlformats.org/package/2006/metadata/core-properties"/>
    <ds:schemaRef ds:uri="http://purl.org/dc/elements/1.1/"/>
    <ds:schemaRef ds:uri="http://purl.org/dc/terms/"/>
    <ds:schemaRef ds:uri="http://schemas.microsoft.com/office/internal/2005/internalDocumentation"/>
  </ds:schemaRefs>
</ds:datastoreItem>
</file>

<file path=customXml/itemProps3.xml><?xml version="1.0" encoding="utf-8"?>
<ds:datastoreItem xmlns:ds="http://schemas.openxmlformats.org/officeDocument/2006/customXml" ds:itemID="{60396B75-95CC-493D-A078-40A7C31D2078}">
  <ds:schemaRefs>
    <ds:schemaRef ds:uri="http://schemas.microsoft.com/office/2006/metadata/properties"/>
    <ds:schemaRef ds:uri="e0c5cd90-fa0d-4391-bd91-b400daf014db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2031</TotalTime>
  <Words>717</Words>
  <Application>Microsoft Office PowerPoint</Application>
  <PresentationFormat>自定义</PresentationFormat>
  <Paragraphs>186</Paragraphs>
  <Slides>1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1</vt:i4>
      </vt:variant>
    </vt:vector>
  </HeadingPairs>
  <TitlesOfParts>
    <vt:vector size="12" baseType="lpstr"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r.Wshmily</dc:creator>
  <cp:lastModifiedBy>Windows 用户</cp:lastModifiedBy>
  <cp:revision>121</cp:revision>
  <dcterms:created xsi:type="dcterms:W3CDTF">2016-08-15T03:46:50Z</dcterms:created>
  <dcterms:modified xsi:type="dcterms:W3CDTF">2017-11-22T11:20:2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E8C78F21B45EF479F5CA629480F6AA8</vt:lpwstr>
  </property>
</Properties>
</file>